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notesSlides/notesSlide2.xml" ContentType="application/vnd.openxmlformats-officedocument.presentationml.notesSlide+xml"/>
  <Override PartName="/ppt/tags/tag2.xml" ContentType="application/vnd.openxmlformats-officedocument.presentationml.tags+xml"/>
  <Override PartName="/ppt/notesSlides/notesSlide3.xml" ContentType="application/vnd.openxmlformats-officedocument.presentationml.notesSlide+xml"/>
  <Override PartName="/ppt/tags/tag3.xml" ContentType="application/vnd.openxmlformats-officedocument.presentationml.tags+xml"/>
  <Override PartName="/ppt/notesSlides/notesSlide4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tags/tag4.xml" ContentType="application/vnd.openxmlformats-officedocument.presentationml.tags+xml"/>
  <Override PartName="/ppt/notesSlides/notesSlide5.xml" ContentType="application/vnd.openxmlformats-officedocument.presentationml.notesSlide+xml"/>
  <Override PartName="/ppt/tags/tag5.xml" ContentType="application/vnd.openxmlformats-officedocument.presentationml.tags+xml"/>
  <Override PartName="/ppt/notesSlides/notesSlide6.xml" ContentType="application/vnd.openxmlformats-officedocument.presentationml.notesSlide+xml"/>
  <Override PartName="/ppt/tags/tag6.xml" ContentType="application/vnd.openxmlformats-officedocument.presentationml.tags+xml"/>
  <Override PartName="/ppt/notesSlides/notesSlide7.xml" ContentType="application/vnd.openxmlformats-officedocument.presentationml.notesSlide+xml"/>
  <Override PartName="/ppt/tags/tag7.xml" ContentType="application/vnd.openxmlformats-officedocument.presentationml.tags+xml"/>
  <Override PartName="/ppt/notesSlides/notesSlide8.xml" ContentType="application/vnd.openxmlformats-officedocument.presentationml.notesSlide+xml"/>
  <Override PartName="/ppt/tags/tag8.xml" ContentType="application/vnd.openxmlformats-officedocument.presentationml.tags+xml"/>
  <Override PartName="/ppt/notesSlides/notesSlide9.xml" ContentType="application/vnd.openxmlformats-officedocument.presentationml.notesSlide+xml"/>
  <Override PartName="/ppt/tags/tag9.xml" ContentType="application/vnd.openxmlformats-officedocument.presentationml.tags+xml"/>
  <Override PartName="/ppt/notesSlides/notesSlide10.xml" ContentType="application/vnd.openxmlformats-officedocument.presentationml.notesSlide+xml"/>
  <Override PartName="/ppt/tags/tag10.xml" ContentType="application/vnd.openxmlformats-officedocument.presentationml.tags+xml"/>
  <Override PartName="/ppt/notesSlides/notesSlide11.xml" ContentType="application/vnd.openxmlformats-officedocument.presentationml.notesSlide+xml"/>
  <Override PartName="/ppt/tags/tag11.xml" ContentType="application/vnd.openxmlformats-officedocument.presentationml.tags+xml"/>
  <Override PartName="/ppt/notesSlides/notesSlide12.xml" ContentType="application/vnd.openxmlformats-officedocument.presentationml.notesSlide+xml"/>
  <Override PartName="/ppt/tags/tag12.xml" ContentType="application/vnd.openxmlformats-officedocument.presentationml.tags+xml"/>
  <Override PartName="/ppt/notesSlides/notesSlide13.xml" ContentType="application/vnd.openxmlformats-officedocument.presentationml.notesSlide+xml"/>
  <Override PartName="/ppt/tags/tag13.xml" ContentType="application/vnd.openxmlformats-officedocument.presentationml.tags+xml"/>
  <Override PartName="/ppt/notesSlides/notesSlide14.xml" ContentType="application/vnd.openxmlformats-officedocument.presentationml.notesSlide+xml"/>
  <Override PartName="/ppt/tags/tag14.xml" ContentType="application/vnd.openxmlformats-officedocument.presentationml.tags+xml"/>
  <Override PartName="/ppt/notesSlides/notesSlide15.xml" ContentType="application/vnd.openxmlformats-officedocument.presentationml.notesSlide+xml"/>
  <Override PartName="/ppt/tags/tag15.xml" ContentType="application/vnd.openxmlformats-officedocument.presentationml.tags+xml"/>
  <Override PartName="/ppt/notesSlides/notesSlide16.xml" ContentType="application/vnd.openxmlformats-officedocument.presentationml.notesSlide+xml"/>
  <Override PartName="/ppt/tags/tag16.xml" ContentType="application/vnd.openxmlformats-officedocument.presentationml.tags+xml"/>
  <Override PartName="/ppt/notesSlides/notesSlide17.xml" ContentType="application/vnd.openxmlformats-officedocument.presentationml.notesSlide+xml"/>
  <Override PartName="/ppt/tags/tag17.xml" ContentType="application/vnd.openxmlformats-officedocument.presentationml.tags+xml"/>
  <Override PartName="/ppt/notesSlides/notesSlide18.xml" ContentType="application/vnd.openxmlformats-officedocument.presentationml.notesSlide+xml"/>
  <Override PartName="/ppt/tags/tag18.xml" ContentType="application/vnd.openxmlformats-officedocument.presentationml.tags+xml"/>
  <Override PartName="/ppt/notesSlides/notesSlide19.xml" ContentType="application/vnd.openxmlformats-officedocument.presentationml.notesSlide+xml"/>
  <Override PartName="/ppt/tags/tag19.xml" ContentType="application/vnd.openxmlformats-officedocument.presentationml.tags+xml"/>
  <Override PartName="/ppt/notesSlides/notesSlide20.xml" ContentType="application/vnd.openxmlformats-officedocument.presentationml.notesSlide+xml"/>
  <Override PartName="/ppt/tags/tag20.xml" ContentType="application/vnd.openxmlformats-officedocument.presentationml.tags+xml"/>
  <Override PartName="/ppt/notesSlides/notesSlide21.xml" ContentType="application/vnd.openxmlformats-officedocument.presentationml.notesSlide+xml"/>
  <Override PartName="/ppt/tags/tag21.xml" ContentType="application/vnd.openxmlformats-officedocument.presentationml.tags+xml"/>
  <Override PartName="/ppt/notesSlides/notesSlide22.xml" ContentType="application/vnd.openxmlformats-officedocument.presentationml.notesSlide+xml"/>
  <Override PartName="/ppt/tags/tag22.xml" ContentType="application/vnd.openxmlformats-officedocument.presentationml.tags+xml"/>
  <Override PartName="/ppt/notesSlides/notesSlide23.xml" ContentType="application/vnd.openxmlformats-officedocument.presentationml.notesSlide+xml"/>
  <Override PartName="/ppt/tags/tag23.xml" ContentType="application/vnd.openxmlformats-officedocument.presentationml.tags+xml"/>
  <Override PartName="/ppt/notesSlides/notesSlide24.xml" ContentType="application/vnd.openxmlformats-officedocument.presentationml.notesSlide+xml"/>
  <Override PartName="/ppt/tags/tag24.xml" ContentType="application/vnd.openxmlformats-officedocument.presentationml.tags+xml"/>
  <Override PartName="/ppt/notesSlides/notesSlide25.xml" ContentType="application/vnd.openxmlformats-officedocument.presentationml.notesSlide+xml"/>
  <Override PartName="/ppt/tags/tag25.xml" ContentType="application/vnd.openxmlformats-officedocument.presentationml.tags+xml"/>
  <Override PartName="/ppt/notesSlides/notesSlide26.xml" ContentType="application/vnd.openxmlformats-officedocument.presentationml.notesSlide+xml"/>
  <Override PartName="/ppt/tags/tag26.xml" ContentType="application/vnd.openxmlformats-officedocument.presentationml.tags+xml"/>
  <Override PartName="/ppt/notesSlides/notesSlide27.xml" ContentType="application/vnd.openxmlformats-officedocument.presentationml.notesSlide+xml"/>
  <Override PartName="/ppt/tags/tag27.xml" ContentType="application/vnd.openxmlformats-officedocument.presentationml.tags+xml"/>
  <Override PartName="/ppt/notesSlides/notesSlide28.xml" ContentType="application/vnd.openxmlformats-officedocument.presentationml.notesSlide+xml"/>
  <Override PartName="/ppt/tags/tag28.xml" ContentType="application/vnd.openxmlformats-officedocument.presentationml.tags+xml"/>
  <Override PartName="/ppt/notesSlides/notesSlide29.xml" ContentType="application/vnd.openxmlformats-officedocument.presentationml.notesSlide+xml"/>
  <Override PartName="/ppt/tags/tag29.xml" ContentType="application/vnd.openxmlformats-officedocument.presentationml.tags+xml"/>
  <Override PartName="/ppt/notesSlides/notesSlide30.xml" ContentType="application/vnd.openxmlformats-officedocument.presentationml.notesSlide+xml"/>
  <Override PartName="/ppt/tags/tag30.xml" ContentType="application/vnd.openxmlformats-officedocument.presentationml.tags+xml"/>
  <Override PartName="/ppt/notesSlides/notesSlide31.xml" ContentType="application/vnd.openxmlformats-officedocument.presentationml.notesSlide+xml"/>
  <Override PartName="/ppt/tags/tag31.xml" ContentType="application/vnd.openxmlformats-officedocument.presentationml.tags+xml"/>
  <Override PartName="/ppt/notesSlides/notesSlide32.xml" ContentType="application/vnd.openxmlformats-officedocument.presentationml.notesSlide+xml"/>
  <Override PartName="/ppt/tags/tag32.xml" ContentType="application/vnd.openxmlformats-officedocument.presentationml.tags+xml"/>
  <Override PartName="/ppt/notesSlides/notesSlide33.xml" ContentType="application/vnd.openxmlformats-officedocument.presentationml.notesSlide+xml"/>
  <Override PartName="/ppt/tags/tag33.xml" ContentType="application/vnd.openxmlformats-officedocument.presentationml.tags+xml"/>
  <Override PartName="/ppt/notesSlides/notesSlide34.xml" ContentType="application/vnd.openxmlformats-officedocument.presentationml.notesSlide+xml"/>
  <Override PartName="/ppt/tags/tag34.xml" ContentType="application/vnd.openxmlformats-officedocument.presentationml.tags+xml"/>
  <Override PartName="/ppt/notesSlides/notesSlide35.xml" ContentType="application/vnd.openxmlformats-officedocument.presentationml.notesSlide+xml"/>
  <Override PartName="/ppt/tags/tag35.xml" ContentType="application/vnd.openxmlformats-officedocument.presentationml.tags+xml"/>
  <Override PartName="/ppt/notesSlides/notesSlide36.xml" ContentType="application/vnd.openxmlformats-officedocument.presentationml.notesSlide+xml"/>
  <Override PartName="/ppt/tags/tag36.xml" ContentType="application/vnd.openxmlformats-officedocument.presentationml.tags+xml"/>
  <Override PartName="/ppt/notesSlides/notesSlide37.xml" ContentType="application/vnd.openxmlformats-officedocument.presentationml.notesSlide+xml"/>
  <Override PartName="/ppt/tags/tag37.xml" ContentType="application/vnd.openxmlformats-officedocument.presentationml.tags+xml"/>
  <Override PartName="/ppt/notesSlides/notesSlide38.xml" ContentType="application/vnd.openxmlformats-officedocument.presentationml.notesSlide+xml"/>
  <Override PartName="/ppt/tags/tag38.xml" ContentType="application/vnd.openxmlformats-officedocument.presentationml.tags+xml"/>
  <Override PartName="/ppt/notesSlides/notesSlide39.xml" ContentType="application/vnd.openxmlformats-officedocument.presentationml.notesSlide+xml"/>
  <Override PartName="/ppt/tags/tag39.xml" ContentType="application/vnd.openxmlformats-officedocument.presentationml.tags+xml"/>
  <Override PartName="/ppt/notesSlides/notesSlide40.xml" ContentType="application/vnd.openxmlformats-officedocument.presentationml.notesSlide+xml"/>
  <Override PartName="/ppt/tags/tag40.xml" ContentType="application/vnd.openxmlformats-officedocument.presentationml.tags+xml"/>
  <Override PartName="/ppt/notesSlides/notesSlide41.xml" ContentType="application/vnd.openxmlformats-officedocument.presentationml.notesSlide+xml"/>
  <Override PartName="/ppt/tags/tag41.xml" ContentType="application/vnd.openxmlformats-officedocument.presentationml.tags+xml"/>
  <Override PartName="/ppt/notesSlides/notesSlide42.xml" ContentType="application/vnd.openxmlformats-officedocument.presentationml.notesSlide+xml"/>
  <Override PartName="/ppt/tags/tag42.xml" ContentType="application/vnd.openxmlformats-officedocument.presentationml.tags+xml"/>
  <Override PartName="/ppt/notesSlides/notesSlide43.xml" ContentType="application/vnd.openxmlformats-officedocument.presentationml.notesSlide+xml"/>
  <Override PartName="/ppt/tags/tag43.xml" ContentType="application/vnd.openxmlformats-officedocument.presentationml.tags+xml"/>
  <Override PartName="/ppt/notesSlides/notesSlide44.xml" ContentType="application/vnd.openxmlformats-officedocument.presentationml.notesSlide+xml"/>
  <Override PartName="/ppt/tags/tag44.xml" ContentType="application/vnd.openxmlformats-officedocument.presentationml.tags+xml"/>
  <Override PartName="/ppt/notesSlides/notesSlide45.xml" ContentType="application/vnd.openxmlformats-officedocument.presentationml.notesSlide+xml"/>
  <Override PartName="/ppt/tags/tag45.xml" ContentType="application/vnd.openxmlformats-officedocument.presentationml.tags+xml"/>
  <Override PartName="/ppt/notesSlides/notesSlide46.xml" ContentType="application/vnd.openxmlformats-officedocument.presentationml.notesSlide+xml"/>
  <Override PartName="/ppt/tags/tag46.xml" ContentType="application/vnd.openxmlformats-officedocument.presentationml.tags+xml"/>
  <Override PartName="/ppt/notesSlides/notesSlide47.xml" ContentType="application/vnd.openxmlformats-officedocument.presentationml.notesSlide+xml"/>
  <Override PartName="/ppt/tags/tag47.xml" ContentType="application/vnd.openxmlformats-officedocument.presentationml.tags+xml"/>
  <Override PartName="/ppt/notesSlides/notesSlide48.xml" ContentType="application/vnd.openxmlformats-officedocument.presentationml.notesSlide+xml"/>
  <Override PartName="/ppt/tags/tag48.xml" ContentType="application/vnd.openxmlformats-officedocument.presentationml.tags+xml"/>
  <Override PartName="/ppt/notesSlides/notesSlide49.xml" ContentType="application/vnd.openxmlformats-officedocument.presentationml.notesSlide+xml"/>
  <Override PartName="/ppt/tags/tag49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1"/>
  </p:notesMasterIdLst>
  <p:handoutMasterIdLst>
    <p:handoutMasterId r:id="rId52"/>
  </p:handoutMasterIdLst>
  <p:sldIdLst>
    <p:sldId id="340" r:id="rId2"/>
    <p:sldId id="284" r:id="rId3"/>
    <p:sldId id="352" r:id="rId4"/>
    <p:sldId id="324" r:id="rId5"/>
    <p:sldId id="289" r:id="rId6"/>
    <p:sldId id="290" r:id="rId7"/>
    <p:sldId id="325" r:id="rId8"/>
    <p:sldId id="295" r:id="rId9"/>
    <p:sldId id="296" r:id="rId10"/>
    <p:sldId id="293" r:id="rId11"/>
    <p:sldId id="291" r:id="rId12"/>
    <p:sldId id="343" r:id="rId13"/>
    <p:sldId id="297" r:id="rId14"/>
    <p:sldId id="280" r:id="rId15"/>
    <p:sldId id="360" r:id="rId16"/>
    <p:sldId id="260" r:id="rId17"/>
    <p:sldId id="282" r:id="rId18"/>
    <p:sldId id="353" r:id="rId19"/>
    <p:sldId id="341" r:id="rId20"/>
    <p:sldId id="300" r:id="rId21"/>
    <p:sldId id="342" r:id="rId22"/>
    <p:sldId id="322" r:id="rId23"/>
    <p:sldId id="302" r:id="rId24"/>
    <p:sldId id="328" r:id="rId25"/>
    <p:sldId id="330" r:id="rId26"/>
    <p:sldId id="331" r:id="rId27"/>
    <p:sldId id="304" r:id="rId28"/>
    <p:sldId id="339" r:id="rId29"/>
    <p:sldId id="276" r:id="rId30"/>
    <p:sldId id="309" r:id="rId31"/>
    <p:sldId id="356" r:id="rId32"/>
    <p:sldId id="357" r:id="rId33"/>
    <p:sldId id="358" r:id="rId34"/>
    <p:sldId id="278" r:id="rId35"/>
    <p:sldId id="311" r:id="rId36"/>
    <p:sldId id="261" r:id="rId37"/>
    <p:sldId id="313" r:id="rId38"/>
    <p:sldId id="314" r:id="rId39"/>
    <p:sldId id="315" r:id="rId40"/>
    <p:sldId id="348" r:id="rId41"/>
    <p:sldId id="316" r:id="rId42"/>
    <p:sldId id="317" r:id="rId43"/>
    <p:sldId id="318" r:id="rId44"/>
    <p:sldId id="319" r:id="rId45"/>
    <p:sldId id="320" r:id="rId46"/>
    <p:sldId id="326" r:id="rId47"/>
    <p:sldId id="327" r:id="rId48"/>
    <p:sldId id="287" r:id="rId49"/>
    <p:sldId id="359" r:id="rId50"/>
  </p:sldIdLst>
  <p:sldSz cx="9144000" cy="6858000" type="screen4x3"/>
  <p:notesSz cx="6858000" cy="9144000"/>
  <p:custShowLst>
    <p:custShow name="Self-Assessment - Standard Radi" id="0">
      <p:sldLst>
        <p:sld r:id="rId47"/>
      </p:sldLst>
    </p:custShow>
    <p:custShow name="Self-Assessment - Operative Int" id="1">
      <p:sldLst>
        <p:sld r:id="rId48"/>
      </p:sldLst>
    </p:custShow>
    <p:custShow name="Self-Assessment - Urgent Manage" id="2">
      <p:sldLst>
        <p:sld r:id="rId49"/>
      </p:sldLst>
    </p:custShow>
    <p:custShow name="Splinting - additional informat" id="3">
      <p:sldLst>
        <p:sld r:id="rId50"/>
      </p:sldLst>
    </p:custShow>
  </p:custShow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0C86FE9-399E-42BB-B410-B62145C4A26C}">
          <p14:sldIdLst>
            <p14:sldId id="340"/>
            <p14:sldId id="284"/>
            <p14:sldId id="352"/>
          </p14:sldIdLst>
        </p14:section>
        <p14:section name="Contents" id="{12811825-6CAE-4590-91DD-71A54637BA43}">
          <p14:sldIdLst>
            <p14:sldId id="324"/>
          </p14:sldIdLst>
        </p14:section>
        <p14:section name="Physical Exam" id="{DC3C1050-F7F4-4A33-BAD1-AB206228A8D1}">
          <p14:sldIdLst>
            <p14:sldId id="289"/>
            <p14:sldId id="290"/>
            <p14:sldId id="325"/>
            <p14:sldId id="295"/>
            <p14:sldId id="296"/>
            <p14:sldId id="293"/>
            <p14:sldId id="291"/>
            <p14:sldId id="343"/>
          </p14:sldIdLst>
        </p14:section>
        <p14:section name="Acute Carpal Tunnel Syndrome" id="{357DC067-39BD-406A-9D3C-BE6F994E7B79}">
          <p14:sldIdLst>
            <p14:sldId id="297"/>
            <p14:sldId id="280"/>
          </p14:sldIdLst>
        </p14:section>
        <p14:section name="Radiographic Examination" id="{C6E09DFD-1F31-4987-9327-322EE41652F6}">
          <p14:sldIdLst>
            <p14:sldId id="360"/>
            <p14:sldId id="260"/>
            <p14:sldId id="282"/>
            <p14:sldId id="353"/>
            <p14:sldId id="341"/>
          </p14:sldIdLst>
        </p14:section>
        <p14:section name="Types of Fracture" id="{781D3DED-1AFB-4DD7-9C3E-0B28EB4B2B4A}">
          <p14:sldIdLst>
            <p14:sldId id="300"/>
            <p14:sldId id="342"/>
            <p14:sldId id="322"/>
            <p14:sldId id="302"/>
            <p14:sldId id="328"/>
            <p14:sldId id="330"/>
            <p14:sldId id="331"/>
            <p14:sldId id="304"/>
            <p14:sldId id="339"/>
            <p14:sldId id="276"/>
            <p14:sldId id="309"/>
            <p14:sldId id="356"/>
            <p14:sldId id="357"/>
            <p14:sldId id="358"/>
            <p14:sldId id="278"/>
            <p14:sldId id="311"/>
            <p14:sldId id="261"/>
          </p14:sldIdLst>
        </p14:section>
        <p14:section name="Management" id="{D681AA90-A4D6-4A5E-A115-D82C3A66DC90}">
          <p14:sldIdLst>
            <p14:sldId id="313"/>
            <p14:sldId id="314"/>
            <p14:sldId id="315"/>
            <p14:sldId id="348"/>
            <p14:sldId id="316"/>
            <p14:sldId id="317"/>
            <p14:sldId id="318"/>
            <p14:sldId id="319"/>
            <p14:sldId id="320"/>
          </p14:sldIdLst>
        </p14:section>
        <p14:section name="Self-Assessment" id="{FC55B58E-5EB9-4D73-BC0D-FAD675DE2831}">
          <p14:sldIdLst>
            <p14:sldId id="326"/>
            <p14:sldId id="327"/>
            <p14:sldId id="287"/>
            <p14:sldId id="359"/>
          </p14:sldIdLst>
        </p14:section>
      </p14:section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ichael Hulme" initials="A" lastIdx="3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447" autoAdjust="0"/>
    <p:restoredTop sz="94660"/>
  </p:normalViewPr>
  <p:slideViewPr>
    <p:cSldViewPr snapToGrid="0" snapToObjects="1">
      <p:cViewPr>
        <p:scale>
          <a:sx n="85" d="100"/>
          <a:sy n="85" d="100"/>
        </p:scale>
        <p:origin x="-1488" y="-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theme" Target="theme/theme1.xml"/><Relationship Id="rId8" Type="http://schemas.openxmlformats.org/officeDocument/2006/relationships/slide" Target="slides/slide7.xml"/><Relationship Id="rId51" Type="http://schemas.openxmlformats.org/officeDocument/2006/relationships/notesMaster" Target="notesMasters/notesMaster1.xml"/><Relationship Id="rId3" Type="http://schemas.openxmlformats.org/officeDocument/2006/relationships/slide" Target="slides/slide2.xml"/></Relationships>
</file>

<file path=ppt/diagrams/_rels/data1.xml.rels><?xml version="1.0" encoding="UTF-8" standalone="yes"?>
<Relationships xmlns="http://schemas.openxmlformats.org/package/2006/relationships"><Relationship Id="rId8" Type="http://schemas.openxmlformats.org/officeDocument/2006/relationships/slide" Target="../slides/slide43.xml"/><Relationship Id="rId3" Type="http://schemas.openxmlformats.org/officeDocument/2006/relationships/slide" Target="../slides/slide13.xml"/><Relationship Id="rId7" Type="http://schemas.openxmlformats.org/officeDocument/2006/relationships/slide" Target="../slides/slide2.xml"/><Relationship Id="rId2" Type="http://schemas.openxmlformats.org/officeDocument/2006/relationships/slide" Target="../slides/slide5.xml"/><Relationship Id="rId1" Type="http://schemas.openxmlformats.org/officeDocument/2006/relationships/image" Target="../media/image1.jpeg"/><Relationship Id="rId6" Type="http://schemas.openxmlformats.org/officeDocument/2006/relationships/slide" Target="../slides/slide3.xml"/><Relationship Id="rId5" Type="http://schemas.openxmlformats.org/officeDocument/2006/relationships/slide" Target="../slides/slide20.xml"/><Relationship Id="rId4" Type="http://schemas.openxmlformats.org/officeDocument/2006/relationships/slide" Target="../slides/slide15.xml"/></Relationships>
</file>

<file path=ppt/diagrams/_rels/drawing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1956370-2A2A-4C18-9AEA-97727139842C}" type="doc">
      <dgm:prSet loTypeId="urn:microsoft.com/office/officeart/2005/8/layout/radial1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13D93C37-AC0B-4542-AF9C-D5FF902741DA}">
      <dgm:prSet phldrT="[Text]"/>
      <dgm:spPr/>
      <dgm:t>
        <a:bodyPr/>
        <a:lstStyle/>
        <a:p>
          <a:r>
            <a:rPr lang="en-US" dirty="0" smtClean="0"/>
            <a:t>Wrist Fracture</a:t>
          </a:r>
          <a:endParaRPr lang="en-US" dirty="0"/>
        </a:p>
      </dgm:t>
    </dgm:pt>
    <dgm:pt modelId="{DACFB4E9-965D-4950-8376-2503F06140B4}" type="parTrans" cxnId="{BDB22294-453E-429D-B590-1B1367BDEC4C}">
      <dgm:prSet/>
      <dgm:spPr/>
      <dgm:t>
        <a:bodyPr/>
        <a:lstStyle/>
        <a:p>
          <a:endParaRPr lang="en-US"/>
        </a:p>
      </dgm:t>
    </dgm:pt>
    <dgm:pt modelId="{312E98FF-85B7-4CDB-A490-0B2492750BAE}" type="sibTrans" cxnId="{BDB22294-453E-429D-B590-1B1367BDEC4C}">
      <dgm:prSet/>
      <dgm:spPr/>
      <dgm:t>
        <a:bodyPr/>
        <a:lstStyle/>
        <a:p>
          <a:endParaRPr lang="en-US"/>
        </a:p>
      </dgm:t>
    </dgm:pt>
    <dgm:pt modelId="{73749A64-D89A-4BEE-9BBC-591A7547AE39}">
      <dgm:prSet phldrT="[Text]"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Physical Exam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2" action="ppaction://hlinksldjump"/>
          </dgm14:cNvPr>
        </a:ext>
      </dgm:extLst>
    </dgm:pt>
    <dgm:pt modelId="{58D6FE09-747B-4E4A-A1D8-AE0B08FCDEDC}" type="parTrans" cxnId="{37167280-72E4-4B1E-B0A5-DA35A254CBD4}">
      <dgm:prSet/>
      <dgm:spPr/>
      <dgm:t>
        <a:bodyPr/>
        <a:lstStyle/>
        <a:p>
          <a:endParaRPr lang="en-US"/>
        </a:p>
      </dgm:t>
    </dgm:pt>
    <dgm:pt modelId="{5F274D5A-D60E-471C-A2F9-7FF7DCB59447}" type="sibTrans" cxnId="{37167280-72E4-4B1E-B0A5-DA35A254CBD4}">
      <dgm:prSet/>
      <dgm:spPr/>
      <dgm:t>
        <a:bodyPr/>
        <a:lstStyle/>
        <a:p>
          <a:endParaRPr lang="en-US"/>
        </a:p>
      </dgm:t>
    </dgm:pt>
    <dgm:pt modelId="{8C9B91F2-7D93-4D59-95BC-B490A747F2D6}">
      <dgm:prSet phldrT="[Text]"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Acute Carpal Tunnel Syndrome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3" action="ppaction://hlinksldjump"/>
          </dgm14:cNvPr>
        </a:ext>
      </dgm:extLst>
    </dgm:pt>
    <dgm:pt modelId="{12C95121-611D-4698-ABBA-F22B6AEB2CE9}" type="parTrans" cxnId="{9964D7B4-FDEC-448A-B147-477D478D1278}">
      <dgm:prSet/>
      <dgm:spPr/>
      <dgm:t>
        <a:bodyPr/>
        <a:lstStyle/>
        <a:p>
          <a:endParaRPr lang="en-US"/>
        </a:p>
      </dgm:t>
    </dgm:pt>
    <dgm:pt modelId="{3E542EBB-212B-4E6C-ABDE-1AA0D6D2B9E7}" type="sibTrans" cxnId="{9964D7B4-FDEC-448A-B147-477D478D1278}">
      <dgm:prSet/>
      <dgm:spPr/>
      <dgm:t>
        <a:bodyPr/>
        <a:lstStyle/>
        <a:p>
          <a:endParaRPr lang="en-US"/>
        </a:p>
      </dgm:t>
    </dgm:pt>
    <dgm:pt modelId="{76993CC8-F38B-4E73-AEA4-70805117DDB0}">
      <dgm:prSet phldrT="[Text]"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Radio-graphic Exam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4" action="ppaction://hlinksldjump"/>
          </dgm14:cNvPr>
        </a:ext>
      </dgm:extLst>
    </dgm:pt>
    <dgm:pt modelId="{8AC4E558-74AB-4D02-AF1B-70140DDA9271}" type="parTrans" cxnId="{8B40454C-8E83-414B-929C-1649A67D533C}">
      <dgm:prSet/>
      <dgm:spPr/>
      <dgm:t>
        <a:bodyPr/>
        <a:lstStyle/>
        <a:p>
          <a:endParaRPr lang="en-US"/>
        </a:p>
      </dgm:t>
    </dgm:pt>
    <dgm:pt modelId="{C128094F-EDD5-4CAB-A538-B81C423CC2D2}" type="sibTrans" cxnId="{8B40454C-8E83-414B-929C-1649A67D533C}">
      <dgm:prSet/>
      <dgm:spPr/>
      <dgm:t>
        <a:bodyPr/>
        <a:lstStyle/>
        <a:p>
          <a:endParaRPr lang="en-US"/>
        </a:p>
      </dgm:t>
    </dgm:pt>
    <dgm:pt modelId="{ACA723EE-E14D-4B4B-977F-7CD87A0AD761}">
      <dgm:prSet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Types of Wrist Fracture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5" action="ppaction://hlinksldjump"/>
          </dgm14:cNvPr>
        </a:ext>
      </dgm:extLst>
    </dgm:pt>
    <dgm:pt modelId="{702687E1-3154-46B0-9D5A-4B4ABF22426A}" type="parTrans" cxnId="{D4144B9F-FF7A-4B32-B27C-6CA5DC003E2A}">
      <dgm:prSet/>
      <dgm:spPr/>
      <dgm:t>
        <a:bodyPr/>
        <a:lstStyle/>
        <a:p>
          <a:endParaRPr lang="en-US"/>
        </a:p>
      </dgm:t>
    </dgm:pt>
    <dgm:pt modelId="{12E0ED85-A86F-4728-93C5-1CB78B4BBF8B}" type="sibTrans" cxnId="{D4144B9F-FF7A-4B32-B27C-6CA5DC003E2A}">
      <dgm:prSet/>
      <dgm:spPr/>
      <dgm:t>
        <a:bodyPr/>
        <a:lstStyle/>
        <a:p>
          <a:endParaRPr lang="en-US"/>
        </a:p>
      </dgm:t>
    </dgm:pt>
    <dgm:pt modelId="{28E5EB1A-6B59-48F6-961A-FA866485A4DD}">
      <dgm:prSet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Self-Assessment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6" action="ppaction://hlinksldjump"/>
          </dgm14:cNvPr>
        </a:ext>
      </dgm:extLst>
    </dgm:pt>
    <dgm:pt modelId="{490D4522-31ED-4D8D-90F6-C9906A58611A}" type="parTrans" cxnId="{0A1B26B1-A17D-495B-835F-B72B2E7C79C9}">
      <dgm:prSet/>
      <dgm:spPr/>
      <dgm:t>
        <a:bodyPr/>
        <a:lstStyle/>
        <a:p>
          <a:endParaRPr lang="en-US"/>
        </a:p>
      </dgm:t>
    </dgm:pt>
    <dgm:pt modelId="{83A92F69-26C6-4CF5-951B-DCF92E580BBD}" type="sibTrans" cxnId="{0A1B26B1-A17D-495B-835F-B72B2E7C79C9}">
      <dgm:prSet/>
      <dgm:spPr/>
      <dgm:t>
        <a:bodyPr/>
        <a:lstStyle/>
        <a:p>
          <a:endParaRPr lang="en-US"/>
        </a:p>
      </dgm:t>
    </dgm:pt>
    <dgm:pt modelId="{2B1E1BCC-6963-4675-8991-6A10A408E244}">
      <dgm:prSet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Objectives</a:t>
          </a:r>
          <a:endParaRPr lang="en-US" sz="1500" b="1" dirty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7" action="ppaction://hlinksldjump"/>
          </dgm14:cNvPr>
        </a:ext>
      </dgm:extLst>
    </dgm:pt>
    <dgm:pt modelId="{38540EE7-2272-4AE8-B809-BB7C7F69AF80}" type="parTrans" cxnId="{4CF696B6-4F5A-46EA-AFE9-84D321FFDB98}">
      <dgm:prSet/>
      <dgm:spPr/>
      <dgm:t>
        <a:bodyPr/>
        <a:lstStyle/>
        <a:p>
          <a:endParaRPr lang="en-US"/>
        </a:p>
      </dgm:t>
    </dgm:pt>
    <dgm:pt modelId="{77DD7E33-49AC-4B1A-A7C3-C80C348FD910}" type="sibTrans" cxnId="{4CF696B6-4F5A-46EA-AFE9-84D321FFDB98}">
      <dgm:prSet/>
      <dgm:spPr/>
      <dgm:t>
        <a:bodyPr/>
        <a:lstStyle/>
        <a:p>
          <a:endParaRPr lang="en-US"/>
        </a:p>
      </dgm:t>
    </dgm:pt>
    <dgm:pt modelId="{DBFE4500-484C-4F54-8250-B072A9C73216}">
      <dgm:prSet custT="1"/>
      <dgm:spPr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>
          <a:noFill/>
        </a:ln>
      </dgm:spPr>
      <dgm:t>
        <a:bodyPr/>
        <a:lstStyle/>
        <a:p>
          <a:r>
            <a:rPr lang="en-US" sz="1500" b="1" dirty="0" smtClean="0">
              <a:solidFill>
                <a:schemeClr val="bg1"/>
              </a:solidFill>
            </a:rPr>
            <a:t>Manage-</a:t>
          </a:r>
          <a:r>
            <a:rPr lang="en-US" sz="1500" b="1" dirty="0" err="1" smtClean="0">
              <a:solidFill>
                <a:schemeClr val="bg1"/>
              </a:solidFill>
            </a:rPr>
            <a:t>ment</a:t>
          </a:r>
          <a:endParaRPr lang="en-US" sz="1500" b="1" dirty="0" smtClean="0">
            <a:solidFill>
              <a:schemeClr val="bg1"/>
            </a:solidFill>
          </a:endParaRPr>
        </a:p>
      </dgm:t>
      <dgm:extLst>
        <a:ext uri="{E40237B7-FDA0-4F09-8148-C483321AD2D9}">
          <dgm14:cNvPr xmlns:dgm14="http://schemas.microsoft.com/office/drawing/2010/diagram" id="0" name="">
            <a:hlinkClick xmlns:r="http://schemas.openxmlformats.org/officeDocument/2006/relationships" r:id="rId8" action="ppaction://hlinksldjump"/>
          </dgm14:cNvPr>
        </a:ext>
      </dgm:extLst>
    </dgm:pt>
    <dgm:pt modelId="{C78B5607-CDDE-4196-8A0D-B688CBE6C593}" type="parTrans" cxnId="{2890B22B-9F38-49FB-AE68-0E87AE082188}">
      <dgm:prSet/>
      <dgm:spPr/>
      <dgm:t>
        <a:bodyPr/>
        <a:lstStyle/>
        <a:p>
          <a:endParaRPr lang="en-US"/>
        </a:p>
      </dgm:t>
    </dgm:pt>
    <dgm:pt modelId="{B026C885-7F7F-4319-B3F7-FE3C775F7A88}" type="sibTrans" cxnId="{2890B22B-9F38-49FB-AE68-0E87AE082188}">
      <dgm:prSet/>
      <dgm:spPr/>
      <dgm:t>
        <a:bodyPr/>
        <a:lstStyle/>
        <a:p>
          <a:endParaRPr lang="en-US"/>
        </a:p>
      </dgm:t>
    </dgm:pt>
    <dgm:pt modelId="{870943AF-FD53-470D-8ACD-3302F8EF16F5}" type="pres">
      <dgm:prSet presAssocID="{F1956370-2A2A-4C18-9AEA-97727139842C}" presName="cycle" presStyleCnt="0">
        <dgm:presLayoutVars>
          <dgm:chMax val="1"/>
          <dgm:dir/>
          <dgm:animLvl val="ctr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404826E5-96D3-4487-ABB1-4784E7FAF9BB}" type="pres">
      <dgm:prSet presAssocID="{13D93C37-AC0B-4542-AF9C-D5FF902741DA}" presName="centerShape" presStyleLbl="node0" presStyleIdx="0" presStyleCnt="1"/>
      <dgm:spPr/>
      <dgm:t>
        <a:bodyPr/>
        <a:lstStyle/>
        <a:p>
          <a:endParaRPr lang="en-US"/>
        </a:p>
      </dgm:t>
    </dgm:pt>
    <dgm:pt modelId="{689283B0-1572-4BB1-A618-E0830C3189E2}" type="pres">
      <dgm:prSet presAssocID="{38540EE7-2272-4AE8-B809-BB7C7F69AF80}" presName="Name9" presStyleLbl="parChTrans1D2" presStyleIdx="0" presStyleCnt="7"/>
      <dgm:spPr/>
      <dgm:t>
        <a:bodyPr/>
        <a:lstStyle/>
        <a:p>
          <a:endParaRPr lang="en-US"/>
        </a:p>
      </dgm:t>
    </dgm:pt>
    <dgm:pt modelId="{113D72AA-3CBB-4144-BD3F-567237E79AA5}" type="pres">
      <dgm:prSet presAssocID="{38540EE7-2272-4AE8-B809-BB7C7F69AF80}" presName="connTx" presStyleLbl="parChTrans1D2" presStyleIdx="0" presStyleCnt="7"/>
      <dgm:spPr/>
      <dgm:t>
        <a:bodyPr/>
        <a:lstStyle/>
        <a:p>
          <a:endParaRPr lang="en-US"/>
        </a:p>
      </dgm:t>
    </dgm:pt>
    <dgm:pt modelId="{50FE95C2-5D91-4648-BBB9-DA339C53BD77}" type="pres">
      <dgm:prSet presAssocID="{2B1E1BCC-6963-4675-8991-6A10A408E244}" presName="node" presStyleLbl="node1" presStyleIdx="0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0E3944F-3EF5-427B-A95C-C4A7D5AE71EC}" type="pres">
      <dgm:prSet presAssocID="{58D6FE09-747B-4E4A-A1D8-AE0B08FCDEDC}" presName="Name9" presStyleLbl="parChTrans1D2" presStyleIdx="1" presStyleCnt="7"/>
      <dgm:spPr/>
      <dgm:t>
        <a:bodyPr/>
        <a:lstStyle/>
        <a:p>
          <a:endParaRPr lang="en-US"/>
        </a:p>
      </dgm:t>
    </dgm:pt>
    <dgm:pt modelId="{C8C30482-5089-43AA-83AF-7643C2B1E73C}" type="pres">
      <dgm:prSet presAssocID="{58D6FE09-747B-4E4A-A1D8-AE0B08FCDEDC}" presName="connTx" presStyleLbl="parChTrans1D2" presStyleIdx="1" presStyleCnt="7"/>
      <dgm:spPr/>
      <dgm:t>
        <a:bodyPr/>
        <a:lstStyle/>
        <a:p>
          <a:endParaRPr lang="en-US"/>
        </a:p>
      </dgm:t>
    </dgm:pt>
    <dgm:pt modelId="{A6E00D07-35EE-4E7D-8366-EAD4683E578F}" type="pres">
      <dgm:prSet presAssocID="{73749A64-D89A-4BEE-9BBC-591A7547AE39}" presName="node" presStyleLbl="node1" presStyleIdx="1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8365D89-EA61-4589-BDA2-9CC000A423AE}" type="pres">
      <dgm:prSet presAssocID="{12C95121-611D-4698-ABBA-F22B6AEB2CE9}" presName="Name9" presStyleLbl="parChTrans1D2" presStyleIdx="2" presStyleCnt="7"/>
      <dgm:spPr/>
      <dgm:t>
        <a:bodyPr/>
        <a:lstStyle/>
        <a:p>
          <a:endParaRPr lang="en-US"/>
        </a:p>
      </dgm:t>
    </dgm:pt>
    <dgm:pt modelId="{4EE744B1-4666-4D1E-8791-2F5229DE42FB}" type="pres">
      <dgm:prSet presAssocID="{12C95121-611D-4698-ABBA-F22B6AEB2CE9}" presName="connTx" presStyleLbl="parChTrans1D2" presStyleIdx="2" presStyleCnt="7"/>
      <dgm:spPr/>
      <dgm:t>
        <a:bodyPr/>
        <a:lstStyle/>
        <a:p>
          <a:endParaRPr lang="en-US"/>
        </a:p>
      </dgm:t>
    </dgm:pt>
    <dgm:pt modelId="{EE8975DE-FB20-4091-BAEC-782D0478AB39}" type="pres">
      <dgm:prSet presAssocID="{8C9B91F2-7D93-4D59-95BC-B490A747F2D6}" presName="node" presStyleLbl="node1" presStyleIdx="2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6928237-CF14-4EA8-83B5-6930CF641B6B}" type="pres">
      <dgm:prSet presAssocID="{8AC4E558-74AB-4D02-AF1B-70140DDA9271}" presName="Name9" presStyleLbl="parChTrans1D2" presStyleIdx="3" presStyleCnt="7"/>
      <dgm:spPr/>
      <dgm:t>
        <a:bodyPr/>
        <a:lstStyle/>
        <a:p>
          <a:endParaRPr lang="en-US"/>
        </a:p>
      </dgm:t>
    </dgm:pt>
    <dgm:pt modelId="{A593FF77-D56C-4A34-B57B-8A92B3AA579E}" type="pres">
      <dgm:prSet presAssocID="{8AC4E558-74AB-4D02-AF1B-70140DDA9271}" presName="connTx" presStyleLbl="parChTrans1D2" presStyleIdx="3" presStyleCnt="7"/>
      <dgm:spPr/>
      <dgm:t>
        <a:bodyPr/>
        <a:lstStyle/>
        <a:p>
          <a:endParaRPr lang="en-US"/>
        </a:p>
      </dgm:t>
    </dgm:pt>
    <dgm:pt modelId="{8B80C6FD-C3D7-4E8C-9EA8-BE6C26B11A5F}" type="pres">
      <dgm:prSet presAssocID="{76993CC8-F38B-4E73-AEA4-70805117DDB0}" presName="node" presStyleLbl="node1" presStyleIdx="3" presStyleCnt="7" custAng="60000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D4F5399-A3A8-4DF1-8EE1-D6860092DC85}" type="pres">
      <dgm:prSet presAssocID="{702687E1-3154-46B0-9D5A-4B4ABF22426A}" presName="Name9" presStyleLbl="parChTrans1D2" presStyleIdx="4" presStyleCnt="7"/>
      <dgm:spPr/>
      <dgm:t>
        <a:bodyPr/>
        <a:lstStyle/>
        <a:p>
          <a:endParaRPr lang="en-US"/>
        </a:p>
      </dgm:t>
    </dgm:pt>
    <dgm:pt modelId="{62FE8F4D-E9C1-4689-ABA4-B6BB5A0C4C3D}" type="pres">
      <dgm:prSet presAssocID="{702687E1-3154-46B0-9D5A-4B4ABF22426A}" presName="connTx" presStyleLbl="parChTrans1D2" presStyleIdx="4" presStyleCnt="7"/>
      <dgm:spPr/>
      <dgm:t>
        <a:bodyPr/>
        <a:lstStyle/>
        <a:p>
          <a:endParaRPr lang="en-US"/>
        </a:p>
      </dgm:t>
    </dgm:pt>
    <dgm:pt modelId="{749853BF-A175-4DF8-A8A0-538A28A00F2E}" type="pres">
      <dgm:prSet presAssocID="{ACA723EE-E14D-4B4B-977F-7CD87A0AD761}" presName="node" presStyleLbl="node1" presStyleIdx="4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48CDA79-331F-4000-9D5E-79F2C95994C6}" type="pres">
      <dgm:prSet presAssocID="{C78B5607-CDDE-4196-8A0D-B688CBE6C593}" presName="Name9" presStyleLbl="parChTrans1D2" presStyleIdx="5" presStyleCnt="7"/>
      <dgm:spPr/>
      <dgm:t>
        <a:bodyPr/>
        <a:lstStyle/>
        <a:p>
          <a:endParaRPr lang="en-US"/>
        </a:p>
      </dgm:t>
    </dgm:pt>
    <dgm:pt modelId="{57EB1BBF-614D-4952-89F0-BBF334333B17}" type="pres">
      <dgm:prSet presAssocID="{C78B5607-CDDE-4196-8A0D-B688CBE6C593}" presName="connTx" presStyleLbl="parChTrans1D2" presStyleIdx="5" presStyleCnt="7"/>
      <dgm:spPr/>
      <dgm:t>
        <a:bodyPr/>
        <a:lstStyle/>
        <a:p>
          <a:endParaRPr lang="en-US"/>
        </a:p>
      </dgm:t>
    </dgm:pt>
    <dgm:pt modelId="{5EB37EE2-6F89-4A55-9BC6-DC1661F9DF7F}" type="pres">
      <dgm:prSet presAssocID="{DBFE4500-484C-4F54-8250-B072A9C73216}" presName="node" presStyleLbl="node1" presStyleIdx="5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8434D87-AFD1-4EF5-A43D-758FA5F8ABEC}" type="pres">
      <dgm:prSet presAssocID="{490D4522-31ED-4D8D-90F6-C9906A58611A}" presName="Name9" presStyleLbl="parChTrans1D2" presStyleIdx="6" presStyleCnt="7"/>
      <dgm:spPr/>
      <dgm:t>
        <a:bodyPr/>
        <a:lstStyle/>
        <a:p>
          <a:endParaRPr lang="en-US"/>
        </a:p>
      </dgm:t>
    </dgm:pt>
    <dgm:pt modelId="{8FFFDEFC-E8F2-4AF1-9EA9-F81F1F984EB3}" type="pres">
      <dgm:prSet presAssocID="{490D4522-31ED-4D8D-90F6-C9906A58611A}" presName="connTx" presStyleLbl="parChTrans1D2" presStyleIdx="6" presStyleCnt="7"/>
      <dgm:spPr/>
      <dgm:t>
        <a:bodyPr/>
        <a:lstStyle/>
        <a:p>
          <a:endParaRPr lang="en-US"/>
        </a:p>
      </dgm:t>
    </dgm:pt>
    <dgm:pt modelId="{C77A6BB7-94CC-4B0D-920F-968DC5D4C628}" type="pres">
      <dgm:prSet presAssocID="{28E5EB1A-6B59-48F6-961A-FA866485A4DD}" presName="node" presStyleLbl="node1" presStyleIdx="6" presStyleCnt="7" custScaleX="108924" custScaleY="108924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89AE5323-1452-4510-A676-D49F09E7286F}" type="presOf" srcId="{F1956370-2A2A-4C18-9AEA-97727139842C}" destId="{870943AF-FD53-470D-8ACD-3302F8EF16F5}" srcOrd="0" destOrd="0" presId="urn:microsoft.com/office/officeart/2005/8/layout/radial1"/>
    <dgm:cxn modelId="{85378451-E46A-457F-881A-AC0EBDD246B2}" type="presOf" srcId="{C78B5607-CDDE-4196-8A0D-B688CBE6C593}" destId="{57EB1BBF-614D-4952-89F0-BBF334333B17}" srcOrd="1" destOrd="0" presId="urn:microsoft.com/office/officeart/2005/8/layout/radial1"/>
    <dgm:cxn modelId="{CABF20B9-9F5D-44B9-8A0D-BF39D9D01932}" type="presOf" srcId="{58D6FE09-747B-4E4A-A1D8-AE0B08FCDEDC}" destId="{C8C30482-5089-43AA-83AF-7643C2B1E73C}" srcOrd="1" destOrd="0" presId="urn:microsoft.com/office/officeart/2005/8/layout/radial1"/>
    <dgm:cxn modelId="{29ECD5B9-3D86-48B8-9AB9-E5095BAF1250}" type="presOf" srcId="{38540EE7-2272-4AE8-B809-BB7C7F69AF80}" destId="{689283B0-1572-4BB1-A618-E0830C3189E2}" srcOrd="0" destOrd="0" presId="urn:microsoft.com/office/officeart/2005/8/layout/radial1"/>
    <dgm:cxn modelId="{42DEA34B-946D-458A-B542-9C510AB6DF9C}" type="presOf" srcId="{DBFE4500-484C-4F54-8250-B072A9C73216}" destId="{5EB37EE2-6F89-4A55-9BC6-DC1661F9DF7F}" srcOrd="0" destOrd="0" presId="urn:microsoft.com/office/officeart/2005/8/layout/radial1"/>
    <dgm:cxn modelId="{8B40454C-8E83-414B-929C-1649A67D533C}" srcId="{13D93C37-AC0B-4542-AF9C-D5FF902741DA}" destId="{76993CC8-F38B-4E73-AEA4-70805117DDB0}" srcOrd="3" destOrd="0" parTransId="{8AC4E558-74AB-4D02-AF1B-70140DDA9271}" sibTransId="{C128094F-EDD5-4CAB-A538-B81C423CC2D2}"/>
    <dgm:cxn modelId="{3FB7F908-FD30-4E26-A896-0F982C3DB372}" type="presOf" srcId="{28E5EB1A-6B59-48F6-961A-FA866485A4DD}" destId="{C77A6BB7-94CC-4B0D-920F-968DC5D4C628}" srcOrd="0" destOrd="0" presId="urn:microsoft.com/office/officeart/2005/8/layout/radial1"/>
    <dgm:cxn modelId="{FEBC7E1D-0BD9-41E1-B7DF-40E3D99E9BC2}" type="presOf" srcId="{58D6FE09-747B-4E4A-A1D8-AE0B08FCDEDC}" destId="{D0E3944F-3EF5-427B-A95C-C4A7D5AE71EC}" srcOrd="0" destOrd="0" presId="urn:microsoft.com/office/officeart/2005/8/layout/radial1"/>
    <dgm:cxn modelId="{2890B22B-9F38-49FB-AE68-0E87AE082188}" srcId="{13D93C37-AC0B-4542-AF9C-D5FF902741DA}" destId="{DBFE4500-484C-4F54-8250-B072A9C73216}" srcOrd="5" destOrd="0" parTransId="{C78B5607-CDDE-4196-8A0D-B688CBE6C593}" sibTransId="{B026C885-7F7F-4319-B3F7-FE3C775F7A88}"/>
    <dgm:cxn modelId="{30961733-E366-435C-B199-B48C34F5338F}" type="presOf" srcId="{490D4522-31ED-4D8D-90F6-C9906A58611A}" destId="{8FFFDEFC-E8F2-4AF1-9EA9-F81F1F984EB3}" srcOrd="1" destOrd="0" presId="urn:microsoft.com/office/officeart/2005/8/layout/radial1"/>
    <dgm:cxn modelId="{9932E90B-A5FC-48BE-BBF9-6DC41B27C2BB}" type="presOf" srcId="{702687E1-3154-46B0-9D5A-4B4ABF22426A}" destId="{62FE8F4D-E9C1-4689-ABA4-B6BB5A0C4C3D}" srcOrd="1" destOrd="0" presId="urn:microsoft.com/office/officeart/2005/8/layout/radial1"/>
    <dgm:cxn modelId="{FE5F29DB-259E-4463-83B3-E304784131A0}" type="presOf" srcId="{490D4522-31ED-4D8D-90F6-C9906A58611A}" destId="{98434D87-AFD1-4EF5-A43D-758FA5F8ABEC}" srcOrd="0" destOrd="0" presId="urn:microsoft.com/office/officeart/2005/8/layout/radial1"/>
    <dgm:cxn modelId="{5DADA0E9-6667-48FA-A483-BDB296897820}" type="presOf" srcId="{73749A64-D89A-4BEE-9BBC-591A7547AE39}" destId="{A6E00D07-35EE-4E7D-8366-EAD4683E578F}" srcOrd="0" destOrd="0" presId="urn:microsoft.com/office/officeart/2005/8/layout/radial1"/>
    <dgm:cxn modelId="{511CE25A-2742-400D-A028-0DD536C8CC37}" type="presOf" srcId="{702687E1-3154-46B0-9D5A-4B4ABF22426A}" destId="{BD4F5399-A3A8-4DF1-8EE1-D6860092DC85}" srcOrd="0" destOrd="0" presId="urn:microsoft.com/office/officeart/2005/8/layout/radial1"/>
    <dgm:cxn modelId="{13E00B84-3894-42F9-9368-0F5BECA5C7AB}" type="presOf" srcId="{12C95121-611D-4698-ABBA-F22B6AEB2CE9}" destId="{B8365D89-EA61-4589-BDA2-9CC000A423AE}" srcOrd="0" destOrd="0" presId="urn:microsoft.com/office/officeart/2005/8/layout/radial1"/>
    <dgm:cxn modelId="{B6628ADE-4700-4C3C-A74E-34B5593484C5}" type="presOf" srcId="{8AC4E558-74AB-4D02-AF1B-70140DDA9271}" destId="{C6928237-CF14-4EA8-83B5-6930CF641B6B}" srcOrd="0" destOrd="0" presId="urn:microsoft.com/office/officeart/2005/8/layout/radial1"/>
    <dgm:cxn modelId="{14913BF0-F236-4021-BAD7-EED4E3C0DC1B}" type="presOf" srcId="{8AC4E558-74AB-4D02-AF1B-70140DDA9271}" destId="{A593FF77-D56C-4A34-B57B-8A92B3AA579E}" srcOrd="1" destOrd="0" presId="urn:microsoft.com/office/officeart/2005/8/layout/radial1"/>
    <dgm:cxn modelId="{BDB22294-453E-429D-B590-1B1367BDEC4C}" srcId="{F1956370-2A2A-4C18-9AEA-97727139842C}" destId="{13D93C37-AC0B-4542-AF9C-D5FF902741DA}" srcOrd="0" destOrd="0" parTransId="{DACFB4E9-965D-4950-8376-2503F06140B4}" sibTransId="{312E98FF-85B7-4CDB-A490-0B2492750BAE}"/>
    <dgm:cxn modelId="{C265817E-F1B3-4166-A904-11A3EF43DA60}" type="presOf" srcId="{38540EE7-2272-4AE8-B809-BB7C7F69AF80}" destId="{113D72AA-3CBB-4144-BD3F-567237E79AA5}" srcOrd="1" destOrd="0" presId="urn:microsoft.com/office/officeart/2005/8/layout/radial1"/>
    <dgm:cxn modelId="{D4144B9F-FF7A-4B32-B27C-6CA5DC003E2A}" srcId="{13D93C37-AC0B-4542-AF9C-D5FF902741DA}" destId="{ACA723EE-E14D-4B4B-977F-7CD87A0AD761}" srcOrd="4" destOrd="0" parTransId="{702687E1-3154-46B0-9D5A-4B4ABF22426A}" sibTransId="{12E0ED85-A86F-4728-93C5-1CB78B4BBF8B}"/>
    <dgm:cxn modelId="{37167280-72E4-4B1E-B0A5-DA35A254CBD4}" srcId="{13D93C37-AC0B-4542-AF9C-D5FF902741DA}" destId="{73749A64-D89A-4BEE-9BBC-591A7547AE39}" srcOrd="1" destOrd="0" parTransId="{58D6FE09-747B-4E4A-A1D8-AE0B08FCDEDC}" sibTransId="{5F274D5A-D60E-471C-A2F9-7FF7DCB59447}"/>
    <dgm:cxn modelId="{E1E2E7F6-7A7D-435F-84F7-9455D31F3700}" type="presOf" srcId="{8C9B91F2-7D93-4D59-95BC-B490A747F2D6}" destId="{EE8975DE-FB20-4091-BAEC-782D0478AB39}" srcOrd="0" destOrd="0" presId="urn:microsoft.com/office/officeart/2005/8/layout/radial1"/>
    <dgm:cxn modelId="{C1161D29-851F-40E3-9388-41BA810743B8}" type="presOf" srcId="{13D93C37-AC0B-4542-AF9C-D5FF902741DA}" destId="{404826E5-96D3-4487-ABB1-4784E7FAF9BB}" srcOrd="0" destOrd="0" presId="urn:microsoft.com/office/officeart/2005/8/layout/radial1"/>
    <dgm:cxn modelId="{FC755BCA-634B-4CE2-B684-4498072AE2E9}" type="presOf" srcId="{ACA723EE-E14D-4B4B-977F-7CD87A0AD761}" destId="{749853BF-A175-4DF8-A8A0-538A28A00F2E}" srcOrd="0" destOrd="0" presId="urn:microsoft.com/office/officeart/2005/8/layout/radial1"/>
    <dgm:cxn modelId="{E1EAAC41-FF99-484A-91DA-18D1A22CE0EB}" type="presOf" srcId="{2B1E1BCC-6963-4675-8991-6A10A408E244}" destId="{50FE95C2-5D91-4648-BBB9-DA339C53BD77}" srcOrd="0" destOrd="0" presId="urn:microsoft.com/office/officeart/2005/8/layout/radial1"/>
    <dgm:cxn modelId="{74EB8CA5-9121-4AFB-AB76-84BACEECC45A}" type="presOf" srcId="{12C95121-611D-4698-ABBA-F22B6AEB2CE9}" destId="{4EE744B1-4666-4D1E-8791-2F5229DE42FB}" srcOrd="1" destOrd="0" presId="urn:microsoft.com/office/officeart/2005/8/layout/radial1"/>
    <dgm:cxn modelId="{0A1B26B1-A17D-495B-835F-B72B2E7C79C9}" srcId="{13D93C37-AC0B-4542-AF9C-D5FF902741DA}" destId="{28E5EB1A-6B59-48F6-961A-FA866485A4DD}" srcOrd="6" destOrd="0" parTransId="{490D4522-31ED-4D8D-90F6-C9906A58611A}" sibTransId="{83A92F69-26C6-4CF5-951B-DCF92E580BBD}"/>
    <dgm:cxn modelId="{4948623C-1891-41E3-AC92-F5BC53230B2C}" type="presOf" srcId="{C78B5607-CDDE-4196-8A0D-B688CBE6C593}" destId="{048CDA79-331F-4000-9D5E-79F2C95994C6}" srcOrd="0" destOrd="0" presId="urn:microsoft.com/office/officeart/2005/8/layout/radial1"/>
    <dgm:cxn modelId="{4CF696B6-4F5A-46EA-AFE9-84D321FFDB98}" srcId="{13D93C37-AC0B-4542-AF9C-D5FF902741DA}" destId="{2B1E1BCC-6963-4675-8991-6A10A408E244}" srcOrd="0" destOrd="0" parTransId="{38540EE7-2272-4AE8-B809-BB7C7F69AF80}" sibTransId="{77DD7E33-49AC-4B1A-A7C3-C80C348FD910}"/>
    <dgm:cxn modelId="{393C4782-C3E3-444E-AFD6-BA0FF656E250}" type="presOf" srcId="{76993CC8-F38B-4E73-AEA4-70805117DDB0}" destId="{8B80C6FD-C3D7-4E8C-9EA8-BE6C26B11A5F}" srcOrd="0" destOrd="0" presId="urn:microsoft.com/office/officeart/2005/8/layout/radial1"/>
    <dgm:cxn modelId="{9964D7B4-FDEC-448A-B147-477D478D1278}" srcId="{13D93C37-AC0B-4542-AF9C-D5FF902741DA}" destId="{8C9B91F2-7D93-4D59-95BC-B490A747F2D6}" srcOrd="2" destOrd="0" parTransId="{12C95121-611D-4698-ABBA-F22B6AEB2CE9}" sibTransId="{3E542EBB-212B-4E6C-ABDE-1AA0D6D2B9E7}"/>
    <dgm:cxn modelId="{70E7E0D8-500A-401B-8DAC-8EF8B83FA377}" type="presParOf" srcId="{870943AF-FD53-470D-8ACD-3302F8EF16F5}" destId="{404826E5-96D3-4487-ABB1-4784E7FAF9BB}" srcOrd="0" destOrd="0" presId="urn:microsoft.com/office/officeart/2005/8/layout/radial1"/>
    <dgm:cxn modelId="{E4A2F371-FF75-4116-8413-736F38E1B843}" type="presParOf" srcId="{870943AF-FD53-470D-8ACD-3302F8EF16F5}" destId="{689283B0-1572-4BB1-A618-E0830C3189E2}" srcOrd="1" destOrd="0" presId="urn:microsoft.com/office/officeart/2005/8/layout/radial1"/>
    <dgm:cxn modelId="{3D60CD23-E3A4-4797-A95C-475FF3DA8BB7}" type="presParOf" srcId="{689283B0-1572-4BB1-A618-E0830C3189E2}" destId="{113D72AA-3CBB-4144-BD3F-567237E79AA5}" srcOrd="0" destOrd="0" presId="urn:microsoft.com/office/officeart/2005/8/layout/radial1"/>
    <dgm:cxn modelId="{AC0F4A79-1D8B-4557-A882-7B5ECD1E9A28}" type="presParOf" srcId="{870943AF-FD53-470D-8ACD-3302F8EF16F5}" destId="{50FE95C2-5D91-4648-BBB9-DA339C53BD77}" srcOrd="2" destOrd="0" presId="urn:microsoft.com/office/officeart/2005/8/layout/radial1"/>
    <dgm:cxn modelId="{958B8466-3047-4364-8B3A-20E19D46EA87}" type="presParOf" srcId="{870943AF-FD53-470D-8ACD-3302F8EF16F5}" destId="{D0E3944F-3EF5-427B-A95C-C4A7D5AE71EC}" srcOrd="3" destOrd="0" presId="urn:microsoft.com/office/officeart/2005/8/layout/radial1"/>
    <dgm:cxn modelId="{BD6CB5E1-425D-460A-9FA2-DB44C65B8338}" type="presParOf" srcId="{D0E3944F-3EF5-427B-A95C-C4A7D5AE71EC}" destId="{C8C30482-5089-43AA-83AF-7643C2B1E73C}" srcOrd="0" destOrd="0" presId="urn:microsoft.com/office/officeart/2005/8/layout/radial1"/>
    <dgm:cxn modelId="{1FB23597-B005-4069-888B-21E90C008911}" type="presParOf" srcId="{870943AF-FD53-470D-8ACD-3302F8EF16F5}" destId="{A6E00D07-35EE-4E7D-8366-EAD4683E578F}" srcOrd="4" destOrd="0" presId="urn:microsoft.com/office/officeart/2005/8/layout/radial1"/>
    <dgm:cxn modelId="{3D7CF5C6-9E37-4F69-9FD7-633B411BEF85}" type="presParOf" srcId="{870943AF-FD53-470D-8ACD-3302F8EF16F5}" destId="{B8365D89-EA61-4589-BDA2-9CC000A423AE}" srcOrd="5" destOrd="0" presId="urn:microsoft.com/office/officeart/2005/8/layout/radial1"/>
    <dgm:cxn modelId="{96C12973-526A-48A8-9872-E3494A882E30}" type="presParOf" srcId="{B8365D89-EA61-4589-BDA2-9CC000A423AE}" destId="{4EE744B1-4666-4D1E-8791-2F5229DE42FB}" srcOrd="0" destOrd="0" presId="urn:microsoft.com/office/officeart/2005/8/layout/radial1"/>
    <dgm:cxn modelId="{573527E3-DECF-4DF6-9C4D-F1DF6A5EDCB6}" type="presParOf" srcId="{870943AF-FD53-470D-8ACD-3302F8EF16F5}" destId="{EE8975DE-FB20-4091-BAEC-782D0478AB39}" srcOrd="6" destOrd="0" presId="urn:microsoft.com/office/officeart/2005/8/layout/radial1"/>
    <dgm:cxn modelId="{E4DCE054-1B19-4D23-BCDB-EE52654750F2}" type="presParOf" srcId="{870943AF-FD53-470D-8ACD-3302F8EF16F5}" destId="{C6928237-CF14-4EA8-83B5-6930CF641B6B}" srcOrd="7" destOrd="0" presId="urn:microsoft.com/office/officeart/2005/8/layout/radial1"/>
    <dgm:cxn modelId="{EF33847D-4970-4FA3-85DA-5F816F02D179}" type="presParOf" srcId="{C6928237-CF14-4EA8-83B5-6930CF641B6B}" destId="{A593FF77-D56C-4A34-B57B-8A92B3AA579E}" srcOrd="0" destOrd="0" presId="urn:microsoft.com/office/officeart/2005/8/layout/radial1"/>
    <dgm:cxn modelId="{77DA7C4C-7DC7-4946-B4EA-446C2CA343A8}" type="presParOf" srcId="{870943AF-FD53-470D-8ACD-3302F8EF16F5}" destId="{8B80C6FD-C3D7-4E8C-9EA8-BE6C26B11A5F}" srcOrd="8" destOrd="0" presId="urn:microsoft.com/office/officeart/2005/8/layout/radial1"/>
    <dgm:cxn modelId="{AE98677A-8826-4602-A783-B9FB5812B189}" type="presParOf" srcId="{870943AF-FD53-470D-8ACD-3302F8EF16F5}" destId="{BD4F5399-A3A8-4DF1-8EE1-D6860092DC85}" srcOrd="9" destOrd="0" presId="urn:microsoft.com/office/officeart/2005/8/layout/radial1"/>
    <dgm:cxn modelId="{46D4B27E-64BC-43F0-BE67-CC867EDE8EB1}" type="presParOf" srcId="{BD4F5399-A3A8-4DF1-8EE1-D6860092DC85}" destId="{62FE8F4D-E9C1-4689-ABA4-B6BB5A0C4C3D}" srcOrd="0" destOrd="0" presId="urn:microsoft.com/office/officeart/2005/8/layout/radial1"/>
    <dgm:cxn modelId="{DBF2BA99-9408-4975-8D6C-F21A4F5BF003}" type="presParOf" srcId="{870943AF-FD53-470D-8ACD-3302F8EF16F5}" destId="{749853BF-A175-4DF8-A8A0-538A28A00F2E}" srcOrd="10" destOrd="0" presId="urn:microsoft.com/office/officeart/2005/8/layout/radial1"/>
    <dgm:cxn modelId="{FCB9C5ED-C2F6-4C88-8097-56047660948F}" type="presParOf" srcId="{870943AF-FD53-470D-8ACD-3302F8EF16F5}" destId="{048CDA79-331F-4000-9D5E-79F2C95994C6}" srcOrd="11" destOrd="0" presId="urn:microsoft.com/office/officeart/2005/8/layout/radial1"/>
    <dgm:cxn modelId="{BB030315-ECBE-4A3B-897E-D39FB409C482}" type="presParOf" srcId="{048CDA79-331F-4000-9D5E-79F2C95994C6}" destId="{57EB1BBF-614D-4952-89F0-BBF334333B17}" srcOrd="0" destOrd="0" presId="urn:microsoft.com/office/officeart/2005/8/layout/radial1"/>
    <dgm:cxn modelId="{4CC11219-A09A-479A-868E-ABC1074B54BB}" type="presParOf" srcId="{870943AF-FD53-470D-8ACD-3302F8EF16F5}" destId="{5EB37EE2-6F89-4A55-9BC6-DC1661F9DF7F}" srcOrd="12" destOrd="0" presId="urn:microsoft.com/office/officeart/2005/8/layout/radial1"/>
    <dgm:cxn modelId="{9901C6B7-08D5-43B3-95D0-DE56AE7A276D}" type="presParOf" srcId="{870943AF-FD53-470D-8ACD-3302F8EF16F5}" destId="{98434D87-AFD1-4EF5-A43D-758FA5F8ABEC}" srcOrd="13" destOrd="0" presId="urn:microsoft.com/office/officeart/2005/8/layout/radial1"/>
    <dgm:cxn modelId="{013ADB6D-A842-4082-9539-023D81FBBFEE}" type="presParOf" srcId="{98434D87-AFD1-4EF5-A43D-758FA5F8ABEC}" destId="{8FFFDEFC-E8F2-4AF1-9EA9-F81F1F984EB3}" srcOrd="0" destOrd="0" presId="urn:microsoft.com/office/officeart/2005/8/layout/radial1"/>
    <dgm:cxn modelId="{2272F879-6D6F-4494-8CC0-E405AD723515}" type="presParOf" srcId="{870943AF-FD53-470D-8ACD-3302F8EF16F5}" destId="{C77A6BB7-94CC-4B0D-920F-968DC5D4C628}" srcOrd="14" destOrd="0" presId="urn:microsoft.com/office/officeart/2005/8/layout/radial1"/>
  </dgm:cxnLst>
  <dgm:bg>
    <a:solidFill>
      <a:schemeClr val="bg1">
        <a:lumMod val="50000"/>
        <a:lumOff val="50000"/>
        <a:alpha val="0"/>
      </a:schemeClr>
    </a:solidFill>
    <a:effectLst>
      <a:glow rad="63500">
        <a:schemeClr val="accent1">
          <a:alpha val="40000"/>
        </a:schemeClr>
      </a:glow>
      <a:softEdge rad="63500"/>
    </a:effectLst>
  </dgm:bg>
  <dgm:whole>
    <a:ln cap="rnd"/>
  </dgm:whole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04826E5-96D3-4487-ABB1-4784E7FAF9BB}">
      <dsp:nvSpPr>
        <dsp:cNvPr id="0" name=""/>
        <dsp:cNvSpPr/>
      </dsp:nvSpPr>
      <dsp:spPr>
        <a:xfrm>
          <a:off x="3727632" y="1966320"/>
          <a:ext cx="1309593" cy="1309593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700" tIns="12700" rIns="12700" bIns="12700" numCol="1" spcCol="1270" anchor="ctr" anchorCtr="0">
          <a:noAutofit/>
        </a:bodyPr>
        <a:lstStyle/>
        <a:p>
          <a:pPr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000" kern="1200" dirty="0" smtClean="0"/>
            <a:t>Wrist Fracture</a:t>
          </a:r>
          <a:endParaRPr lang="en-US" sz="2000" kern="1200" dirty="0"/>
        </a:p>
      </dsp:txBody>
      <dsp:txXfrm>
        <a:off x="3919417" y="2158105"/>
        <a:ext cx="926023" cy="926023"/>
      </dsp:txXfrm>
    </dsp:sp>
    <dsp:sp modelId="{689283B0-1572-4BB1-A618-E0830C3189E2}">
      <dsp:nvSpPr>
        <dsp:cNvPr id="0" name=""/>
        <dsp:cNvSpPr/>
      </dsp:nvSpPr>
      <dsp:spPr>
        <a:xfrm rot="16200000">
          <a:off x="4085492" y="1655936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367582" y="1654536"/>
        <a:ext cx="29693" cy="29693"/>
      </dsp:txXfrm>
    </dsp:sp>
    <dsp:sp modelId="{50FE95C2-5D91-4648-BBB9-DA339C53BD77}">
      <dsp:nvSpPr>
        <dsp:cNvPr id="0" name=""/>
        <dsp:cNvSpPr/>
      </dsp:nvSpPr>
      <dsp:spPr>
        <a:xfrm>
          <a:off x="3669198" y="-54014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Objectives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3878098" y="154886"/>
        <a:ext cx="1008661" cy="1008661"/>
      </dsp:txXfrm>
    </dsp:sp>
    <dsp:sp modelId="{D0E3944F-3EF5-427B-A95C-C4A7D5AE71EC}">
      <dsp:nvSpPr>
        <dsp:cNvPr id="0" name=""/>
        <dsp:cNvSpPr/>
      </dsp:nvSpPr>
      <dsp:spPr>
        <a:xfrm rot="19285714">
          <a:off x="4829587" y="2014273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111677" y="2012873"/>
        <a:ext cx="29693" cy="29693"/>
      </dsp:txXfrm>
    </dsp:sp>
    <dsp:sp modelId="{A6E00D07-35EE-4E7D-8366-EAD4683E578F}">
      <dsp:nvSpPr>
        <dsp:cNvPr id="0" name=""/>
        <dsp:cNvSpPr/>
      </dsp:nvSpPr>
      <dsp:spPr>
        <a:xfrm>
          <a:off x="5203073" y="684661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Physical Exam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5411973" y="893561"/>
        <a:ext cx="1008661" cy="1008661"/>
      </dsp:txXfrm>
    </dsp:sp>
    <dsp:sp modelId="{B8365D89-EA61-4589-BDA2-9CC000A423AE}">
      <dsp:nvSpPr>
        <dsp:cNvPr id="0" name=""/>
        <dsp:cNvSpPr/>
      </dsp:nvSpPr>
      <dsp:spPr>
        <a:xfrm rot="771429">
          <a:off x="5013363" y="2819449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295453" y="2818050"/>
        <a:ext cx="29693" cy="29693"/>
      </dsp:txXfrm>
    </dsp:sp>
    <dsp:sp modelId="{EE8975DE-FB20-4091-BAEC-782D0478AB39}">
      <dsp:nvSpPr>
        <dsp:cNvPr id="0" name=""/>
        <dsp:cNvSpPr/>
      </dsp:nvSpPr>
      <dsp:spPr>
        <a:xfrm>
          <a:off x="5581909" y="2344449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Acute Carpal Tunnel Syndrome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5790809" y="2553349"/>
        <a:ext cx="1008661" cy="1008661"/>
      </dsp:txXfrm>
    </dsp:sp>
    <dsp:sp modelId="{C6928237-CF14-4EA8-83B5-6930CF641B6B}">
      <dsp:nvSpPr>
        <dsp:cNvPr id="0" name=""/>
        <dsp:cNvSpPr/>
      </dsp:nvSpPr>
      <dsp:spPr>
        <a:xfrm rot="3857143">
          <a:off x="4498433" y="3465151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780523" y="3463751"/>
        <a:ext cx="29693" cy="29693"/>
      </dsp:txXfrm>
    </dsp:sp>
    <dsp:sp modelId="{8B80C6FD-C3D7-4E8C-9EA8-BE6C26B11A5F}">
      <dsp:nvSpPr>
        <dsp:cNvPr id="0" name=""/>
        <dsp:cNvSpPr/>
      </dsp:nvSpPr>
      <dsp:spPr>
        <a:xfrm rot="60000">
          <a:off x="4520434" y="3675496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Radio-graphic Exam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4729334" y="3884396"/>
        <a:ext cx="1008661" cy="1008661"/>
      </dsp:txXfrm>
    </dsp:sp>
    <dsp:sp modelId="{BD4F5399-A3A8-4DF1-8EE1-D6860092DC85}">
      <dsp:nvSpPr>
        <dsp:cNvPr id="0" name=""/>
        <dsp:cNvSpPr/>
      </dsp:nvSpPr>
      <dsp:spPr>
        <a:xfrm rot="6942857">
          <a:off x="3672551" y="3465151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 rot="10800000">
        <a:off x="3954640" y="3463751"/>
        <a:ext cx="29693" cy="29693"/>
      </dsp:txXfrm>
    </dsp:sp>
    <dsp:sp modelId="{749853BF-A175-4DF8-A8A0-538A28A00F2E}">
      <dsp:nvSpPr>
        <dsp:cNvPr id="0" name=""/>
        <dsp:cNvSpPr/>
      </dsp:nvSpPr>
      <dsp:spPr>
        <a:xfrm>
          <a:off x="2817961" y="3675496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Types of Wrist Fracture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3026861" y="3884396"/>
        <a:ext cx="1008661" cy="1008661"/>
      </dsp:txXfrm>
    </dsp:sp>
    <dsp:sp modelId="{048CDA79-331F-4000-9D5E-79F2C95994C6}">
      <dsp:nvSpPr>
        <dsp:cNvPr id="0" name=""/>
        <dsp:cNvSpPr/>
      </dsp:nvSpPr>
      <dsp:spPr>
        <a:xfrm rot="10028571">
          <a:off x="3157621" y="2819449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 rot="10800000">
        <a:off x="3439711" y="2818050"/>
        <a:ext cx="29693" cy="29693"/>
      </dsp:txXfrm>
    </dsp:sp>
    <dsp:sp modelId="{5EB37EE2-6F89-4A55-9BC6-DC1661F9DF7F}">
      <dsp:nvSpPr>
        <dsp:cNvPr id="0" name=""/>
        <dsp:cNvSpPr/>
      </dsp:nvSpPr>
      <dsp:spPr>
        <a:xfrm>
          <a:off x="1756487" y="2344449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Manage-</a:t>
          </a:r>
          <a:r>
            <a:rPr lang="en-US" sz="1500" b="1" kern="1200" dirty="0" err="1" smtClean="0">
              <a:solidFill>
                <a:schemeClr val="bg1"/>
              </a:solidFill>
            </a:rPr>
            <a:t>ment</a:t>
          </a:r>
          <a:endParaRPr lang="en-US" sz="1500" b="1" kern="1200" dirty="0" smtClean="0">
            <a:solidFill>
              <a:schemeClr val="bg1"/>
            </a:solidFill>
          </a:endParaRPr>
        </a:p>
      </dsp:txBody>
      <dsp:txXfrm>
        <a:off x="1965387" y="2553349"/>
        <a:ext cx="1008661" cy="1008661"/>
      </dsp:txXfrm>
    </dsp:sp>
    <dsp:sp modelId="{98434D87-AFD1-4EF5-A43D-758FA5F8ABEC}">
      <dsp:nvSpPr>
        <dsp:cNvPr id="0" name=""/>
        <dsp:cNvSpPr/>
      </dsp:nvSpPr>
      <dsp:spPr>
        <a:xfrm rot="13114286">
          <a:off x="3341397" y="2014273"/>
          <a:ext cx="593872" cy="26894"/>
        </a:xfrm>
        <a:custGeom>
          <a:avLst/>
          <a:gdLst/>
          <a:ahLst/>
          <a:cxnLst/>
          <a:rect l="0" t="0" r="0" b="0"/>
          <a:pathLst>
            <a:path>
              <a:moveTo>
                <a:pt x="0" y="13447"/>
              </a:moveTo>
              <a:lnTo>
                <a:pt x="593872" y="13447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 rot="10800000">
        <a:off x="3623487" y="2012873"/>
        <a:ext cx="29693" cy="29693"/>
      </dsp:txXfrm>
    </dsp:sp>
    <dsp:sp modelId="{C77A6BB7-94CC-4B0D-920F-968DC5D4C628}">
      <dsp:nvSpPr>
        <dsp:cNvPr id="0" name=""/>
        <dsp:cNvSpPr/>
      </dsp:nvSpPr>
      <dsp:spPr>
        <a:xfrm>
          <a:off x="2135323" y="684661"/>
          <a:ext cx="1426461" cy="1426461"/>
        </a:xfrm>
        <a:prstGeom prst="ellipse">
          <a:avLst/>
        </a:prstGeom>
        <a:blipFill dpi="0" rotWithShape="0">
          <a:blip xmlns:r="http://schemas.openxmlformats.org/officeDocument/2006/relationships" r:embed="rId1"/>
          <a:srcRect/>
          <a:tile tx="0" ty="0" sx="100000" sy="100000" flip="none" algn="tl"/>
        </a:blipFill>
        <a:ln w="25400" cap="flat" cmpd="sng" algn="ctr">
          <a:noFill/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b="1" kern="1200" dirty="0" smtClean="0">
              <a:solidFill>
                <a:schemeClr val="bg1"/>
              </a:solidFill>
            </a:rPr>
            <a:t>Self-Assessment</a:t>
          </a:r>
          <a:endParaRPr lang="en-US" sz="1500" b="1" kern="1200" dirty="0">
            <a:solidFill>
              <a:schemeClr val="bg1"/>
            </a:solidFill>
          </a:endParaRPr>
        </a:p>
      </dsp:txBody>
      <dsp:txXfrm>
        <a:off x="2344223" y="893561"/>
        <a:ext cx="1008661" cy="100866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1">
  <dgm:title val=""/>
  <dgm:desc val=""/>
  <dgm:catLst>
    <dgm:cat type="relationship" pri="22000"/>
    <dgm:cat type="cycle" pri="1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ycle">
    <dgm:varLst>
      <dgm:chMax val="1"/>
      <dgm:dir/>
      <dgm:animLvl val="ctr"/>
      <dgm:resizeHandles val="exact"/>
    </dgm:varLst>
    <dgm:choose name="Name0">
      <dgm:if name="Name1" func="var" arg="dir" op="equ" val="norm">
        <dgm:choose name="Name2">
          <dgm:if name="Name3" axis="ch ch" ptType="node node" st="1 1" cnt="1 0" func="cnt" op="lte" val="1">
            <dgm:alg type="cycle">
              <dgm:param type="stAng" val="90"/>
              <dgm:param type="spanAng" val="360"/>
              <dgm:param type="ctrShpMap" val="fNode"/>
            </dgm:alg>
          </dgm:if>
          <dgm:else name="Name4">
            <dgm:alg type="cycle">
              <dgm:param type="stAng" val="0"/>
              <dgm:param type="spanAng" val="360"/>
              <dgm:param type="ctrShpMap" val="fNode"/>
            </dgm:alg>
          </dgm:else>
        </dgm:choose>
      </dgm:if>
      <dgm:else name="Name5">
        <dgm:alg type="cycle">
          <dgm:param type="stAng" val="0"/>
          <dgm:param type="spanAng" val="-360"/>
          <dgm:param type="ctrShpMap" val="fNode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enterShape" refType="w"/>
      <dgm:constr type="w" for="ch" forName="node" refType="w" refFor="ch" refForName="centerShape" op="equ"/>
      <dgm:constr type="sp" refType="w" refFor="ch" refForName="node" fact="0.3"/>
      <dgm:constr type="sibSp" refType="w" refFor="ch" refForName="node" fact="0.3"/>
      <dgm:constr type="primFontSz" for="ch" forName="centerShape" val="65"/>
      <dgm:constr type="primFontSz" for="des" forName="node" op="equ" val="65"/>
      <dgm:constr type="primFontSz" for="des" forName="connTx" val="55"/>
      <dgm:constr type="primFontSz" for="des" forName="connTx" refType="primFontSz" refFor="ch" refForName="centerShape" op="lte" fact="0.8"/>
    </dgm:constrLst>
    <dgm:ruleLst/>
    <dgm:forEach name="Name6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h" refType="w"/>
          <dgm:constr type="tMarg" refType="primFontSz" fact="0.05"/>
          <dgm:constr type="bMarg" refType="primFontSz" fact="0.05"/>
          <dgm:constr type="lMarg" refType="primFontSz" fact="0.05"/>
          <dgm:constr type="rMarg" refType="primFontSz" fact="0.05"/>
        </dgm:constrLst>
        <dgm:ruleLst>
          <dgm:rule type="primFontSz" val="5" fact="NaN" max="NaN"/>
        </dgm:ruleLst>
      </dgm:layoutNode>
      <dgm:forEach name="Name7" axis="ch">
        <dgm:forEach name="Name8" axis="self" ptType="parTrans">
          <dgm:layoutNode name="Name9">
            <dgm:alg type="conn">
              <dgm:param type="dim" val="1D"/>
              <dgm:param type="begPts" val="auto"/>
              <dgm:param type="endPts" val="auto"/>
              <dgm:param type="begSty" val="noArr"/>
              <dgm:param type="endSty" val="noArr"/>
            </dgm:alg>
            <dgm:shape xmlns:r="http://schemas.openxmlformats.org/officeDocument/2006/relationships" type="conn" r:blip="">
              <dgm:adjLst/>
            </dgm:shape>
            <dgm:presOf axis="self"/>
            <dgm:constrLst>
              <dgm:constr type="connDist"/>
              <dgm:constr type="userA" for="ch" refType="connDist"/>
              <dgm:constr type="w" val="1"/>
              <dgm:constr type="h" val="5"/>
              <dgm:constr type="begPad"/>
              <dgm:constr type="endPad"/>
            </dgm:constrLst>
            <dgm:ruleLst/>
            <dgm:layoutNode name="connTx">
              <dgm:alg type="tx">
                <dgm:param type="autoTxRot" val="grav"/>
              </dgm:alg>
              <dgm:shape xmlns:r="http://schemas.openxmlformats.org/officeDocument/2006/relationships" type="rect" r:blip="" hideGeom="1">
                <dgm:adjLst/>
              </dgm:shape>
              <dgm:presOf axis="self"/>
              <dgm:constrLst>
                <dgm:constr type="userA"/>
                <dgm:constr type="w" refType="userA" fact="0.05"/>
                <dgm:constr type="h" refType="userA" fact="0.05"/>
                <dgm:constr type="lMarg" val="1"/>
                <dgm:constr type="rMarg" val="1"/>
                <dgm:constr type="tMarg"/>
                <dgm:constr type="bMarg"/>
              </dgm:constrLst>
              <dgm:ruleLst>
                <dgm:rule type="w" val="NaN" fact="0.8" max="NaN"/>
                <dgm:rule type="h" val="NaN" fact="1" max="NaN"/>
                <dgm:rule type="primFontSz" val="5" fact="NaN" max="NaN"/>
              </dgm:ruleLst>
            </dgm:layoutNode>
          </dgm:layoutNode>
        </dgm:forEach>
        <dgm:forEach name="Name10" axis="self" ptType="node">
          <dgm:layoutNode name="node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h" refType="w"/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</dgm:forEach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FFF98F-ED9B-40F1-A2EE-5ABAD993E4F8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0DA680-35A6-462E-A6AF-07000B401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6831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4D2BD1-6842-3D46-84A1-2E9F7CEF846D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17499B-74A4-054C-AF19-B99AA783B9A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524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.xml"/></Relationships>
</file>

<file path=ppt/notesSlides/_rels/notesSlide10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0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0.xml"/></Relationships>
</file>

<file path=ppt/notesSlides/_rels/notesSlide1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1.xml"/></Relationships>
</file>

<file path=ppt/notesSlides/_rels/notesSlide1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2.xml"/></Relationships>
</file>

<file path=ppt/notesSlides/_rels/notesSlide13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3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3.xml"/></Relationships>
</file>

<file path=ppt/notesSlides/_rels/notesSlide14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4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4.xml"/></Relationships>
</file>

<file path=ppt/notesSlides/_rels/notesSlide15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5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5.xml"/></Relationships>
</file>

<file path=ppt/notesSlides/_rels/notesSlide16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6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6.xml"/></Relationships>
</file>

<file path=ppt/notesSlides/_rels/notesSlide17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7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7.xml"/></Relationships>
</file>

<file path=ppt/notesSlides/_rels/notesSlide18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8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8.xml"/></Relationships>
</file>

<file path=ppt/notesSlides/_rels/notesSlide19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9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9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.xml"/></Relationships>
</file>

<file path=ppt/notesSlides/_rels/notesSlide20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0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0.xml"/></Relationships>
</file>

<file path=ppt/notesSlides/_rels/notesSlide2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1.xml"/></Relationships>
</file>

<file path=ppt/notesSlides/_rels/notesSlide2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2.xml"/></Relationships>
</file>

<file path=ppt/notesSlides/_rels/notesSlide23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3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3.xml"/></Relationships>
</file>

<file path=ppt/notesSlides/_rels/notesSlide24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4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4.xml"/></Relationships>
</file>

<file path=ppt/notesSlides/_rels/notesSlide25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5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5.xml"/></Relationships>
</file>

<file path=ppt/notesSlides/_rels/notesSlide26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6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6.xml"/></Relationships>
</file>

<file path=ppt/notesSlides/_rels/notesSlide27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7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7.xml"/></Relationships>
</file>

<file path=ppt/notesSlides/_rels/notesSlide28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8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8.xml"/></Relationships>
</file>

<file path=ppt/notesSlides/_rels/notesSlide29.xml.rels><?xml version="1.0" encoding="UTF-8" standalone="yes"?>
<Relationships xmlns="http://schemas.openxmlformats.org/package/2006/relationships"><Relationship Id="rId3" Type="http://schemas.openxmlformats.org/officeDocument/2006/relationships/slide" Target="../slides/slide29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29.xml"/></Relationships>
</file>

<file path=ppt/notesSlides/_rels/notesSlide3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.xml"/></Relationships>
</file>

<file path=ppt/notesSlides/_rels/notesSlide30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0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0.xml"/></Relationships>
</file>

<file path=ppt/notesSlides/_rels/notesSlide3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1.xml"/></Relationships>
</file>

<file path=ppt/notesSlides/_rels/notesSlide3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2.xml"/></Relationships>
</file>

<file path=ppt/notesSlides/_rels/notesSlide33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3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3.xml"/></Relationships>
</file>

<file path=ppt/notesSlides/_rels/notesSlide34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4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4.xml"/></Relationships>
</file>

<file path=ppt/notesSlides/_rels/notesSlide35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5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5.xml"/></Relationships>
</file>

<file path=ppt/notesSlides/_rels/notesSlide36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6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6.xml"/></Relationships>
</file>

<file path=ppt/notesSlides/_rels/notesSlide37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7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7.xml"/></Relationships>
</file>

<file path=ppt/notesSlides/_rels/notesSlide38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8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8.xml"/></Relationships>
</file>

<file path=ppt/notesSlides/_rels/notesSlide39.xml.rels><?xml version="1.0" encoding="UTF-8" standalone="yes"?>
<Relationships xmlns="http://schemas.openxmlformats.org/package/2006/relationships"><Relationship Id="rId3" Type="http://schemas.openxmlformats.org/officeDocument/2006/relationships/slide" Target="../slides/slide39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39.xml"/></Relationships>
</file>

<file path=ppt/notesSlides/_rels/notesSlide4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.xml"/></Relationships>
</file>

<file path=ppt/notesSlides/_rels/notesSlide40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0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0.xml"/></Relationships>
</file>

<file path=ppt/notesSlides/_rels/notesSlide4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1.xml"/></Relationships>
</file>

<file path=ppt/notesSlides/_rels/notesSlide42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2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2.xml"/></Relationships>
</file>

<file path=ppt/notesSlides/_rels/notesSlide43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3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3.xml"/></Relationships>
</file>

<file path=ppt/notesSlides/_rels/notesSlide44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4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4.xml"/></Relationships>
</file>

<file path=ppt/notesSlides/_rels/notesSlide45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5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5.xml"/></Relationships>
</file>

<file path=ppt/notesSlides/_rels/notesSlide46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6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6.xml"/></Relationships>
</file>

<file path=ppt/notesSlides/_rels/notesSlide47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7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7.xml"/></Relationships>
</file>

<file path=ppt/notesSlides/_rels/notesSlide48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8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8.xml"/></Relationships>
</file>

<file path=ppt/notesSlides/_rels/notesSlide49.xml.rels><?xml version="1.0" encoding="UTF-8" standalone="yes"?>
<Relationships xmlns="http://schemas.openxmlformats.org/package/2006/relationships"><Relationship Id="rId3" Type="http://schemas.openxmlformats.org/officeDocument/2006/relationships/slide" Target="../slides/slide49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49.xml"/></Relationships>
</file>

<file path=ppt/notesSlides/_rels/notesSlide5.xml.rels><?xml version="1.0" encoding="UTF-8" standalone="yes"?>
<Relationships xmlns="http://schemas.openxmlformats.org/package/2006/relationships"><Relationship Id="rId3" Type="http://schemas.openxmlformats.org/officeDocument/2006/relationships/slide" Target="../slides/slide5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5.xml"/></Relationships>
</file>

<file path=ppt/notesSlides/_rels/notesSlide6.xml.rels><?xml version="1.0" encoding="UTF-8" standalone="yes"?>
<Relationships xmlns="http://schemas.openxmlformats.org/package/2006/relationships"><Relationship Id="rId3" Type="http://schemas.openxmlformats.org/officeDocument/2006/relationships/slide" Target="../slides/slide6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6.xml"/></Relationships>
</file>

<file path=ppt/notesSlides/_rels/notesSlide7.xml.rels><?xml version="1.0" encoding="UTF-8" standalone="yes"?>
<Relationships xmlns="http://schemas.openxmlformats.org/package/2006/relationships"><Relationship Id="rId3" Type="http://schemas.openxmlformats.org/officeDocument/2006/relationships/slide" Target="../slides/slide7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7.xml"/></Relationships>
</file>

<file path=ppt/notesSlides/_rels/notesSlide8.xml.rels><?xml version="1.0" encoding="UTF-8" standalone="yes"?>
<Relationships xmlns="http://schemas.openxmlformats.org/package/2006/relationships"><Relationship Id="rId3" Type="http://schemas.openxmlformats.org/officeDocument/2006/relationships/slide" Target="../slides/slide8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8.xml"/></Relationships>
</file>

<file path=ppt/notesSlides/_rels/notesSlide9.xml.rels><?xml version="1.0" encoding="UTF-8" standalone="yes"?>
<Relationships xmlns="http://schemas.openxmlformats.org/package/2006/relationships"><Relationship Id="rId3" Type="http://schemas.openxmlformats.org/officeDocument/2006/relationships/slide" Target="../slides/slide9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8306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55530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85117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11948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228632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228632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>
                <a:solidFill>
                  <a:prstClr val="black"/>
                </a:solidFill>
              </a:rPr>
              <a:pPr/>
              <a:t>15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219651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657378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041739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68580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6858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144862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83061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347619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347619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317517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896976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056031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50849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030244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83061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774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964104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409280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523809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523809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523809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871504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609190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048240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306537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014432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5799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181569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50849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022465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20291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424099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545422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866695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43453"/>
      </p:ext>
    </p:extLst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379508"/>
      </p:ext>
    </p:extLst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210905"/>
      </p:ext>
    </p:extLst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>
                <a:solidFill>
                  <a:prstClr val="black"/>
                </a:solidFill>
              </a:rPr>
              <a:pPr/>
              <a:t>49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332142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22447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8688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7862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55080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  <p:custDataLst>
              <p:tags r:id="rId1"/>
            </p:custDataLst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17499B-74A4-054C-AF19-B99AA783B9AD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779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019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498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941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33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95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01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940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06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128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1161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574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bg1">
                <a:lumMod val="95000"/>
                <a:lumOff val="5000"/>
              </a:schemeClr>
            </a:gs>
            <a:gs pos="50000">
              <a:schemeClr val="bg1">
                <a:lumMod val="75000"/>
                <a:lumOff val="25000"/>
              </a:schemeClr>
            </a:gs>
            <a:gs pos="100000">
              <a:schemeClr val="bg1">
                <a:lumMod val="50000"/>
                <a:lumOff val="50000"/>
              </a:schemeClr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FECD78-3C8E-49F2-8FAB-59489D168ABB}" type="datetimeFigureOut">
              <a:rPr lang="en-US" smtClean="0"/>
              <a:pPr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B56013-B943-42BA-886F-6F9D4EB85E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711237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3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3.tif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5.tif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5.tif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7.tif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7.tif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6.xml"/><Relationship Id="rId4" Type="http://schemas.openxmlformats.org/officeDocument/2006/relationships/slide" Target="slide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6.xml"/><Relationship Id="rId4" Type="http://schemas.openxmlformats.org/officeDocument/2006/relationships/slide" Target="slide4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6.xml"/><Relationship Id="rId4" Type="http://schemas.openxmlformats.org/officeDocument/2006/relationships/slide" Target="slide4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6.xml"/><Relationship Id="rId4" Type="http://schemas.openxmlformats.org/officeDocument/2006/relationships/slide" Target="slide4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17.tif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6.xml"/><Relationship Id="rId5" Type="http://schemas.openxmlformats.org/officeDocument/2006/relationships/slide" Target="slide4.xml"/><Relationship Id="rId4" Type="http://schemas.openxmlformats.org/officeDocument/2006/relationships/image" Target="../media/image22.tiff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6.xml"/><Relationship Id="rId5" Type="http://schemas.openxmlformats.org/officeDocument/2006/relationships/slide" Target="slide4.xml"/><Relationship Id="rId4" Type="http://schemas.openxmlformats.org/officeDocument/2006/relationships/image" Target="../media/image23.tiff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" Target="slide4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slide" Target="slide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slide" Target="slide4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valuation of Wrist Injuries in the Urgent Setting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" name="Subtitle 2"/>
          <p:cNvSpPr>
            <a:spLocks noGrp="1"/>
          </p:cNvSpPr>
          <p:nvPr>
            <p:ph type="subTitle" idx="1"/>
          </p:nvPr>
        </p:nvSpPr>
        <p:spPr>
          <a:xfrm>
            <a:off x="1028700" y="3886200"/>
            <a:ext cx="7086600" cy="1143000"/>
          </a:xfrm>
        </p:spPr>
        <p:txBody>
          <a:bodyPr>
            <a:normAutofit lnSpcReduction="10000"/>
          </a:bodyPr>
          <a:lstStyle/>
          <a:p>
            <a:pPr lvl="0"/>
            <a:r>
              <a:rPr lang="en-US" sz="3600" i="1" dirty="0">
                <a:solidFill>
                  <a:prstClr val="white">
                    <a:tint val="75000"/>
                  </a:prst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 self-guided course for Primary Care </a:t>
            </a:r>
            <a:r>
              <a:rPr lang="en-US" sz="3600" i="1" dirty="0" smtClean="0">
                <a:solidFill>
                  <a:prstClr val="white">
                    <a:tint val="75000"/>
                  </a:prstClr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nd Emergency Medicine Providers</a:t>
            </a:r>
            <a:endParaRPr lang="en-US" sz="3600" i="1" dirty="0">
              <a:solidFill>
                <a:prstClr val="white">
                  <a:tint val="75000"/>
                </a:prstClr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701594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otor – Finger </a:t>
            </a:r>
            <a:r>
              <a:rPr lang="en-US" sz="4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ex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4" name="Picture 3" descr="IMG_7585.JPG"/>
          <p:cNvPicPr>
            <a:picLocks/>
          </p:cNvPicPr>
          <p:nvPr/>
        </p:nvPicPr>
        <p:blipFill>
          <a:blip r:embed="rId3"/>
          <a:srcRect l="13981" r="4088" b="16748"/>
          <a:stretch>
            <a:fillRect/>
          </a:stretch>
        </p:blipFill>
        <p:spPr>
          <a:xfrm>
            <a:off x="1371600" y="1371600"/>
            <a:ext cx="4114800" cy="41148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897880" y="2194560"/>
            <a:ext cx="2971800" cy="914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nterior </a:t>
            </a:r>
            <a:r>
              <a:rPr lang="en-US" dirty="0"/>
              <a:t>interosseous nerve is most distal branch of median nerv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6 of 8</a:t>
            </a:r>
            <a:endParaRPr lang="en-US" sz="1200" i="1" dirty="0"/>
          </a:p>
        </p:txBody>
      </p:sp>
      <p:sp>
        <p:nvSpPr>
          <p:cNvPr id="11" name="Rounded Rectangle 10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8" name="Rounded Rectangular Callout 7"/>
          <p:cNvSpPr/>
          <p:nvPr/>
        </p:nvSpPr>
        <p:spPr>
          <a:xfrm>
            <a:off x="5897880" y="3185160"/>
            <a:ext cx="2971800" cy="1805940"/>
          </a:xfrm>
          <a:prstGeom prst="wedgeRoundRectCallout">
            <a:avLst>
              <a:gd name="adj1" fmla="val -117638"/>
              <a:gd name="adj2" fmla="val 20442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Test resistance to breaking “OK” sign with thumb and index </a:t>
            </a:r>
            <a:r>
              <a:rPr lang="en-US" dirty="0" smtClean="0">
                <a:solidFill>
                  <a:prstClr val="white"/>
                </a:solidFill>
              </a:rPr>
              <a:t>finger, comparing with the other hand. Pain with resistance should be documented appropriately.</a:t>
            </a:r>
            <a:endParaRPr lang="en-US" dirty="0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otor – Finger Extens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5" name="Picture 4" descr="IMG_7586.JPG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0" y="1371600"/>
            <a:ext cx="4114800" cy="41148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897880" y="2194560"/>
            <a:ext cx="2971800" cy="9144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osterior </a:t>
            </a:r>
            <a:r>
              <a:rPr lang="en-US" dirty="0"/>
              <a:t>interosseous nerve is most distal branch of radial nerv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7 of 8</a:t>
            </a:r>
            <a:endParaRPr lang="en-US" sz="1200" i="1" dirty="0"/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8" name="Rounded Rectangular Callout 7"/>
          <p:cNvSpPr/>
          <p:nvPr/>
        </p:nvSpPr>
        <p:spPr>
          <a:xfrm>
            <a:off x="5907405" y="3179445"/>
            <a:ext cx="2971800" cy="1573530"/>
          </a:xfrm>
          <a:prstGeom prst="wedgeRoundRectCallout">
            <a:avLst>
              <a:gd name="adj1" fmla="val -159235"/>
              <a:gd name="adj2" fmla="val -2589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Test resistance to </a:t>
            </a:r>
            <a:r>
              <a:rPr lang="en-US" dirty="0" smtClean="0">
                <a:solidFill>
                  <a:prstClr val="white"/>
                </a:solidFill>
              </a:rPr>
              <a:t>“thumbs up”, </a:t>
            </a:r>
            <a:r>
              <a:rPr lang="en-US" dirty="0">
                <a:solidFill>
                  <a:prstClr val="white"/>
                </a:solidFill>
              </a:rPr>
              <a:t>comparing with </a:t>
            </a:r>
            <a:r>
              <a:rPr lang="en-US" dirty="0" smtClean="0">
                <a:solidFill>
                  <a:prstClr val="white"/>
                </a:solidFill>
              </a:rPr>
              <a:t>the other </a:t>
            </a:r>
            <a:r>
              <a:rPr lang="en-US" dirty="0">
                <a:solidFill>
                  <a:prstClr val="white"/>
                </a:solidFill>
              </a:rPr>
              <a:t>hand. Pain with resistance should be documented appropriately.</a:t>
            </a:r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IMG_7587.JPG"/>
          <p:cNvPicPr>
            <a:picLocks/>
          </p:cNvPicPr>
          <p:nvPr/>
        </p:nvPicPr>
        <p:blipFill>
          <a:blip r:embed="rId3"/>
          <a:srcRect l="8528" r="13011" b="3043"/>
          <a:stretch>
            <a:fillRect/>
          </a:stretch>
        </p:blipFill>
        <p:spPr>
          <a:xfrm>
            <a:off x="1371600" y="1371600"/>
            <a:ext cx="4114800" cy="411480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otor – Finger Spread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943600" y="2240280"/>
            <a:ext cx="29550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1"/>
            <a:r>
              <a:rPr lang="en-US" dirty="0" err="1" smtClean="0"/>
              <a:t>Interossei</a:t>
            </a:r>
            <a:r>
              <a:rPr lang="en-US" dirty="0" smtClean="0"/>
              <a:t> </a:t>
            </a:r>
            <a:r>
              <a:rPr lang="en-US" dirty="0"/>
              <a:t>muscles (ulnar nerve</a:t>
            </a:r>
            <a:r>
              <a:rPr lang="en-US" dirty="0" smtClean="0"/>
              <a:t>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8 of 8</a:t>
            </a:r>
            <a:endParaRPr lang="en-US" sz="1200" i="1" dirty="0"/>
          </a:p>
        </p:txBody>
      </p:sp>
      <p:sp>
        <p:nvSpPr>
          <p:cNvPr id="12" name="Rounded Rectangle 11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0" name="Rounded Rectangular Callout 9"/>
          <p:cNvSpPr/>
          <p:nvPr/>
        </p:nvSpPr>
        <p:spPr>
          <a:xfrm>
            <a:off x="5907405" y="3188969"/>
            <a:ext cx="2991267" cy="1564005"/>
          </a:xfrm>
          <a:prstGeom prst="wedgeRoundRectCallout">
            <a:avLst>
              <a:gd name="adj1" fmla="val -141880"/>
              <a:gd name="adj2" fmla="val 64389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US" sz="2800" dirty="0">
              <a:solidFill>
                <a:prstClr val="white"/>
              </a:solidFill>
            </a:endParaRPr>
          </a:p>
        </p:txBody>
      </p:sp>
      <p:sp>
        <p:nvSpPr>
          <p:cNvPr id="13" name="Rounded Rectangular Callout 12"/>
          <p:cNvSpPr/>
          <p:nvPr/>
        </p:nvSpPr>
        <p:spPr>
          <a:xfrm>
            <a:off x="5907405" y="3195636"/>
            <a:ext cx="2991267" cy="1557338"/>
          </a:xfrm>
          <a:prstGeom prst="wedgeRoundRectCallout">
            <a:avLst>
              <a:gd name="adj1" fmla="val -169259"/>
              <a:gd name="adj2" fmla="val 31175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US" sz="2800" dirty="0">
              <a:solidFill>
                <a:prstClr val="white"/>
              </a:solidFill>
            </a:endParaRPr>
          </a:p>
        </p:txBody>
      </p:sp>
      <p:sp>
        <p:nvSpPr>
          <p:cNvPr id="15" name="Rounded Rectangular Callout 14"/>
          <p:cNvSpPr/>
          <p:nvPr/>
        </p:nvSpPr>
        <p:spPr>
          <a:xfrm>
            <a:off x="5907405" y="3179445"/>
            <a:ext cx="2971800" cy="1573530"/>
          </a:xfrm>
          <a:prstGeom prst="wedgeRoundRectCallout">
            <a:avLst>
              <a:gd name="adj1" fmla="val -189363"/>
              <a:gd name="adj2" fmla="val -11365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Test resistance of spread </a:t>
            </a:r>
            <a:r>
              <a:rPr lang="en-US" dirty="0" smtClean="0">
                <a:solidFill>
                  <a:prstClr val="white"/>
                </a:solidFill>
              </a:rPr>
              <a:t>fingers, comparing </a:t>
            </a:r>
            <a:r>
              <a:rPr lang="en-US" dirty="0">
                <a:solidFill>
                  <a:prstClr val="white"/>
                </a:solidFill>
              </a:rPr>
              <a:t>with </a:t>
            </a:r>
            <a:r>
              <a:rPr lang="en-US" dirty="0" smtClean="0">
                <a:solidFill>
                  <a:prstClr val="white"/>
                </a:solidFill>
              </a:rPr>
              <a:t>the other </a:t>
            </a:r>
            <a:r>
              <a:rPr lang="en-US" dirty="0">
                <a:solidFill>
                  <a:prstClr val="white"/>
                </a:solidFill>
              </a:rPr>
              <a:t>hand. Pain with resistance should be documented appropriately.</a:t>
            </a:r>
          </a:p>
        </p:txBody>
      </p:sp>
    </p:spTree>
    <p:extLst>
      <p:ext uri="{BB962C8B-B14F-4D97-AF65-F5344CB8AC3E}">
        <p14:creationId xmlns:p14="http://schemas.microsoft.com/office/powerpoint/2010/main" val="4178442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lvl="0"/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cute Carpal Tunnel Syndrom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028" name="Picture 4" descr="S:\ort\File Transfers (Data Over 24 hrs is Removed Automatically)\Eileen to Dr. Anna Miller\Dr Miller wrist 2 020915.jpg"/>
          <p:cNvPicPr>
            <a:picLocks noChangeArrowheads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1463040"/>
            <a:ext cx="3546088" cy="411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313972" y="5585806"/>
            <a:ext cx="3431089" cy="70788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Reproduced with permission from Koman LA </a:t>
            </a:r>
            <a:r>
              <a:rPr lang="en-US" sz="1000" dirty="0" smtClean="0"/>
              <a:t>ed.</a:t>
            </a:r>
          </a:p>
          <a:p>
            <a:r>
              <a:rPr lang="en-US" sz="1000" dirty="0" smtClean="0"/>
              <a:t>Wake </a:t>
            </a:r>
            <a:r>
              <a:rPr lang="en-US" sz="1000" dirty="0"/>
              <a:t>Forest University Orthopaedic </a:t>
            </a:r>
            <a:r>
              <a:rPr lang="en-US" sz="1000" dirty="0" smtClean="0"/>
              <a:t> Manual</a:t>
            </a:r>
          </a:p>
          <a:p>
            <a:r>
              <a:rPr lang="en-US" sz="1000" dirty="0" smtClean="0"/>
              <a:t>Wake </a:t>
            </a:r>
            <a:r>
              <a:rPr lang="en-US" sz="1000" dirty="0"/>
              <a:t>Forest University Orthopaedic </a:t>
            </a:r>
            <a:r>
              <a:rPr lang="en-US" sz="1000" dirty="0" smtClean="0"/>
              <a:t>Press</a:t>
            </a:r>
          </a:p>
          <a:p>
            <a:r>
              <a:rPr lang="en-US" sz="1000" dirty="0" smtClean="0"/>
              <a:t>Winston-Salem</a:t>
            </a:r>
            <a:r>
              <a:rPr lang="en-US" sz="1000" dirty="0"/>
              <a:t>, NC, </a:t>
            </a:r>
            <a:r>
              <a:rPr lang="en-US" sz="1000" dirty="0" smtClean="0"/>
              <a:t>27157</a:t>
            </a:r>
            <a:endParaRPr lang="en-US" sz="1000" dirty="0"/>
          </a:p>
        </p:txBody>
      </p:sp>
      <p:sp>
        <p:nvSpPr>
          <p:cNvPr id="14" name="Rectangle 13"/>
          <p:cNvSpPr/>
          <p:nvPr/>
        </p:nvSpPr>
        <p:spPr>
          <a:xfrm>
            <a:off x="4114798" y="2615191"/>
            <a:ext cx="4754881" cy="25135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lvl="0" indent="-3429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/>
              <a:t>Can occur with original fracture displacement or during reduction</a:t>
            </a:r>
          </a:p>
          <a:p>
            <a:pPr marL="342900" lvl="0" indent="-3429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In </a:t>
            </a:r>
            <a:r>
              <a:rPr lang="en-US" sz="2400" dirty="0"/>
              <a:t>contrast to normal </a:t>
            </a:r>
            <a:r>
              <a:rPr lang="en-US" sz="2400" dirty="0" smtClean="0"/>
              <a:t>patients </a:t>
            </a:r>
            <a:r>
              <a:rPr lang="en-US" sz="2400" dirty="0"/>
              <a:t>with acute carpal tunnel, symptoms get WORSE, not better after reductio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Acute Carpal </a:t>
            </a:r>
            <a:r>
              <a:rPr lang="en-US" sz="1200" i="1" dirty="0"/>
              <a:t>T</a:t>
            </a:r>
            <a:r>
              <a:rPr lang="en-US" sz="1200" i="1" dirty="0" smtClean="0"/>
              <a:t>unnel</a:t>
            </a:r>
          </a:p>
          <a:p>
            <a:pPr algn="r"/>
            <a:r>
              <a:rPr lang="en-US" sz="1200" i="1" dirty="0" smtClean="0"/>
              <a:t>Slide 1 of 2</a:t>
            </a:r>
            <a:endParaRPr lang="en-US" sz="1200" i="1" dirty="0"/>
          </a:p>
        </p:txBody>
      </p:sp>
      <p:sp>
        <p:nvSpPr>
          <p:cNvPr id="3" name="TextBox 2"/>
          <p:cNvSpPr txBox="1"/>
          <p:nvPr/>
        </p:nvSpPr>
        <p:spPr>
          <a:xfrm>
            <a:off x="4114800" y="1784194"/>
            <a:ext cx="47548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u="sng" dirty="0">
                <a:solidFill>
                  <a:prstClr val="white"/>
                </a:solidFill>
                <a:ea typeface="+mj-ea"/>
                <a:cs typeface="+mj-cs"/>
              </a:rPr>
              <a:t>Rare</a:t>
            </a:r>
            <a:r>
              <a:rPr lang="en-US" sz="2400" b="1" dirty="0">
                <a:solidFill>
                  <a:prstClr val="white"/>
                </a:solidFill>
                <a:ea typeface="+mj-ea"/>
                <a:cs typeface="+mj-cs"/>
              </a:rPr>
              <a:t> complication from distal radius fracture</a:t>
            </a:r>
            <a:endParaRPr lang="en-US" sz="2400" b="1" dirty="0"/>
          </a:p>
        </p:txBody>
      </p:sp>
      <p:sp>
        <p:nvSpPr>
          <p:cNvPr id="10" name="Rounded Rectangle 9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2511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cute Carpal Tunnel Syndrom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1" name="Content Placeholder 10"/>
          <p:cNvSpPr>
            <a:spLocks noGrp="1"/>
          </p:cNvSpPr>
          <p:nvPr>
            <p:ph idx="1"/>
          </p:nvPr>
        </p:nvSpPr>
        <p:spPr>
          <a:xfrm>
            <a:off x="4114800" y="1993284"/>
            <a:ext cx="4750420" cy="3749594"/>
          </a:xfrm>
        </p:spPr>
        <p:txBody>
          <a:bodyPr>
            <a:noAutofit/>
          </a:bodyPr>
          <a:lstStyle/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Median nerve compression from displacement of fracture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Median nerve symptoms should resolve with fracture reduction normally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If symptoms do NOT resolve, patient needs emergent carpal tunnel release</a:t>
            </a:r>
            <a:endParaRPr lang="en-US" sz="2400" dirty="0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228600" y="1463040"/>
            <a:ext cx="2604533" cy="4114800"/>
            <a:chOff x="5029200" y="1197060"/>
            <a:chExt cx="3657600" cy="5778500"/>
          </a:xfrm>
        </p:grpSpPr>
        <p:grpSp>
          <p:nvGrpSpPr>
            <p:cNvPr id="7" name="Group 6"/>
            <p:cNvGrpSpPr/>
            <p:nvPr/>
          </p:nvGrpSpPr>
          <p:grpSpPr>
            <a:xfrm>
              <a:off x="5029200" y="1197060"/>
              <a:ext cx="3657600" cy="5778500"/>
              <a:chOff x="5029200" y="1197060"/>
              <a:chExt cx="3657600" cy="5778500"/>
            </a:xfrm>
          </p:grpSpPr>
          <p:pic>
            <p:nvPicPr>
              <p:cNvPr id="4" name="Picture 3" descr="acute CTS.tiff"/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29200" y="1197060"/>
                <a:ext cx="3657600" cy="5778500"/>
              </a:xfrm>
              <a:prstGeom prst="rect">
                <a:avLst/>
              </a:prstGeom>
            </p:spPr>
          </p:pic>
          <p:sp>
            <p:nvSpPr>
              <p:cNvPr id="6" name="Freeform 5"/>
              <p:cNvSpPr/>
              <p:nvPr/>
            </p:nvSpPr>
            <p:spPr>
              <a:xfrm>
                <a:off x="5442788" y="3744427"/>
                <a:ext cx="1232556" cy="2702500"/>
              </a:xfrm>
              <a:custGeom>
                <a:avLst/>
                <a:gdLst>
                  <a:gd name="connsiteX0" fmla="*/ 206832 w 1232556"/>
                  <a:gd name="connsiteY0" fmla="*/ 2702500 h 2702500"/>
                  <a:gd name="connsiteX1" fmla="*/ 27738 w 1232556"/>
                  <a:gd name="connsiteY1" fmla="*/ 1221009 h 2702500"/>
                  <a:gd name="connsiteX2" fmla="*/ 727835 w 1232556"/>
                  <a:gd name="connsiteY2" fmla="*/ 879127 h 2702500"/>
                  <a:gd name="connsiteX3" fmla="*/ 1232556 w 1232556"/>
                  <a:gd name="connsiteY3" fmla="*/ 0 h 2702500"/>
                  <a:gd name="connsiteX4" fmla="*/ 1232556 w 1232556"/>
                  <a:gd name="connsiteY4" fmla="*/ 0 h 27025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232556" h="2702500">
                    <a:moveTo>
                      <a:pt x="206832" y="2702500"/>
                    </a:moveTo>
                    <a:cubicBezTo>
                      <a:pt x="73868" y="2113702"/>
                      <a:pt x="-59096" y="1524904"/>
                      <a:pt x="27738" y="1221009"/>
                    </a:cubicBezTo>
                    <a:cubicBezTo>
                      <a:pt x="114572" y="917114"/>
                      <a:pt x="527032" y="1082628"/>
                      <a:pt x="727835" y="879127"/>
                    </a:cubicBezTo>
                    <a:cubicBezTo>
                      <a:pt x="928638" y="675626"/>
                      <a:pt x="1232556" y="0"/>
                      <a:pt x="1232556" y="0"/>
                    </a:cubicBezTo>
                    <a:lnTo>
                      <a:pt x="1232556" y="0"/>
                    </a:lnTo>
                  </a:path>
                </a:pathLst>
              </a:custGeom>
              <a:ln w="38100" cmpd="sng">
                <a:solidFill>
                  <a:srgbClr val="FFFF00"/>
                </a:solidFill>
                <a:prstDash val="sys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" name="Freeform 7"/>
            <p:cNvSpPr/>
            <p:nvPr/>
          </p:nvSpPr>
          <p:spPr>
            <a:xfrm>
              <a:off x="5942684" y="3695209"/>
              <a:ext cx="879192" cy="668895"/>
            </a:xfrm>
            <a:custGeom>
              <a:avLst/>
              <a:gdLst>
                <a:gd name="connsiteX0" fmla="*/ 0 w 879192"/>
                <a:gd name="connsiteY0" fmla="*/ 325980 h 668895"/>
                <a:gd name="connsiteX1" fmla="*/ 781504 w 879192"/>
                <a:gd name="connsiteY1" fmla="*/ 667863 h 668895"/>
                <a:gd name="connsiteX2" fmla="*/ 48844 w 879192"/>
                <a:gd name="connsiteY2" fmla="*/ 228300 h 668895"/>
                <a:gd name="connsiteX3" fmla="*/ 846629 w 879192"/>
                <a:gd name="connsiteY3" fmla="*/ 586462 h 668895"/>
                <a:gd name="connsiteX4" fmla="*/ 81407 w 879192"/>
                <a:gd name="connsiteY4" fmla="*/ 114339 h 668895"/>
                <a:gd name="connsiteX5" fmla="*/ 814067 w 879192"/>
                <a:gd name="connsiteY5" fmla="*/ 423661 h 668895"/>
                <a:gd name="connsiteX6" fmla="*/ 179095 w 879192"/>
                <a:gd name="connsiteY6" fmla="*/ 378 h 668895"/>
                <a:gd name="connsiteX7" fmla="*/ 879192 w 879192"/>
                <a:gd name="connsiteY7" fmla="*/ 342260 h 668895"/>
                <a:gd name="connsiteX8" fmla="*/ 879192 w 879192"/>
                <a:gd name="connsiteY8" fmla="*/ 342260 h 66889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879192" h="668895">
                  <a:moveTo>
                    <a:pt x="0" y="325980"/>
                  </a:moveTo>
                  <a:cubicBezTo>
                    <a:pt x="386681" y="505061"/>
                    <a:pt x="773363" y="684143"/>
                    <a:pt x="781504" y="667863"/>
                  </a:cubicBezTo>
                  <a:cubicBezTo>
                    <a:pt x="789645" y="651583"/>
                    <a:pt x="37990" y="241867"/>
                    <a:pt x="48844" y="228300"/>
                  </a:cubicBezTo>
                  <a:cubicBezTo>
                    <a:pt x="59698" y="214733"/>
                    <a:pt x="841202" y="605456"/>
                    <a:pt x="846629" y="586462"/>
                  </a:cubicBezTo>
                  <a:cubicBezTo>
                    <a:pt x="852056" y="567468"/>
                    <a:pt x="86834" y="141472"/>
                    <a:pt x="81407" y="114339"/>
                  </a:cubicBezTo>
                  <a:cubicBezTo>
                    <a:pt x="75980" y="87205"/>
                    <a:pt x="797786" y="442655"/>
                    <a:pt x="814067" y="423661"/>
                  </a:cubicBezTo>
                  <a:cubicBezTo>
                    <a:pt x="830348" y="404668"/>
                    <a:pt x="168241" y="13945"/>
                    <a:pt x="179095" y="378"/>
                  </a:cubicBezTo>
                  <a:cubicBezTo>
                    <a:pt x="189949" y="-13189"/>
                    <a:pt x="879192" y="342260"/>
                    <a:pt x="879192" y="342260"/>
                  </a:cubicBezTo>
                  <a:lnTo>
                    <a:pt x="879192" y="342260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n w="57150" cmpd="sng">
                  <a:solidFill>
                    <a:srgbClr val="000000"/>
                  </a:solidFill>
                </a:ln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Acute Carpal </a:t>
            </a:r>
            <a:r>
              <a:rPr lang="en-US" sz="1200" i="1" dirty="0"/>
              <a:t>T</a:t>
            </a:r>
            <a:r>
              <a:rPr lang="en-US" sz="1200" i="1" dirty="0" smtClean="0"/>
              <a:t>unnel</a:t>
            </a:r>
          </a:p>
          <a:p>
            <a:pPr algn="r"/>
            <a:r>
              <a:rPr lang="en-US" sz="1200" i="1" dirty="0" smtClean="0"/>
              <a:t>Slide 2 of 2</a:t>
            </a:r>
            <a:endParaRPr lang="en-US" sz="1200" i="1" dirty="0"/>
          </a:p>
        </p:txBody>
      </p:sp>
      <p:sp>
        <p:nvSpPr>
          <p:cNvPr id="3" name="Rectangle 2"/>
          <p:cNvSpPr/>
          <p:nvPr/>
        </p:nvSpPr>
        <p:spPr>
          <a:xfrm>
            <a:off x="2642839" y="2308302"/>
            <a:ext cx="190294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ounded Rectangle 12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2511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adiographic Examina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7395" y="1104027"/>
            <a:ext cx="8686800" cy="5287248"/>
          </a:xfrm>
        </p:spPr>
        <p:txBody>
          <a:bodyPr>
            <a:noAutofit/>
          </a:bodyPr>
          <a:lstStyle/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Always confirm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200" dirty="0" smtClean="0"/>
              <a:t>Correct patient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200" dirty="0" smtClean="0"/>
              <a:t>Correct limb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200" dirty="0" smtClean="0"/>
              <a:t>Radiograph in correct orientation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200" dirty="0" smtClean="0"/>
              <a:t>Are these good radiographs?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Evaluate soft tissues and other structures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Bones may have odd shapes, but should always be smooth – look for sharp edges or cortical disruption to avoid missing subtle fractures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400" dirty="0" smtClean="0"/>
              <a:t>Use information gathered from physical exam to focus your radiographic examination; consider elbow radiograph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>
                <a:solidFill>
                  <a:prstClr val="white"/>
                </a:solidFill>
              </a:rPr>
              <a:t>Radiographic Exam</a:t>
            </a:r>
          </a:p>
          <a:p>
            <a:pPr algn="r"/>
            <a:r>
              <a:rPr lang="en-US" sz="1200" i="1" dirty="0">
                <a:solidFill>
                  <a:prstClr val="white"/>
                </a:solidFill>
              </a:rPr>
              <a:t>S</a:t>
            </a:r>
            <a:r>
              <a:rPr lang="en-US" sz="1200" i="1" dirty="0" smtClean="0">
                <a:solidFill>
                  <a:prstClr val="white"/>
                </a:solidFill>
              </a:rPr>
              <a:t>lide 1 of 5</a:t>
            </a:r>
            <a:endParaRPr lang="en-US" sz="1200" i="1" dirty="0">
              <a:solidFill>
                <a:prstClr val="white"/>
              </a:solidFill>
            </a:endParaRPr>
          </a:p>
        </p:txBody>
      </p:sp>
      <p:sp>
        <p:nvSpPr>
          <p:cNvPr id="8" name="Rounded Rectangle 7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</a:rPr>
              <a:t>Contents</a:t>
            </a:r>
            <a:endParaRPr lang="en-US" sz="1200" b="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55912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Wrist Radiographs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3044283" cy="1667107"/>
          </a:xfrm>
        </p:spPr>
        <p:txBody>
          <a:bodyPr/>
          <a:lstStyle/>
          <a:p>
            <a:pPr marL="0" indent="0">
              <a:buNone/>
            </a:pPr>
            <a:r>
              <a:rPr lang="en-US" sz="2400" b="1" dirty="0" smtClean="0"/>
              <a:t>Two views </a:t>
            </a:r>
          </a:p>
          <a:p>
            <a:pPr marL="514350" indent="-457200">
              <a:buFont typeface="Wingdings" panose="05000000000000000000" pitchFamily="2" charset="2"/>
              <a:buChar char="Ø"/>
            </a:pPr>
            <a:r>
              <a:rPr lang="en-US" sz="2200" dirty="0" smtClean="0"/>
              <a:t>PA</a:t>
            </a:r>
          </a:p>
          <a:p>
            <a:pPr marL="514350" indent="-4572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Lateral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Radiographic Exam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2 of 5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25837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C:\Documents and Settings\anmiller\My Documents\Dropbox\Resident Talks\MEC Talks\Distal Radius\good ap.jpg"/>
          <p:cNvPicPr>
            <a:picLocks noChangeAspect="1" noChangeArrowheads="1"/>
          </p:cNvPicPr>
          <p:nvPr/>
        </p:nvPicPr>
        <p:blipFill>
          <a:blip r:embed="rId3" cstate="print"/>
          <a:srcRect l="45916" t="11665" b="35268"/>
          <a:stretch>
            <a:fillRect/>
          </a:stretch>
        </p:blipFill>
        <p:spPr bwMode="auto">
          <a:xfrm>
            <a:off x="228600" y="1600200"/>
            <a:ext cx="3473528" cy="4114800"/>
          </a:xfrm>
          <a:prstGeom prst="rect">
            <a:avLst/>
          </a:prstGeom>
          <a:noFill/>
        </p:spPr>
      </p:pic>
      <p:sp>
        <p:nvSpPr>
          <p:cNvPr id="16" name="Rounded Rectangular Callout 15"/>
          <p:cNvSpPr/>
          <p:nvPr/>
        </p:nvSpPr>
        <p:spPr>
          <a:xfrm>
            <a:off x="4699312" y="2935301"/>
            <a:ext cx="3566160" cy="411480"/>
          </a:xfrm>
          <a:prstGeom prst="wedgeRoundRectCallout">
            <a:avLst>
              <a:gd name="adj1" fmla="val -117659"/>
              <a:gd name="adj2" fmla="val 277608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US" sz="2800" dirty="0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8" y="403412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Normal Radiographs</a:t>
            </a:r>
            <a:r>
              <a:rPr lang="en-US" sz="4000" dirty="0" smtClean="0"/>
              <a:t/>
            </a:r>
            <a:br>
              <a:rPr lang="en-US" sz="4000" dirty="0" smtClean="0"/>
            </a:br>
            <a:r>
              <a:rPr lang="en-US" sz="4000" dirty="0" smtClean="0"/>
              <a:t>PA</a:t>
            </a:r>
            <a:endParaRPr lang="en-US" sz="4000" dirty="0"/>
          </a:p>
        </p:txBody>
      </p:sp>
      <p:sp>
        <p:nvSpPr>
          <p:cNvPr id="15" name="Rounded Rectangular Callout 14"/>
          <p:cNvSpPr/>
          <p:nvPr/>
        </p:nvSpPr>
        <p:spPr>
          <a:xfrm>
            <a:off x="4699312" y="2935224"/>
            <a:ext cx="3566160" cy="411480"/>
          </a:xfrm>
          <a:prstGeom prst="wedgeRoundRectCallout">
            <a:avLst>
              <a:gd name="adj1" fmla="val -149002"/>
              <a:gd name="adj2" fmla="val 32618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Radial styloid distal to ulnar styloid</a:t>
            </a:r>
          </a:p>
        </p:txBody>
      </p:sp>
      <p:sp>
        <p:nvSpPr>
          <p:cNvPr id="17" name="Rounded Rectangular Callout 16"/>
          <p:cNvSpPr/>
          <p:nvPr/>
        </p:nvSpPr>
        <p:spPr>
          <a:xfrm>
            <a:off x="4699312" y="4016807"/>
            <a:ext cx="3566160" cy="777240"/>
          </a:xfrm>
          <a:prstGeom prst="wedgeRoundRectCallout">
            <a:avLst>
              <a:gd name="adj1" fmla="val -126898"/>
              <a:gd name="adj2" fmla="val 1593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Well-aligned </a:t>
            </a:r>
            <a:r>
              <a:rPr lang="en-US" dirty="0">
                <a:solidFill>
                  <a:prstClr val="white"/>
                </a:solidFill>
              </a:rPr>
              <a:t>wrist joint with appropriate </a:t>
            </a:r>
            <a:r>
              <a:rPr lang="en-US" dirty="0" err="1">
                <a:solidFill>
                  <a:prstClr val="white"/>
                </a:solidFill>
              </a:rPr>
              <a:t>radiocarpal</a:t>
            </a:r>
            <a:r>
              <a:rPr lang="en-US" dirty="0">
                <a:solidFill>
                  <a:prstClr val="white"/>
                </a:solidFill>
              </a:rPr>
              <a:t> </a:t>
            </a:r>
            <a:r>
              <a:rPr lang="en-US" dirty="0" smtClean="0">
                <a:solidFill>
                  <a:prstClr val="white"/>
                </a:solidFill>
              </a:rPr>
              <a:t>space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Radiographic Exam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3 of 5</a:t>
            </a:r>
            <a:endParaRPr lang="en-US" sz="1200" i="1" dirty="0"/>
          </a:p>
        </p:txBody>
      </p:sp>
      <p:sp>
        <p:nvSpPr>
          <p:cNvPr id="10" name="Rounded Rectangle 9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9712" y="1529828"/>
            <a:ext cx="3277187" cy="4882113"/>
          </a:xfrm>
          <a:prstGeom prst="rect">
            <a:avLst/>
          </a:prstGeom>
        </p:spPr>
      </p:pic>
      <p:sp>
        <p:nvSpPr>
          <p:cNvPr id="8" name="Freeform 7"/>
          <p:cNvSpPr/>
          <p:nvPr/>
        </p:nvSpPr>
        <p:spPr>
          <a:xfrm>
            <a:off x="2891088" y="3523779"/>
            <a:ext cx="426186" cy="485243"/>
          </a:xfrm>
          <a:custGeom>
            <a:avLst/>
            <a:gdLst>
              <a:gd name="connsiteX0" fmla="*/ 62144 w 426186"/>
              <a:gd name="connsiteY0" fmla="*/ 0 h 710214"/>
              <a:gd name="connsiteX1" fmla="*/ 159798 w 426186"/>
              <a:gd name="connsiteY1" fmla="*/ 26633 h 710214"/>
              <a:gd name="connsiteX2" fmla="*/ 186431 w 426186"/>
              <a:gd name="connsiteY2" fmla="*/ 35511 h 710214"/>
              <a:gd name="connsiteX3" fmla="*/ 213064 w 426186"/>
              <a:gd name="connsiteY3" fmla="*/ 44388 h 710214"/>
              <a:gd name="connsiteX4" fmla="*/ 346229 w 426186"/>
              <a:gd name="connsiteY4" fmla="*/ 35511 h 710214"/>
              <a:gd name="connsiteX5" fmla="*/ 381740 w 426186"/>
              <a:gd name="connsiteY5" fmla="*/ 17755 h 710214"/>
              <a:gd name="connsiteX6" fmla="*/ 408373 w 426186"/>
              <a:gd name="connsiteY6" fmla="*/ 8878 h 710214"/>
              <a:gd name="connsiteX7" fmla="*/ 417251 w 426186"/>
              <a:gd name="connsiteY7" fmla="*/ 71021 h 710214"/>
              <a:gd name="connsiteX8" fmla="*/ 399495 w 426186"/>
              <a:gd name="connsiteY8" fmla="*/ 355107 h 710214"/>
              <a:gd name="connsiteX9" fmla="*/ 390618 w 426186"/>
              <a:gd name="connsiteY9" fmla="*/ 470516 h 710214"/>
              <a:gd name="connsiteX10" fmla="*/ 372862 w 426186"/>
              <a:gd name="connsiteY10" fmla="*/ 523783 h 710214"/>
              <a:gd name="connsiteX11" fmla="*/ 355107 w 426186"/>
              <a:gd name="connsiteY11" fmla="*/ 594804 h 710214"/>
              <a:gd name="connsiteX12" fmla="*/ 310719 w 426186"/>
              <a:gd name="connsiteY12" fmla="*/ 674703 h 710214"/>
              <a:gd name="connsiteX13" fmla="*/ 284086 w 426186"/>
              <a:gd name="connsiteY13" fmla="*/ 692458 h 710214"/>
              <a:gd name="connsiteX14" fmla="*/ 221942 w 426186"/>
              <a:gd name="connsiteY14" fmla="*/ 710214 h 710214"/>
              <a:gd name="connsiteX15" fmla="*/ 88777 w 426186"/>
              <a:gd name="connsiteY15" fmla="*/ 692458 h 710214"/>
              <a:gd name="connsiteX16" fmla="*/ 53266 w 426186"/>
              <a:gd name="connsiteY16" fmla="*/ 674703 h 710214"/>
              <a:gd name="connsiteX17" fmla="*/ 17756 w 426186"/>
              <a:gd name="connsiteY17" fmla="*/ 594804 h 710214"/>
              <a:gd name="connsiteX18" fmla="*/ 26633 w 426186"/>
              <a:gd name="connsiteY18" fmla="*/ 506027 h 710214"/>
              <a:gd name="connsiteX19" fmla="*/ 35511 w 426186"/>
              <a:gd name="connsiteY19" fmla="*/ 470516 h 710214"/>
              <a:gd name="connsiteX20" fmla="*/ 26633 w 426186"/>
              <a:gd name="connsiteY20" fmla="*/ 266330 h 710214"/>
              <a:gd name="connsiteX21" fmla="*/ 17756 w 426186"/>
              <a:gd name="connsiteY21" fmla="*/ 230819 h 710214"/>
              <a:gd name="connsiteX22" fmla="*/ 0 w 426186"/>
              <a:gd name="connsiteY22" fmla="*/ 142043 h 710214"/>
              <a:gd name="connsiteX23" fmla="*/ 44389 w 426186"/>
              <a:gd name="connsiteY23" fmla="*/ 35511 h 710214"/>
              <a:gd name="connsiteX24" fmla="*/ 62144 w 426186"/>
              <a:gd name="connsiteY24" fmla="*/ 0 h 7102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426186" h="710214">
                <a:moveTo>
                  <a:pt x="62144" y="0"/>
                </a:moveTo>
                <a:cubicBezTo>
                  <a:pt x="124882" y="12548"/>
                  <a:pt x="92220" y="4107"/>
                  <a:pt x="159798" y="26633"/>
                </a:cubicBezTo>
                <a:lnTo>
                  <a:pt x="186431" y="35511"/>
                </a:lnTo>
                <a:lnTo>
                  <a:pt x="213064" y="44388"/>
                </a:lnTo>
                <a:cubicBezTo>
                  <a:pt x="257452" y="41429"/>
                  <a:pt x="302287" y="42449"/>
                  <a:pt x="346229" y="35511"/>
                </a:cubicBezTo>
                <a:cubicBezTo>
                  <a:pt x="359301" y="33447"/>
                  <a:pt x="369576" y="22968"/>
                  <a:pt x="381740" y="17755"/>
                </a:cubicBezTo>
                <a:cubicBezTo>
                  <a:pt x="390341" y="14069"/>
                  <a:pt x="399495" y="11837"/>
                  <a:pt x="408373" y="8878"/>
                </a:cubicBezTo>
                <a:cubicBezTo>
                  <a:pt x="439770" y="55975"/>
                  <a:pt x="420854" y="13368"/>
                  <a:pt x="417251" y="71021"/>
                </a:cubicBezTo>
                <a:cubicBezTo>
                  <a:pt x="398625" y="369037"/>
                  <a:pt x="429853" y="233679"/>
                  <a:pt x="399495" y="355107"/>
                </a:cubicBezTo>
                <a:cubicBezTo>
                  <a:pt x="396536" y="393577"/>
                  <a:pt x="396636" y="432405"/>
                  <a:pt x="390618" y="470516"/>
                </a:cubicBezTo>
                <a:cubicBezTo>
                  <a:pt x="387699" y="489003"/>
                  <a:pt x="377401" y="505626"/>
                  <a:pt x="372862" y="523783"/>
                </a:cubicBezTo>
                <a:cubicBezTo>
                  <a:pt x="366944" y="547457"/>
                  <a:pt x="362824" y="571654"/>
                  <a:pt x="355107" y="594804"/>
                </a:cubicBezTo>
                <a:cubicBezTo>
                  <a:pt x="345856" y="622556"/>
                  <a:pt x="336882" y="657261"/>
                  <a:pt x="310719" y="674703"/>
                </a:cubicBezTo>
                <a:cubicBezTo>
                  <a:pt x="301841" y="680621"/>
                  <a:pt x="293629" y="687686"/>
                  <a:pt x="284086" y="692458"/>
                </a:cubicBezTo>
                <a:cubicBezTo>
                  <a:pt x="271349" y="698827"/>
                  <a:pt x="233321" y="707369"/>
                  <a:pt x="221942" y="710214"/>
                </a:cubicBezTo>
                <a:cubicBezTo>
                  <a:pt x="169563" y="705849"/>
                  <a:pt x="132545" y="711216"/>
                  <a:pt x="88777" y="692458"/>
                </a:cubicBezTo>
                <a:cubicBezTo>
                  <a:pt x="76613" y="687245"/>
                  <a:pt x="65103" y="680621"/>
                  <a:pt x="53266" y="674703"/>
                </a:cubicBezTo>
                <a:cubicBezTo>
                  <a:pt x="32137" y="611315"/>
                  <a:pt x="45892" y="637010"/>
                  <a:pt x="17756" y="594804"/>
                </a:cubicBezTo>
                <a:cubicBezTo>
                  <a:pt x="20715" y="565212"/>
                  <a:pt x="22427" y="535468"/>
                  <a:pt x="26633" y="506027"/>
                </a:cubicBezTo>
                <a:cubicBezTo>
                  <a:pt x="28358" y="493948"/>
                  <a:pt x="35511" y="482717"/>
                  <a:pt x="35511" y="470516"/>
                </a:cubicBezTo>
                <a:cubicBezTo>
                  <a:pt x="35511" y="402390"/>
                  <a:pt x="31666" y="334270"/>
                  <a:pt x="26633" y="266330"/>
                </a:cubicBezTo>
                <a:cubicBezTo>
                  <a:pt x="25732" y="254162"/>
                  <a:pt x="20313" y="242749"/>
                  <a:pt x="17756" y="230819"/>
                </a:cubicBezTo>
                <a:cubicBezTo>
                  <a:pt x="11433" y="201311"/>
                  <a:pt x="0" y="142043"/>
                  <a:pt x="0" y="142043"/>
                </a:cubicBezTo>
                <a:cubicBezTo>
                  <a:pt x="9149" y="41406"/>
                  <a:pt x="-22521" y="48892"/>
                  <a:pt x="44389" y="35511"/>
                </a:cubicBezTo>
                <a:cubicBezTo>
                  <a:pt x="47291" y="34931"/>
                  <a:pt x="50307" y="35511"/>
                  <a:pt x="62144" y="0"/>
                </a:cubicBezTo>
                <a:close/>
              </a:path>
            </a:pathLst>
          </a:custGeom>
          <a:noFill/>
          <a:ln w="3810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/>
          <p:cNvSpPr/>
          <p:nvPr/>
        </p:nvSpPr>
        <p:spPr>
          <a:xfrm>
            <a:off x="2793434" y="3979276"/>
            <a:ext cx="514905" cy="279818"/>
          </a:xfrm>
          <a:custGeom>
            <a:avLst/>
            <a:gdLst>
              <a:gd name="connsiteX0" fmla="*/ 97654 w 514905"/>
              <a:gd name="connsiteY0" fmla="*/ 3859 h 361274"/>
              <a:gd name="connsiteX1" fmla="*/ 17755 w 514905"/>
              <a:gd name="connsiteY1" fmla="*/ 30492 h 361274"/>
              <a:gd name="connsiteX2" fmla="*/ 0 w 514905"/>
              <a:gd name="connsiteY2" fmla="*/ 83758 h 361274"/>
              <a:gd name="connsiteX3" fmla="*/ 44388 w 514905"/>
              <a:gd name="connsiteY3" fmla="*/ 287944 h 361274"/>
              <a:gd name="connsiteX4" fmla="*/ 79899 w 514905"/>
              <a:gd name="connsiteY4" fmla="*/ 323455 h 361274"/>
              <a:gd name="connsiteX5" fmla="*/ 106532 w 514905"/>
              <a:gd name="connsiteY5" fmla="*/ 332332 h 361274"/>
              <a:gd name="connsiteX6" fmla="*/ 124287 w 514905"/>
              <a:gd name="connsiteY6" fmla="*/ 350088 h 361274"/>
              <a:gd name="connsiteX7" fmla="*/ 284085 w 514905"/>
              <a:gd name="connsiteY7" fmla="*/ 350088 h 361274"/>
              <a:gd name="connsiteX8" fmla="*/ 346229 w 514905"/>
              <a:gd name="connsiteY8" fmla="*/ 332332 h 361274"/>
              <a:gd name="connsiteX9" fmla="*/ 399495 w 514905"/>
              <a:gd name="connsiteY9" fmla="*/ 314577 h 361274"/>
              <a:gd name="connsiteX10" fmla="*/ 426128 w 514905"/>
              <a:gd name="connsiteY10" fmla="*/ 305699 h 361274"/>
              <a:gd name="connsiteX11" fmla="*/ 452761 w 514905"/>
              <a:gd name="connsiteY11" fmla="*/ 287944 h 361274"/>
              <a:gd name="connsiteX12" fmla="*/ 470516 w 514905"/>
              <a:gd name="connsiteY12" fmla="*/ 261311 h 361274"/>
              <a:gd name="connsiteX13" fmla="*/ 488272 w 514905"/>
              <a:gd name="connsiteY13" fmla="*/ 243556 h 361274"/>
              <a:gd name="connsiteX14" fmla="*/ 506027 w 514905"/>
              <a:gd name="connsiteY14" fmla="*/ 190290 h 361274"/>
              <a:gd name="connsiteX15" fmla="*/ 514905 w 514905"/>
              <a:gd name="connsiteY15" fmla="*/ 163657 h 361274"/>
              <a:gd name="connsiteX16" fmla="*/ 506027 w 514905"/>
              <a:gd name="connsiteY16" fmla="*/ 110391 h 361274"/>
              <a:gd name="connsiteX17" fmla="*/ 497149 w 514905"/>
              <a:gd name="connsiteY17" fmla="*/ 83758 h 361274"/>
              <a:gd name="connsiteX18" fmla="*/ 470516 w 514905"/>
              <a:gd name="connsiteY18" fmla="*/ 74880 h 361274"/>
              <a:gd name="connsiteX19" fmla="*/ 426128 w 514905"/>
              <a:gd name="connsiteY19" fmla="*/ 83758 h 361274"/>
              <a:gd name="connsiteX20" fmla="*/ 399495 w 514905"/>
              <a:gd name="connsiteY20" fmla="*/ 110391 h 361274"/>
              <a:gd name="connsiteX21" fmla="*/ 346229 w 514905"/>
              <a:gd name="connsiteY21" fmla="*/ 137024 h 361274"/>
              <a:gd name="connsiteX22" fmla="*/ 213064 w 514905"/>
              <a:gd name="connsiteY22" fmla="*/ 128146 h 361274"/>
              <a:gd name="connsiteX23" fmla="*/ 115410 w 514905"/>
              <a:gd name="connsiteY23" fmla="*/ 101513 h 361274"/>
              <a:gd name="connsiteX24" fmla="*/ 97654 w 514905"/>
              <a:gd name="connsiteY24" fmla="*/ 83758 h 361274"/>
              <a:gd name="connsiteX25" fmla="*/ 97654 w 514905"/>
              <a:gd name="connsiteY25" fmla="*/ 3859 h 36127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</a:cxnLst>
            <a:rect l="l" t="t" r="r" b="b"/>
            <a:pathLst>
              <a:path w="514905" h="361274">
                <a:moveTo>
                  <a:pt x="97654" y="3859"/>
                </a:moveTo>
                <a:cubicBezTo>
                  <a:pt x="84338" y="-5019"/>
                  <a:pt x="32779" y="444"/>
                  <a:pt x="17755" y="30492"/>
                </a:cubicBezTo>
                <a:cubicBezTo>
                  <a:pt x="9385" y="47232"/>
                  <a:pt x="0" y="83758"/>
                  <a:pt x="0" y="83758"/>
                </a:cubicBezTo>
                <a:cubicBezTo>
                  <a:pt x="4697" y="149512"/>
                  <a:pt x="-3029" y="232624"/>
                  <a:pt x="44388" y="287944"/>
                </a:cubicBezTo>
                <a:cubicBezTo>
                  <a:pt x="55282" y="300654"/>
                  <a:pt x="64018" y="318162"/>
                  <a:pt x="79899" y="323455"/>
                </a:cubicBezTo>
                <a:lnTo>
                  <a:pt x="106532" y="332332"/>
                </a:lnTo>
                <a:cubicBezTo>
                  <a:pt x="112450" y="338251"/>
                  <a:pt x="117110" y="345782"/>
                  <a:pt x="124287" y="350088"/>
                </a:cubicBezTo>
                <a:cubicBezTo>
                  <a:pt x="165586" y="374868"/>
                  <a:pt x="272498" y="350860"/>
                  <a:pt x="284085" y="350088"/>
                </a:cubicBezTo>
                <a:cubicBezTo>
                  <a:pt x="373561" y="320261"/>
                  <a:pt x="234794" y="365763"/>
                  <a:pt x="346229" y="332332"/>
                </a:cubicBezTo>
                <a:cubicBezTo>
                  <a:pt x="364155" y="326954"/>
                  <a:pt x="381740" y="320495"/>
                  <a:pt x="399495" y="314577"/>
                </a:cubicBezTo>
                <a:cubicBezTo>
                  <a:pt x="408373" y="311618"/>
                  <a:pt x="418342" y="310890"/>
                  <a:pt x="426128" y="305699"/>
                </a:cubicBezTo>
                <a:lnTo>
                  <a:pt x="452761" y="287944"/>
                </a:lnTo>
                <a:cubicBezTo>
                  <a:pt x="458679" y="279066"/>
                  <a:pt x="463851" y="269642"/>
                  <a:pt x="470516" y="261311"/>
                </a:cubicBezTo>
                <a:cubicBezTo>
                  <a:pt x="475745" y="254775"/>
                  <a:pt x="484529" y="251042"/>
                  <a:pt x="488272" y="243556"/>
                </a:cubicBezTo>
                <a:cubicBezTo>
                  <a:pt x="496642" y="226816"/>
                  <a:pt x="500109" y="208045"/>
                  <a:pt x="506027" y="190290"/>
                </a:cubicBezTo>
                <a:lnTo>
                  <a:pt x="514905" y="163657"/>
                </a:lnTo>
                <a:cubicBezTo>
                  <a:pt x="511946" y="145902"/>
                  <a:pt x="509932" y="127963"/>
                  <a:pt x="506027" y="110391"/>
                </a:cubicBezTo>
                <a:cubicBezTo>
                  <a:pt x="503997" y="101256"/>
                  <a:pt x="503766" y="90375"/>
                  <a:pt x="497149" y="83758"/>
                </a:cubicBezTo>
                <a:cubicBezTo>
                  <a:pt x="490532" y="77141"/>
                  <a:pt x="479394" y="77839"/>
                  <a:pt x="470516" y="74880"/>
                </a:cubicBezTo>
                <a:cubicBezTo>
                  <a:pt x="455720" y="77839"/>
                  <a:pt x="439624" y="77010"/>
                  <a:pt x="426128" y="83758"/>
                </a:cubicBezTo>
                <a:cubicBezTo>
                  <a:pt x="414899" y="89373"/>
                  <a:pt x="409140" y="102354"/>
                  <a:pt x="399495" y="110391"/>
                </a:cubicBezTo>
                <a:cubicBezTo>
                  <a:pt x="376550" y="129512"/>
                  <a:pt x="372921" y="128126"/>
                  <a:pt x="346229" y="137024"/>
                </a:cubicBezTo>
                <a:cubicBezTo>
                  <a:pt x="301841" y="134065"/>
                  <a:pt x="257177" y="133900"/>
                  <a:pt x="213064" y="128146"/>
                </a:cubicBezTo>
                <a:cubicBezTo>
                  <a:pt x="180162" y="123854"/>
                  <a:pt x="147093" y="112075"/>
                  <a:pt x="115410" y="101513"/>
                </a:cubicBezTo>
                <a:cubicBezTo>
                  <a:pt x="109491" y="95595"/>
                  <a:pt x="101960" y="90935"/>
                  <a:pt x="97654" y="83758"/>
                </a:cubicBezTo>
                <a:cubicBezTo>
                  <a:pt x="85970" y="64285"/>
                  <a:pt x="110970" y="12737"/>
                  <a:pt x="97654" y="3859"/>
                </a:cubicBezTo>
                <a:close/>
              </a:path>
            </a:pathLst>
          </a:custGeom>
          <a:noFill/>
          <a:ln w="3810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 11"/>
          <p:cNvSpPr/>
          <p:nvPr/>
        </p:nvSpPr>
        <p:spPr>
          <a:xfrm>
            <a:off x="2715436" y="4230549"/>
            <a:ext cx="770456" cy="632596"/>
          </a:xfrm>
          <a:custGeom>
            <a:avLst/>
            <a:gdLst>
              <a:gd name="connsiteX0" fmla="*/ 264429 w 770456"/>
              <a:gd name="connsiteY0" fmla="*/ 736847 h 816746"/>
              <a:gd name="connsiteX1" fmla="*/ 255551 w 770456"/>
              <a:gd name="connsiteY1" fmla="*/ 568171 h 816746"/>
              <a:gd name="connsiteX2" fmla="*/ 220041 w 770456"/>
              <a:gd name="connsiteY2" fmla="*/ 488272 h 816746"/>
              <a:gd name="connsiteX3" fmla="*/ 184530 w 770456"/>
              <a:gd name="connsiteY3" fmla="*/ 443884 h 816746"/>
              <a:gd name="connsiteX4" fmla="*/ 149019 w 770456"/>
              <a:gd name="connsiteY4" fmla="*/ 363985 h 816746"/>
              <a:gd name="connsiteX5" fmla="*/ 140142 w 770456"/>
              <a:gd name="connsiteY5" fmla="*/ 337352 h 816746"/>
              <a:gd name="connsiteX6" fmla="*/ 113509 w 770456"/>
              <a:gd name="connsiteY6" fmla="*/ 328474 h 816746"/>
              <a:gd name="connsiteX7" fmla="*/ 86876 w 770456"/>
              <a:gd name="connsiteY7" fmla="*/ 310719 h 816746"/>
              <a:gd name="connsiteX8" fmla="*/ 33610 w 770456"/>
              <a:gd name="connsiteY8" fmla="*/ 284086 h 816746"/>
              <a:gd name="connsiteX9" fmla="*/ 24732 w 770456"/>
              <a:gd name="connsiteY9" fmla="*/ 257453 h 816746"/>
              <a:gd name="connsiteX10" fmla="*/ 6977 w 770456"/>
              <a:gd name="connsiteY10" fmla="*/ 239697 h 816746"/>
              <a:gd name="connsiteX11" fmla="*/ 42487 w 770456"/>
              <a:gd name="connsiteY11" fmla="*/ 124288 h 816746"/>
              <a:gd name="connsiteX12" fmla="*/ 193408 w 770456"/>
              <a:gd name="connsiteY12" fmla="*/ 150921 h 816746"/>
              <a:gd name="connsiteX13" fmla="*/ 220041 w 770456"/>
              <a:gd name="connsiteY13" fmla="*/ 168676 h 816746"/>
              <a:gd name="connsiteX14" fmla="*/ 397594 w 770456"/>
              <a:gd name="connsiteY14" fmla="*/ 159798 h 816746"/>
              <a:gd name="connsiteX15" fmla="*/ 450860 w 770456"/>
              <a:gd name="connsiteY15" fmla="*/ 142043 h 816746"/>
              <a:gd name="connsiteX16" fmla="*/ 477493 w 770456"/>
              <a:gd name="connsiteY16" fmla="*/ 133165 h 816746"/>
              <a:gd name="connsiteX17" fmla="*/ 513004 w 770456"/>
              <a:gd name="connsiteY17" fmla="*/ 88777 h 816746"/>
              <a:gd name="connsiteX18" fmla="*/ 557392 w 770456"/>
              <a:gd name="connsiteY18" fmla="*/ 53266 h 816746"/>
              <a:gd name="connsiteX19" fmla="*/ 584025 w 770456"/>
              <a:gd name="connsiteY19" fmla="*/ 0 h 816746"/>
              <a:gd name="connsiteX20" fmla="*/ 672802 w 770456"/>
              <a:gd name="connsiteY20" fmla="*/ 8878 h 816746"/>
              <a:gd name="connsiteX21" fmla="*/ 690557 w 770456"/>
              <a:gd name="connsiteY21" fmla="*/ 62144 h 816746"/>
              <a:gd name="connsiteX22" fmla="*/ 699435 w 770456"/>
              <a:gd name="connsiteY22" fmla="*/ 88777 h 816746"/>
              <a:gd name="connsiteX23" fmla="*/ 708312 w 770456"/>
              <a:gd name="connsiteY23" fmla="*/ 115410 h 816746"/>
              <a:gd name="connsiteX24" fmla="*/ 717190 w 770456"/>
              <a:gd name="connsiteY24" fmla="*/ 213064 h 816746"/>
              <a:gd name="connsiteX25" fmla="*/ 734945 w 770456"/>
              <a:gd name="connsiteY25" fmla="*/ 239697 h 816746"/>
              <a:gd name="connsiteX26" fmla="*/ 743823 w 770456"/>
              <a:gd name="connsiteY26" fmla="*/ 266330 h 816746"/>
              <a:gd name="connsiteX27" fmla="*/ 752701 w 770456"/>
              <a:gd name="connsiteY27" fmla="*/ 310719 h 816746"/>
              <a:gd name="connsiteX28" fmla="*/ 770456 w 770456"/>
              <a:gd name="connsiteY28" fmla="*/ 363985 h 816746"/>
              <a:gd name="connsiteX29" fmla="*/ 752701 w 770456"/>
              <a:gd name="connsiteY29" fmla="*/ 461639 h 816746"/>
              <a:gd name="connsiteX30" fmla="*/ 734945 w 770456"/>
              <a:gd name="connsiteY30" fmla="*/ 514905 h 816746"/>
              <a:gd name="connsiteX31" fmla="*/ 726068 w 770456"/>
              <a:gd name="connsiteY31" fmla="*/ 541538 h 816746"/>
              <a:gd name="connsiteX32" fmla="*/ 717190 w 770456"/>
              <a:gd name="connsiteY32" fmla="*/ 568171 h 816746"/>
              <a:gd name="connsiteX33" fmla="*/ 699435 w 770456"/>
              <a:gd name="connsiteY33" fmla="*/ 630315 h 816746"/>
              <a:gd name="connsiteX34" fmla="*/ 672802 w 770456"/>
              <a:gd name="connsiteY34" fmla="*/ 763480 h 816746"/>
              <a:gd name="connsiteX35" fmla="*/ 663924 w 770456"/>
              <a:gd name="connsiteY35" fmla="*/ 790113 h 816746"/>
              <a:gd name="connsiteX36" fmla="*/ 655046 w 770456"/>
              <a:gd name="connsiteY36" fmla="*/ 816746 h 8167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</a:cxnLst>
            <a:rect l="l" t="t" r="r" b="b"/>
            <a:pathLst>
              <a:path w="770456" h="816746">
                <a:moveTo>
                  <a:pt x="264429" y="736847"/>
                </a:moveTo>
                <a:cubicBezTo>
                  <a:pt x="261470" y="680622"/>
                  <a:pt x="262259" y="624073"/>
                  <a:pt x="255551" y="568171"/>
                </a:cubicBezTo>
                <a:cubicBezTo>
                  <a:pt x="252073" y="539187"/>
                  <a:pt x="238115" y="510864"/>
                  <a:pt x="220041" y="488272"/>
                </a:cubicBezTo>
                <a:cubicBezTo>
                  <a:pt x="201592" y="465211"/>
                  <a:pt x="198194" y="474628"/>
                  <a:pt x="184530" y="443884"/>
                </a:cubicBezTo>
                <a:cubicBezTo>
                  <a:pt x="142274" y="348807"/>
                  <a:pt x="189201" y="424256"/>
                  <a:pt x="149019" y="363985"/>
                </a:cubicBezTo>
                <a:cubicBezTo>
                  <a:pt x="146060" y="355107"/>
                  <a:pt x="146759" y="343969"/>
                  <a:pt x="140142" y="337352"/>
                </a:cubicBezTo>
                <a:cubicBezTo>
                  <a:pt x="133525" y="330735"/>
                  <a:pt x="121879" y="332659"/>
                  <a:pt x="113509" y="328474"/>
                </a:cubicBezTo>
                <a:cubicBezTo>
                  <a:pt x="103966" y="323702"/>
                  <a:pt x="96419" y="315491"/>
                  <a:pt x="86876" y="310719"/>
                </a:cubicBezTo>
                <a:cubicBezTo>
                  <a:pt x="13366" y="273964"/>
                  <a:pt x="109936" y="334969"/>
                  <a:pt x="33610" y="284086"/>
                </a:cubicBezTo>
                <a:cubicBezTo>
                  <a:pt x="30651" y="275208"/>
                  <a:pt x="29547" y="265477"/>
                  <a:pt x="24732" y="257453"/>
                </a:cubicBezTo>
                <a:cubicBezTo>
                  <a:pt x="20426" y="250276"/>
                  <a:pt x="7573" y="248046"/>
                  <a:pt x="6977" y="239697"/>
                </a:cubicBezTo>
                <a:cubicBezTo>
                  <a:pt x="-882" y="129677"/>
                  <a:pt x="-13352" y="142900"/>
                  <a:pt x="42487" y="124288"/>
                </a:cubicBezTo>
                <a:cubicBezTo>
                  <a:pt x="73578" y="127114"/>
                  <a:pt x="157921" y="127263"/>
                  <a:pt x="193408" y="150921"/>
                </a:cubicBezTo>
                <a:lnTo>
                  <a:pt x="220041" y="168676"/>
                </a:lnTo>
                <a:cubicBezTo>
                  <a:pt x="279225" y="165717"/>
                  <a:pt x="338726" y="166590"/>
                  <a:pt x="397594" y="159798"/>
                </a:cubicBezTo>
                <a:cubicBezTo>
                  <a:pt x="416186" y="157653"/>
                  <a:pt x="433105" y="147961"/>
                  <a:pt x="450860" y="142043"/>
                </a:cubicBezTo>
                <a:lnTo>
                  <a:pt x="477493" y="133165"/>
                </a:lnTo>
                <a:cubicBezTo>
                  <a:pt x="490678" y="113387"/>
                  <a:pt x="494930" y="103235"/>
                  <a:pt x="513004" y="88777"/>
                </a:cubicBezTo>
                <a:cubicBezTo>
                  <a:pt x="538641" y="68268"/>
                  <a:pt x="538338" y="77085"/>
                  <a:pt x="557392" y="53266"/>
                </a:cubicBezTo>
                <a:cubicBezTo>
                  <a:pt x="577060" y="28681"/>
                  <a:pt x="574648" y="28130"/>
                  <a:pt x="584025" y="0"/>
                </a:cubicBezTo>
                <a:lnTo>
                  <a:pt x="672802" y="8878"/>
                </a:lnTo>
                <a:cubicBezTo>
                  <a:pt x="688968" y="18308"/>
                  <a:pt x="684639" y="44389"/>
                  <a:pt x="690557" y="62144"/>
                </a:cubicBezTo>
                <a:lnTo>
                  <a:pt x="699435" y="88777"/>
                </a:lnTo>
                <a:lnTo>
                  <a:pt x="708312" y="115410"/>
                </a:lnTo>
                <a:cubicBezTo>
                  <a:pt x="711271" y="147961"/>
                  <a:pt x="710341" y="181104"/>
                  <a:pt x="717190" y="213064"/>
                </a:cubicBezTo>
                <a:cubicBezTo>
                  <a:pt x="719426" y="223497"/>
                  <a:pt x="730173" y="230154"/>
                  <a:pt x="734945" y="239697"/>
                </a:cubicBezTo>
                <a:cubicBezTo>
                  <a:pt x="739130" y="248067"/>
                  <a:pt x="741553" y="257252"/>
                  <a:pt x="743823" y="266330"/>
                </a:cubicBezTo>
                <a:cubicBezTo>
                  <a:pt x="747483" y="280969"/>
                  <a:pt x="748731" y="296161"/>
                  <a:pt x="752701" y="310719"/>
                </a:cubicBezTo>
                <a:cubicBezTo>
                  <a:pt x="757625" y="328775"/>
                  <a:pt x="770456" y="363985"/>
                  <a:pt x="770456" y="363985"/>
                </a:cubicBezTo>
                <a:cubicBezTo>
                  <a:pt x="764205" y="407739"/>
                  <a:pt x="764114" y="423594"/>
                  <a:pt x="752701" y="461639"/>
                </a:cubicBezTo>
                <a:cubicBezTo>
                  <a:pt x="747323" y="479566"/>
                  <a:pt x="740863" y="497150"/>
                  <a:pt x="734945" y="514905"/>
                </a:cubicBezTo>
                <a:lnTo>
                  <a:pt x="726068" y="541538"/>
                </a:lnTo>
                <a:cubicBezTo>
                  <a:pt x="723109" y="550416"/>
                  <a:pt x="719460" y="559093"/>
                  <a:pt x="717190" y="568171"/>
                </a:cubicBezTo>
                <a:cubicBezTo>
                  <a:pt x="706042" y="612760"/>
                  <a:pt x="712170" y="592107"/>
                  <a:pt x="699435" y="630315"/>
                </a:cubicBezTo>
                <a:cubicBezTo>
                  <a:pt x="688490" y="728812"/>
                  <a:pt x="699031" y="684794"/>
                  <a:pt x="672802" y="763480"/>
                </a:cubicBezTo>
                <a:lnTo>
                  <a:pt x="663924" y="790113"/>
                </a:lnTo>
                <a:lnTo>
                  <a:pt x="655046" y="816746"/>
                </a:lnTo>
              </a:path>
            </a:pathLst>
          </a:custGeom>
          <a:noFill/>
          <a:ln w="3810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8" y="403412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ormal Radiographs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/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ateral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 flipH="1">
            <a:off x="3110813" y="3590686"/>
            <a:ext cx="1" cy="778384"/>
          </a:xfrm>
          <a:prstGeom prst="straightConnector1">
            <a:avLst/>
          </a:prstGeom>
          <a:ln w="50800" cap="flat" cmpd="sng" algn="ctr">
            <a:solidFill>
              <a:srgbClr val="00B050"/>
            </a:solidFill>
            <a:prstDash val="sysDot"/>
            <a:round/>
            <a:headEnd type="stealth" w="med" len="med"/>
            <a:tailEnd type="stealth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Rounded Rectangular Callout 22"/>
          <p:cNvSpPr/>
          <p:nvPr/>
        </p:nvSpPr>
        <p:spPr>
          <a:xfrm>
            <a:off x="4764214" y="2755037"/>
            <a:ext cx="1645920" cy="411480"/>
          </a:xfrm>
          <a:prstGeom prst="wedgeRoundRectCallout">
            <a:avLst>
              <a:gd name="adj1" fmla="val -137596"/>
              <a:gd name="adj2" fmla="val 13934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err="1" smtClean="0">
                <a:solidFill>
                  <a:prstClr val="white"/>
                </a:solidFill>
              </a:rPr>
              <a:t>Capitate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4" name="Rounded Rectangular Callout 23"/>
          <p:cNvSpPr/>
          <p:nvPr/>
        </p:nvSpPr>
        <p:spPr>
          <a:xfrm>
            <a:off x="4764214" y="4174793"/>
            <a:ext cx="1645920" cy="411480"/>
          </a:xfrm>
          <a:prstGeom prst="wedgeRoundRectCallout">
            <a:avLst>
              <a:gd name="adj1" fmla="val -136919"/>
              <a:gd name="adj2" fmla="val -78786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Lunate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6" name="Rounded Rectangular Callout 25"/>
          <p:cNvSpPr/>
          <p:nvPr/>
        </p:nvSpPr>
        <p:spPr>
          <a:xfrm>
            <a:off x="4773052" y="4976033"/>
            <a:ext cx="1645920" cy="411480"/>
          </a:xfrm>
          <a:prstGeom prst="wedgeRoundRectCallout">
            <a:avLst>
              <a:gd name="adj1" fmla="val -124867"/>
              <a:gd name="adj2" fmla="val -15088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Distal radius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27" name="Rounded Rectangular Callout 26"/>
          <p:cNvSpPr/>
          <p:nvPr/>
        </p:nvSpPr>
        <p:spPr>
          <a:xfrm>
            <a:off x="6620256" y="3006360"/>
            <a:ext cx="1645920" cy="1097280"/>
          </a:xfrm>
          <a:prstGeom prst="wedgeRoundRectCallout">
            <a:avLst>
              <a:gd name="adj1" fmla="val -263234"/>
              <a:gd name="adj2" fmla="val 25926"/>
              <a:gd name="adj3" fmla="val 16667"/>
            </a:avLst>
          </a:prstGeom>
          <a:solidFill>
            <a:srgbClr val="00B050">
              <a:alpha val="5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err="1" smtClean="0">
                <a:solidFill>
                  <a:prstClr val="white"/>
                </a:solidFill>
              </a:rPr>
              <a:t>Capitate</a:t>
            </a:r>
            <a:r>
              <a:rPr lang="en-US" dirty="0" smtClean="0">
                <a:solidFill>
                  <a:prstClr val="white"/>
                </a:solidFill>
              </a:rPr>
              <a:t> / Lunate / Radius in line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Radiographic Exam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4 of 5</a:t>
            </a:r>
            <a:endParaRPr lang="en-US" sz="1200" i="1" dirty="0"/>
          </a:p>
        </p:txBody>
      </p:sp>
      <p:sp>
        <p:nvSpPr>
          <p:cNvPr id="16" name="Rounded Rectangle 15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22799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2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15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" fill="hold">
                            <p:stCondLst>
                              <p:cond delay="2000"/>
                            </p:stCondLst>
                            <p:childTnLst>
                              <p:par>
                                <p:cTn id="21" presetID="2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down)">
                                      <p:cBhvr>
                                        <p:cTn id="23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" fill="hold">
                            <p:stCondLst>
                              <p:cond delay="2500"/>
                            </p:stCondLst>
                            <p:childTnLst>
                              <p:par>
                                <p:cTn id="2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fill="hold">
                            <p:stCondLst>
                              <p:cond delay="3000"/>
                            </p:stCondLst>
                            <p:childTnLst>
                              <p:par>
                                <p:cTn id="29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3500"/>
                            </p:stCondLst>
                            <p:childTnLst>
                              <p:par>
                                <p:cTn id="33" presetID="10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11" grpId="0" animBg="1"/>
      <p:bldP spid="12" grpId="0" animBg="1"/>
      <p:bldP spid="23" grpId="0" animBg="1"/>
      <p:bldP spid="24" grpId="0" animBg="1"/>
      <p:bldP spid="26" grpId="0" animBg="1"/>
      <p:bldP spid="27" grpId="0" animBg="1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9712" y="1529828"/>
            <a:ext cx="3277187" cy="4882113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198" y="403412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ormal Radiographs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/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ateral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Radiographic Exam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5 of 5</a:t>
            </a:r>
            <a:endParaRPr lang="en-US" sz="1200" i="1" dirty="0"/>
          </a:p>
        </p:txBody>
      </p:sp>
      <p:sp>
        <p:nvSpPr>
          <p:cNvPr id="12" name="Rounded Rectangular Callout 11"/>
          <p:cNvSpPr/>
          <p:nvPr/>
        </p:nvSpPr>
        <p:spPr>
          <a:xfrm>
            <a:off x="6619552" y="3006360"/>
            <a:ext cx="1645920" cy="1097280"/>
          </a:xfrm>
          <a:prstGeom prst="wedgeRoundRectCallout">
            <a:avLst>
              <a:gd name="adj1" fmla="val -263234"/>
              <a:gd name="adj2" fmla="val 25926"/>
              <a:gd name="adj3" fmla="val 16667"/>
            </a:avLst>
          </a:prstGeom>
          <a:solidFill>
            <a:srgbClr val="00B050">
              <a:alpha val="50000"/>
            </a:srgb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err="1" smtClean="0">
                <a:solidFill>
                  <a:prstClr val="white"/>
                </a:solidFill>
              </a:rPr>
              <a:t>Capitate</a:t>
            </a:r>
            <a:r>
              <a:rPr lang="en-US" dirty="0" smtClean="0">
                <a:solidFill>
                  <a:prstClr val="white"/>
                </a:solidFill>
              </a:rPr>
              <a:t> / Lunate / Radius in line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4" name="Rounded Rectangular Callout 13"/>
          <p:cNvSpPr/>
          <p:nvPr/>
        </p:nvSpPr>
        <p:spPr>
          <a:xfrm>
            <a:off x="4699312" y="4462847"/>
            <a:ext cx="3566160" cy="777240"/>
          </a:xfrm>
          <a:prstGeom prst="wedgeRoundRectCallout">
            <a:avLst>
              <a:gd name="adj1" fmla="val -93127"/>
              <a:gd name="adj2" fmla="val -6011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Well-aligned </a:t>
            </a:r>
            <a:r>
              <a:rPr lang="en-US" dirty="0">
                <a:solidFill>
                  <a:prstClr val="white"/>
                </a:solidFill>
              </a:rPr>
              <a:t>wrist joint with appropriate </a:t>
            </a:r>
            <a:r>
              <a:rPr lang="en-US" dirty="0" err="1">
                <a:solidFill>
                  <a:prstClr val="white"/>
                </a:solidFill>
              </a:rPr>
              <a:t>radiocarpal</a:t>
            </a:r>
            <a:r>
              <a:rPr lang="en-US" dirty="0">
                <a:solidFill>
                  <a:prstClr val="white"/>
                </a:solidFill>
              </a:rPr>
              <a:t> </a:t>
            </a:r>
            <a:r>
              <a:rPr lang="en-US" dirty="0" smtClean="0">
                <a:solidFill>
                  <a:prstClr val="white"/>
                </a:solidFill>
              </a:rPr>
              <a:t>space</a:t>
            </a:r>
            <a:endParaRPr lang="en-US" dirty="0">
              <a:solidFill>
                <a:prstClr val="white"/>
              </a:solidFill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3110813" y="3590686"/>
            <a:ext cx="1" cy="778384"/>
          </a:xfrm>
          <a:prstGeom prst="straightConnector1">
            <a:avLst/>
          </a:prstGeom>
          <a:ln w="50800" cap="flat" cmpd="sng" algn="ctr">
            <a:solidFill>
              <a:srgbClr val="00B050"/>
            </a:solidFill>
            <a:prstDash val="sysDot"/>
            <a:round/>
            <a:headEnd type="stealth" w="med" len="med"/>
            <a:tailEnd type="stealth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Rounded Rectangle 12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9657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Educational Objectives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016" y="1600200"/>
            <a:ext cx="8887968" cy="4525963"/>
          </a:xfrm>
        </p:spPr>
        <p:txBody>
          <a:bodyPr>
            <a:normAutofit/>
          </a:bodyPr>
          <a:lstStyle/>
          <a:p>
            <a:pPr lvl="0">
              <a:spcBef>
                <a:spcPts val="576"/>
              </a:spcBef>
              <a:spcAft>
                <a:spcPts val="1000"/>
              </a:spcAft>
              <a:buNone/>
            </a:pPr>
            <a:r>
              <a:rPr lang="en-US" sz="2600" dirty="0" smtClean="0"/>
              <a:t>By the end of this course, you will be able to</a:t>
            </a:r>
          </a:p>
          <a:p>
            <a:pPr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/>
              <a:t>conduct a physical exam for a wrist injury</a:t>
            </a:r>
          </a:p>
          <a:p>
            <a:pPr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smtClean="0"/>
              <a:t>appropriately </a:t>
            </a:r>
            <a:r>
              <a:rPr lang="en-US" sz="2400" dirty="0" smtClean="0"/>
              <a:t>order radiographic examination of a wrist injury</a:t>
            </a:r>
          </a:p>
          <a:p>
            <a:pPr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evaluate wrist radiographs and determine appropriate surgical and non-surgical interventions</a:t>
            </a:r>
          </a:p>
          <a:p>
            <a:pPr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/>
              <a:t>d</a:t>
            </a:r>
            <a:r>
              <a:rPr lang="en-US" sz="2400" dirty="0" smtClean="0"/>
              <a:t>escribe the general technique for reduction of a wrist fracture dislocation</a:t>
            </a:r>
          </a:p>
          <a:p>
            <a:pPr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describe the urgency of follow-up for patients with a variety of wrist injuries</a:t>
            </a:r>
          </a:p>
        </p:txBody>
      </p:sp>
      <p:sp>
        <p:nvSpPr>
          <p:cNvPr id="5" name="Rounded Rectangle 4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Types of Wrist Fractur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 of 17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adial/Ulnar </a:t>
            </a:r>
            <a:r>
              <a:rPr lang="en-US" sz="4000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yloid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803023" y="1371600"/>
            <a:ext cx="7537954" cy="4114800"/>
            <a:chOff x="803023" y="1371600"/>
            <a:chExt cx="7537954" cy="411480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81" t="17736" r="22081" b="25548"/>
            <a:stretch/>
          </p:blipFill>
          <p:spPr bwMode="auto">
            <a:xfrm>
              <a:off x="5265239" y="1371600"/>
              <a:ext cx="3075738" cy="411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" name="Picture 2" descr="ulnar styloid.tiff"/>
            <p:cNvPicPr>
              <a:picLocks noChangeAspect="1"/>
            </p:cNvPicPr>
            <p:nvPr/>
          </p:nvPicPr>
          <p:blipFill rotWithShape="1">
            <a:blip r:embed="rId4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193" b="14995"/>
            <a:stretch/>
          </p:blipFill>
          <p:spPr>
            <a:xfrm>
              <a:off x="803023" y="1371600"/>
              <a:ext cx="3378104" cy="41148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2 of 17</a:t>
            </a:r>
            <a:endParaRPr lang="en-US" sz="1200" i="1" dirty="0"/>
          </a:p>
        </p:txBody>
      </p:sp>
      <p:sp>
        <p:nvSpPr>
          <p:cNvPr id="10" name="Rounded Rectangle 9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2341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81" t="17736" r="22081" b="25548"/>
          <a:stretch/>
        </p:blipFill>
        <p:spPr bwMode="auto">
          <a:xfrm>
            <a:off x="5265239" y="1371600"/>
            <a:ext cx="3075738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adial/Ulnar </a:t>
            </a:r>
            <a:r>
              <a:rPr lang="en-US" sz="4000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yloid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3" name="Picture 2" descr="ulnar styloid.tiff"/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93" b="14995"/>
          <a:stretch/>
        </p:blipFill>
        <p:spPr>
          <a:xfrm>
            <a:off x="803023" y="1371600"/>
            <a:ext cx="3378104" cy="4114800"/>
          </a:xfrm>
          <a:prstGeom prst="rect">
            <a:avLst/>
          </a:prstGeom>
        </p:spPr>
      </p:pic>
      <p:sp>
        <p:nvSpPr>
          <p:cNvPr id="12" name="Oval 11"/>
          <p:cNvSpPr/>
          <p:nvPr/>
        </p:nvSpPr>
        <p:spPr>
          <a:xfrm>
            <a:off x="6880302" y="3840928"/>
            <a:ext cx="685800" cy="685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Oval 16"/>
          <p:cNvSpPr/>
          <p:nvPr/>
        </p:nvSpPr>
        <p:spPr>
          <a:xfrm>
            <a:off x="914533" y="3429000"/>
            <a:ext cx="685800" cy="685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3 of 17</a:t>
            </a:r>
            <a:endParaRPr lang="en-US" sz="1200" i="1" dirty="0"/>
          </a:p>
        </p:txBody>
      </p:sp>
      <p:cxnSp>
        <p:nvCxnSpPr>
          <p:cNvPr id="15" name="Straight Connector 14"/>
          <p:cNvCxnSpPr/>
          <p:nvPr/>
        </p:nvCxnSpPr>
        <p:spPr>
          <a:xfrm>
            <a:off x="1178419" y="3734639"/>
            <a:ext cx="161710" cy="101069"/>
          </a:xfrm>
          <a:prstGeom prst="line">
            <a:avLst/>
          </a:pr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Freeform 17"/>
          <p:cNvSpPr/>
          <p:nvPr/>
        </p:nvSpPr>
        <p:spPr>
          <a:xfrm>
            <a:off x="7098164" y="4033875"/>
            <a:ext cx="271208" cy="207114"/>
          </a:xfrm>
          <a:custGeom>
            <a:avLst/>
            <a:gdLst>
              <a:gd name="connsiteX0" fmla="*/ 426225 w 426225"/>
              <a:gd name="connsiteY0" fmla="*/ 284085 h 405397"/>
              <a:gd name="connsiteX1" fmla="*/ 381837 w 426225"/>
              <a:gd name="connsiteY1" fmla="*/ 363984 h 405397"/>
              <a:gd name="connsiteX2" fmla="*/ 355204 w 426225"/>
              <a:gd name="connsiteY2" fmla="*/ 372862 h 405397"/>
              <a:gd name="connsiteX3" fmla="*/ 301938 w 426225"/>
              <a:gd name="connsiteY3" fmla="*/ 399495 h 405397"/>
              <a:gd name="connsiteX4" fmla="*/ 115507 w 426225"/>
              <a:gd name="connsiteY4" fmla="*/ 381739 h 405397"/>
              <a:gd name="connsiteX5" fmla="*/ 97751 w 426225"/>
              <a:gd name="connsiteY5" fmla="*/ 363984 h 405397"/>
              <a:gd name="connsiteX6" fmla="*/ 71118 w 426225"/>
              <a:gd name="connsiteY6" fmla="*/ 346229 h 405397"/>
              <a:gd name="connsiteX7" fmla="*/ 62241 w 426225"/>
              <a:gd name="connsiteY7" fmla="*/ 319596 h 405397"/>
              <a:gd name="connsiteX8" fmla="*/ 44485 w 426225"/>
              <a:gd name="connsiteY8" fmla="*/ 301840 h 405397"/>
              <a:gd name="connsiteX9" fmla="*/ 26730 w 426225"/>
              <a:gd name="connsiteY9" fmla="*/ 248574 h 405397"/>
              <a:gd name="connsiteX10" fmla="*/ 17852 w 426225"/>
              <a:gd name="connsiteY10" fmla="*/ 221941 h 405397"/>
              <a:gd name="connsiteX11" fmla="*/ 8975 w 426225"/>
              <a:gd name="connsiteY11" fmla="*/ 97654 h 405397"/>
              <a:gd name="connsiteX12" fmla="*/ 97 w 426225"/>
              <a:gd name="connsiteY12" fmla="*/ 0 h 40539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426225" h="405397">
                <a:moveTo>
                  <a:pt x="426225" y="284085"/>
                </a:moveTo>
                <a:cubicBezTo>
                  <a:pt x="426042" y="284452"/>
                  <a:pt x="393822" y="354396"/>
                  <a:pt x="381837" y="363984"/>
                </a:cubicBezTo>
                <a:cubicBezTo>
                  <a:pt x="374530" y="369830"/>
                  <a:pt x="363574" y="368677"/>
                  <a:pt x="355204" y="372862"/>
                </a:cubicBezTo>
                <a:cubicBezTo>
                  <a:pt x="286365" y="407281"/>
                  <a:pt x="368881" y="377180"/>
                  <a:pt x="301938" y="399495"/>
                </a:cubicBezTo>
                <a:cubicBezTo>
                  <a:pt x="239794" y="393576"/>
                  <a:pt x="159649" y="425879"/>
                  <a:pt x="115507" y="381739"/>
                </a:cubicBezTo>
                <a:cubicBezTo>
                  <a:pt x="109588" y="375821"/>
                  <a:pt x="104287" y="369213"/>
                  <a:pt x="97751" y="363984"/>
                </a:cubicBezTo>
                <a:cubicBezTo>
                  <a:pt x="89419" y="357319"/>
                  <a:pt x="79996" y="352147"/>
                  <a:pt x="71118" y="346229"/>
                </a:cubicBezTo>
                <a:cubicBezTo>
                  <a:pt x="68159" y="337351"/>
                  <a:pt x="67056" y="327620"/>
                  <a:pt x="62241" y="319596"/>
                </a:cubicBezTo>
                <a:cubicBezTo>
                  <a:pt x="57935" y="312419"/>
                  <a:pt x="48228" y="309327"/>
                  <a:pt x="44485" y="301840"/>
                </a:cubicBezTo>
                <a:cubicBezTo>
                  <a:pt x="36115" y="285100"/>
                  <a:pt x="32648" y="266329"/>
                  <a:pt x="26730" y="248574"/>
                </a:cubicBezTo>
                <a:lnTo>
                  <a:pt x="17852" y="221941"/>
                </a:lnTo>
                <a:cubicBezTo>
                  <a:pt x="14893" y="180512"/>
                  <a:pt x="12913" y="139001"/>
                  <a:pt x="8975" y="97654"/>
                </a:cubicBezTo>
                <a:cubicBezTo>
                  <a:pt x="-1577" y="-13144"/>
                  <a:pt x="97" y="77329"/>
                  <a:pt x="97" y="0"/>
                </a:cubicBezTo>
              </a:path>
            </a:pathLst>
          </a:custGeom>
          <a:noFill/>
          <a:ln w="3810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07242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7" grpId="0" animBg="1"/>
      <p:bldP spid="18" grpId="0" animBg="1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: Extra-articular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665105" y="1371600"/>
            <a:ext cx="7813791" cy="4114800"/>
            <a:chOff x="65124" y="1274752"/>
            <a:chExt cx="7813791" cy="4114800"/>
          </a:xfrm>
        </p:grpSpPr>
        <p:pic>
          <p:nvPicPr>
            <p:cNvPr id="3" name="Picture 2" descr="AP DR.tiff"/>
            <p:cNvPicPr>
              <a:picLocks noChangeAspect="1"/>
            </p:cNvPicPr>
            <p:nvPr/>
          </p:nvPicPr>
          <p:blipFill rotWithShape="1">
            <a:blip r:embed="rId3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99" r="18870" b="4225"/>
            <a:stretch/>
          </p:blipFill>
          <p:spPr>
            <a:xfrm>
              <a:off x="65124" y="1274752"/>
              <a:ext cx="3353105" cy="4114800"/>
            </a:xfrm>
            <a:prstGeom prst="rect">
              <a:avLst/>
            </a:prstGeom>
          </p:spPr>
        </p:pic>
        <p:pic>
          <p:nvPicPr>
            <p:cNvPr id="9" name="Picture 8" descr="Lat DR.tiff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49193" y="1274752"/>
              <a:ext cx="3629722" cy="4114800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4 of 17</a:t>
            </a:r>
            <a:endParaRPr lang="en-US" sz="1200" i="1" dirty="0"/>
          </a:p>
        </p:txBody>
      </p:sp>
      <p:sp>
        <p:nvSpPr>
          <p:cNvPr id="10" name="Rectangle 9"/>
          <p:cNvSpPr/>
          <p:nvPr/>
        </p:nvSpPr>
        <p:spPr>
          <a:xfrm>
            <a:off x="7655936" y="3282696"/>
            <a:ext cx="822960" cy="11889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ounded Rectangle 10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7947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: Extra-articular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3" name="Picture 2" descr="AP DR.tiff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99" r="18870" b="4225"/>
          <a:stretch/>
        </p:blipFill>
        <p:spPr>
          <a:xfrm>
            <a:off x="665105" y="1371600"/>
            <a:ext cx="3353105" cy="4114800"/>
          </a:xfrm>
          <a:prstGeom prst="rect">
            <a:avLst/>
          </a:prstGeom>
        </p:spPr>
      </p:pic>
      <p:pic>
        <p:nvPicPr>
          <p:cNvPr id="9" name="Picture 8" descr="Lat DR.tiff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9174" y="1371600"/>
            <a:ext cx="3629722" cy="4114800"/>
          </a:xfrm>
          <a:prstGeom prst="rect">
            <a:avLst/>
          </a:prstGeom>
        </p:spPr>
      </p:pic>
      <p:sp>
        <p:nvSpPr>
          <p:cNvPr id="18" name="Oval 17"/>
          <p:cNvSpPr/>
          <p:nvPr/>
        </p:nvSpPr>
        <p:spPr>
          <a:xfrm>
            <a:off x="1965960" y="4288536"/>
            <a:ext cx="1005840" cy="100584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6204762" y="3282696"/>
            <a:ext cx="1005840" cy="100584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5 of 17</a:t>
            </a:r>
            <a:endParaRPr lang="en-US" sz="1200" i="1" dirty="0"/>
          </a:p>
        </p:txBody>
      </p:sp>
      <p:sp>
        <p:nvSpPr>
          <p:cNvPr id="5" name="Rectangle 4"/>
          <p:cNvSpPr/>
          <p:nvPr/>
        </p:nvSpPr>
        <p:spPr>
          <a:xfrm>
            <a:off x="7655936" y="3288049"/>
            <a:ext cx="822960" cy="11889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Freeform 14"/>
          <p:cNvSpPr/>
          <p:nvPr/>
        </p:nvSpPr>
        <p:spPr>
          <a:xfrm>
            <a:off x="2107930" y="4637083"/>
            <a:ext cx="729343" cy="384207"/>
          </a:xfrm>
          <a:custGeom>
            <a:avLst/>
            <a:gdLst>
              <a:gd name="connsiteX0" fmla="*/ 0 w 980966"/>
              <a:gd name="connsiteY0" fmla="*/ 516758 h 516758"/>
              <a:gd name="connsiteX1" fmla="*/ 78828 w 980966"/>
              <a:gd name="connsiteY1" fmla="*/ 350344 h 516758"/>
              <a:gd name="connsiteX2" fmla="*/ 183931 w 980966"/>
              <a:gd name="connsiteY2" fmla="*/ 481724 h 516758"/>
              <a:gd name="connsiteX3" fmla="*/ 376621 w 980966"/>
              <a:gd name="connsiteY3" fmla="*/ 385379 h 516758"/>
              <a:gd name="connsiteX4" fmla="*/ 499242 w 980966"/>
              <a:gd name="connsiteY4" fmla="*/ 140138 h 516758"/>
              <a:gd name="connsiteX5" fmla="*/ 980966 w 980966"/>
              <a:gd name="connsiteY5" fmla="*/ 0 h 5167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80966" h="516758">
                <a:moveTo>
                  <a:pt x="0" y="516758"/>
                </a:moveTo>
                <a:lnTo>
                  <a:pt x="78828" y="350344"/>
                </a:lnTo>
                <a:lnTo>
                  <a:pt x="183931" y="481724"/>
                </a:lnTo>
                <a:cubicBezTo>
                  <a:pt x="379279" y="392930"/>
                  <a:pt x="376621" y="464692"/>
                  <a:pt x="376621" y="385379"/>
                </a:cubicBezTo>
                <a:lnTo>
                  <a:pt x="499242" y="140138"/>
                </a:lnTo>
                <a:lnTo>
                  <a:pt x="980966" y="0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Freeform 15"/>
          <p:cNvSpPr/>
          <p:nvPr/>
        </p:nvSpPr>
        <p:spPr>
          <a:xfrm>
            <a:off x="6353466" y="3622833"/>
            <a:ext cx="743153" cy="409364"/>
          </a:xfrm>
          <a:custGeom>
            <a:avLst/>
            <a:gdLst>
              <a:gd name="connsiteX0" fmla="*/ 0 w 1033518"/>
              <a:gd name="connsiteY0" fmla="*/ 420414 h 569310"/>
              <a:gd name="connsiteX1" fmla="*/ 78828 w 1033518"/>
              <a:gd name="connsiteY1" fmla="*/ 385380 h 569310"/>
              <a:gd name="connsiteX2" fmla="*/ 35035 w 1033518"/>
              <a:gd name="connsiteY2" fmla="*/ 35035 h 569310"/>
              <a:gd name="connsiteX3" fmla="*/ 227725 w 1033518"/>
              <a:gd name="connsiteY3" fmla="*/ 254000 h 569310"/>
              <a:gd name="connsiteX4" fmla="*/ 227725 w 1033518"/>
              <a:gd name="connsiteY4" fmla="*/ 394138 h 569310"/>
              <a:gd name="connsiteX5" fmla="*/ 359104 w 1033518"/>
              <a:gd name="connsiteY5" fmla="*/ 534276 h 569310"/>
              <a:gd name="connsiteX6" fmla="*/ 455449 w 1033518"/>
              <a:gd name="connsiteY6" fmla="*/ 446690 h 569310"/>
              <a:gd name="connsiteX7" fmla="*/ 560552 w 1033518"/>
              <a:gd name="connsiteY7" fmla="*/ 516759 h 569310"/>
              <a:gd name="connsiteX8" fmla="*/ 630621 w 1033518"/>
              <a:gd name="connsiteY8" fmla="*/ 297793 h 569310"/>
              <a:gd name="connsiteX9" fmla="*/ 718207 w 1033518"/>
              <a:gd name="connsiteY9" fmla="*/ 394138 h 569310"/>
              <a:gd name="connsiteX10" fmla="*/ 797035 w 1033518"/>
              <a:gd name="connsiteY10" fmla="*/ 201448 h 569310"/>
              <a:gd name="connsiteX11" fmla="*/ 937173 w 1033518"/>
              <a:gd name="connsiteY11" fmla="*/ 105104 h 569310"/>
              <a:gd name="connsiteX12" fmla="*/ 1033518 w 1033518"/>
              <a:gd name="connsiteY12" fmla="*/ 0 h 5693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1033518" h="569310">
                <a:moveTo>
                  <a:pt x="0" y="420414"/>
                </a:moveTo>
                <a:cubicBezTo>
                  <a:pt x="81598" y="393215"/>
                  <a:pt x="78828" y="421835"/>
                  <a:pt x="78828" y="385380"/>
                </a:cubicBezTo>
                <a:lnTo>
                  <a:pt x="35035" y="35035"/>
                </a:lnTo>
                <a:cubicBezTo>
                  <a:pt x="229698" y="247394"/>
                  <a:pt x="227725" y="150189"/>
                  <a:pt x="227725" y="254000"/>
                </a:cubicBezTo>
                <a:lnTo>
                  <a:pt x="227725" y="394138"/>
                </a:lnTo>
                <a:lnTo>
                  <a:pt x="359104" y="534276"/>
                </a:lnTo>
                <a:lnTo>
                  <a:pt x="455449" y="446690"/>
                </a:lnTo>
                <a:cubicBezTo>
                  <a:pt x="562887" y="527269"/>
                  <a:pt x="560552" y="569310"/>
                  <a:pt x="560552" y="516759"/>
                </a:cubicBezTo>
                <a:lnTo>
                  <a:pt x="630621" y="297793"/>
                </a:lnTo>
                <a:cubicBezTo>
                  <a:pt x="704124" y="398860"/>
                  <a:pt x="660980" y="394138"/>
                  <a:pt x="718207" y="394138"/>
                </a:cubicBezTo>
                <a:cubicBezTo>
                  <a:pt x="798185" y="207523"/>
                  <a:pt x="797035" y="276911"/>
                  <a:pt x="797035" y="201448"/>
                </a:cubicBezTo>
                <a:lnTo>
                  <a:pt x="937173" y="105104"/>
                </a:lnTo>
                <a:lnTo>
                  <a:pt x="1033518" y="0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ounded Rectangle 11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524018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 animBg="1"/>
      <p:bldP spid="19" grpId="0" animBg="1"/>
      <p:bldP spid="15" grpId="0" animBg="1"/>
      <p:bldP spid="16" grpId="0" animBg="1"/>
    </p:bld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: Intra-articular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30" name="Group 29"/>
          <p:cNvGrpSpPr/>
          <p:nvPr/>
        </p:nvGrpSpPr>
        <p:grpSpPr>
          <a:xfrm>
            <a:off x="695227" y="1371600"/>
            <a:ext cx="7753550" cy="4114801"/>
            <a:chOff x="19811" y="1371600"/>
            <a:chExt cx="7753550" cy="4114801"/>
          </a:xfrm>
        </p:grpSpPr>
        <p:pic>
          <p:nvPicPr>
            <p:cNvPr id="21" name="Picture 20" descr="AP DR 2.tiff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87" b="17306"/>
            <a:stretch/>
          </p:blipFill>
          <p:spPr>
            <a:xfrm>
              <a:off x="19811" y="1371600"/>
              <a:ext cx="3735417" cy="4114800"/>
            </a:xfrm>
            <a:prstGeom prst="rect">
              <a:avLst/>
            </a:prstGeom>
          </p:spPr>
        </p:pic>
        <p:pic>
          <p:nvPicPr>
            <p:cNvPr id="27" name="Picture 26" descr="Lat DR 2.tiff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75" r="27649" b="31125"/>
            <a:stretch/>
          </p:blipFill>
          <p:spPr>
            <a:xfrm>
              <a:off x="4281988" y="1371600"/>
              <a:ext cx="3491373" cy="4114801"/>
            </a:xfrm>
            <a:prstGeom prst="rect">
              <a:avLst/>
            </a:prstGeom>
          </p:spPr>
        </p:pic>
      </p:grp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6 of 17</a:t>
            </a:r>
            <a:endParaRPr lang="en-US" sz="1200" i="1" dirty="0"/>
          </a:p>
        </p:txBody>
      </p:sp>
      <p:sp>
        <p:nvSpPr>
          <p:cNvPr id="9" name="Rounded Rectangle 8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2156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: Intra-articular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30" name="Group 29"/>
          <p:cNvGrpSpPr/>
          <p:nvPr/>
        </p:nvGrpSpPr>
        <p:grpSpPr>
          <a:xfrm>
            <a:off x="695227" y="1371600"/>
            <a:ext cx="7753546" cy="4114800"/>
            <a:chOff x="19811" y="1371600"/>
            <a:chExt cx="7753546" cy="4114800"/>
          </a:xfrm>
        </p:grpSpPr>
        <p:pic>
          <p:nvPicPr>
            <p:cNvPr id="21" name="Picture 20" descr="AP DR 2.tiff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87" b="17306"/>
            <a:stretch/>
          </p:blipFill>
          <p:spPr>
            <a:xfrm>
              <a:off x="19811" y="1371600"/>
              <a:ext cx="3735416" cy="4114800"/>
            </a:xfrm>
            <a:prstGeom prst="rect">
              <a:avLst/>
            </a:prstGeom>
          </p:spPr>
        </p:pic>
        <p:pic>
          <p:nvPicPr>
            <p:cNvPr id="27" name="Picture 26" descr="Lat DR 2.tiff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75" r="27649" b="31125"/>
            <a:stretch/>
          </p:blipFill>
          <p:spPr>
            <a:xfrm>
              <a:off x="4281986" y="1371600"/>
              <a:ext cx="3491371" cy="4114800"/>
            </a:xfrm>
            <a:prstGeom prst="rect">
              <a:avLst/>
            </a:prstGeom>
          </p:spPr>
        </p:pic>
      </p:grpSp>
      <p:sp>
        <p:nvSpPr>
          <p:cNvPr id="34" name="Oval 33"/>
          <p:cNvSpPr/>
          <p:nvPr/>
        </p:nvSpPr>
        <p:spPr>
          <a:xfrm>
            <a:off x="1316703" y="3099816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Oval 34"/>
          <p:cNvSpPr/>
          <p:nvPr/>
        </p:nvSpPr>
        <p:spPr>
          <a:xfrm>
            <a:off x="5859072" y="3099816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7 of 17</a:t>
            </a:r>
            <a:endParaRPr lang="en-US" sz="1200" i="1" dirty="0"/>
          </a:p>
        </p:txBody>
      </p:sp>
      <p:sp>
        <p:nvSpPr>
          <p:cNvPr id="24" name="Freeform 23"/>
          <p:cNvSpPr/>
          <p:nvPr/>
        </p:nvSpPr>
        <p:spPr>
          <a:xfrm>
            <a:off x="1411246" y="3979850"/>
            <a:ext cx="556066" cy="305925"/>
          </a:xfrm>
          <a:custGeom>
            <a:avLst/>
            <a:gdLst>
              <a:gd name="connsiteX0" fmla="*/ 0 w 753242"/>
              <a:gd name="connsiteY0" fmla="*/ 0 h 414403"/>
              <a:gd name="connsiteX1" fmla="*/ 236483 w 753242"/>
              <a:gd name="connsiteY1" fmla="*/ 157656 h 414403"/>
              <a:gd name="connsiteX2" fmla="*/ 341586 w 753242"/>
              <a:gd name="connsiteY2" fmla="*/ 140138 h 414403"/>
              <a:gd name="connsiteX3" fmla="*/ 472966 w 753242"/>
              <a:gd name="connsiteY3" fmla="*/ 192690 h 414403"/>
              <a:gd name="connsiteX4" fmla="*/ 560552 w 753242"/>
              <a:gd name="connsiteY4" fmla="*/ 411656 h 414403"/>
              <a:gd name="connsiteX5" fmla="*/ 753242 w 753242"/>
              <a:gd name="connsiteY5" fmla="*/ 297793 h 4144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53242" h="414403">
                <a:moveTo>
                  <a:pt x="0" y="0"/>
                </a:moveTo>
                <a:cubicBezTo>
                  <a:pt x="238954" y="150453"/>
                  <a:pt x="236483" y="55746"/>
                  <a:pt x="236483" y="157656"/>
                </a:cubicBezTo>
                <a:lnTo>
                  <a:pt x="341586" y="140138"/>
                </a:lnTo>
                <a:cubicBezTo>
                  <a:pt x="475736" y="184854"/>
                  <a:pt x="472966" y="137769"/>
                  <a:pt x="472966" y="192690"/>
                </a:cubicBezTo>
                <a:cubicBezTo>
                  <a:pt x="552782" y="414403"/>
                  <a:pt x="474219" y="411656"/>
                  <a:pt x="560552" y="411656"/>
                </a:cubicBezTo>
                <a:lnTo>
                  <a:pt x="753242" y="297793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Freeform 32"/>
          <p:cNvSpPr/>
          <p:nvPr/>
        </p:nvSpPr>
        <p:spPr>
          <a:xfrm>
            <a:off x="2012573" y="3861537"/>
            <a:ext cx="363758" cy="299358"/>
          </a:xfrm>
          <a:custGeom>
            <a:avLst/>
            <a:gdLst>
              <a:gd name="connsiteX0" fmla="*/ 0 w 492743"/>
              <a:gd name="connsiteY0" fmla="*/ 274128 h 405508"/>
              <a:gd name="connsiteX1" fmla="*/ 140138 w 492743"/>
              <a:gd name="connsiteY1" fmla="*/ 169025 h 405508"/>
              <a:gd name="connsiteX2" fmla="*/ 201448 w 492743"/>
              <a:gd name="connsiteY2" fmla="*/ 405508 h 405508"/>
              <a:gd name="connsiteX3" fmla="*/ 490483 w 492743"/>
              <a:gd name="connsiteY3" fmla="*/ 160266 h 405508"/>
              <a:gd name="connsiteX4" fmla="*/ 402896 w 492743"/>
              <a:gd name="connsiteY4" fmla="*/ 2611 h 4055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92743" h="405508">
                <a:moveTo>
                  <a:pt x="0" y="274128"/>
                </a:moveTo>
                <a:lnTo>
                  <a:pt x="140138" y="169025"/>
                </a:lnTo>
                <a:lnTo>
                  <a:pt x="201448" y="405508"/>
                </a:lnTo>
                <a:cubicBezTo>
                  <a:pt x="492743" y="167176"/>
                  <a:pt x="490483" y="293509"/>
                  <a:pt x="490483" y="160266"/>
                </a:cubicBezTo>
                <a:cubicBezTo>
                  <a:pt x="410349" y="0"/>
                  <a:pt x="470410" y="2611"/>
                  <a:pt x="402896" y="2611"/>
                </a:cubicBez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Freeform 35"/>
          <p:cNvSpPr/>
          <p:nvPr/>
        </p:nvSpPr>
        <p:spPr>
          <a:xfrm>
            <a:off x="2393427" y="3829051"/>
            <a:ext cx="660153" cy="344445"/>
          </a:xfrm>
          <a:custGeom>
            <a:avLst/>
            <a:gdLst>
              <a:gd name="connsiteX0" fmla="*/ 894237 w 894237"/>
              <a:gd name="connsiteY0" fmla="*/ 449513 h 466582"/>
              <a:gd name="connsiteX1" fmla="*/ 666513 w 894237"/>
              <a:gd name="connsiteY1" fmla="*/ 414478 h 466582"/>
              <a:gd name="connsiteX2" fmla="*/ 648995 w 894237"/>
              <a:gd name="connsiteY2" fmla="*/ 291858 h 466582"/>
              <a:gd name="connsiteX3" fmla="*/ 447547 w 894237"/>
              <a:gd name="connsiteY3" fmla="*/ 396961 h 466582"/>
              <a:gd name="connsiteX4" fmla="*/ 202306 w 894237"/>
              <a:gd name="connsiteY4" fmla="*/ 335651 h 466582"/>
              <a:gd name="connsiteX5" fmla="*/ 123478 w 894237"/>
              <a:gd name="connsiteY5" fmla="*/ 2823 h 466582"/>
              <a:gd name="connsiteX6" fmla="*/ 70926 w 894237"/>
              <a:gd name="connsiteY6" fmla="*/ 11582 h 4665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94237" h="466582">
                <a:moveTo>
                  <a:pt x="894237" y="449513"/>
                </a:moveTo>
                <a:lnTo>
                  <a:pt x="666513" y="414478"/>
                </a:lnTo>
                <a:lnTo>
                  <a:pt x="648995" y="291858"/>
                </a:lnTo>
                <a:cubicBezTo>
                  <a:pt x="458193" y="419058"/>
                  <a:pt x="517168" y="466582"/>
                  <a:pt x="447547" y="396961"/>
                </a:cubicBezTo>
                <a:lnTo>
                  <a:pt x="202306" y="335651"/>
                </a:lnTo>
                <a:cubicBezTo>
                  <a:pt x="113977" y="0"/>
                  <a:pt x="0" y="2823"/>
                  <a:pt x="123478" y="2823"/>
                </a:cubicBezTo>
                <a:lnTo>
                  <a:pt x="70926" y="1158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" name="Straight Connector 36"/>
          <p:cNvCxnSpPr>
            <a:stCxn id="33" idx="3"/>
            <a:endCxn id="36" idx="4"/>
          </p:cNvCxnSpPr>
          <p:nvPr/>
        </p:nvCxnSpPr>
        <p:spPr>
          <a:xfrm>
            <a:off x="2374663" y="3979850"/>
            <a:ext cx="168113" cy="96989"/>
          </a:xfrm>
          <a:prstGeom prst="line">
            <a:avLst/>
          </a:pr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Freeform 37"/>
          <p:cNvSpPr/>
          <p:nvPr/>
        </p:nvSpPr>
        <p:spPr>
          <a:xfrm>
            <a:off x="6236075" y="3552083"/>
            <a:ext cx="1071413" cy="627934"/>
          </a:xfrm>
          <a:custGeom>
            <a:avLst/>
            <a:gdLst>
              <a:gd name="connsiteX0" fmla="*/ 52552 w 1453931"/>
              <a:gd name="connsiteY0" fmla="*/ 770759 h 852121"/>
              <a:gd name="connsiteX1" fmla="*/ 0 w 1453931"/>
              <a:gd name="connsiteY1" fmla="*/ 350345 h 852121"/>
              <a:gd name="connsiteX2" fmla="*/ 113862 w 1453931"/>
              <a:gd name="connsiteY2" fmla="*/ 753241 h 852121"/>
              <a:gd name="connsiteX3" fmla="*/ 201449 w 1453931"/>
              <a:gd name="connsiteY3" fmla="*/ 744483 h 852121"/>
              <a:gd name="connsiteX4" fmla="*/ 271518 w 1453931"/>
              <a:gd name="connsiteY4" fmla="*/ 709448 h 852121"/>
              <a:gd name="connsiteX5" fmla="*/ 411656 w 1453931"/>
              <a:gd name="connsiteY5" fmla="*/ 788276 h 852121"/>
              <a:gd name="connsiteX6" fmla="*/ 464207 w 1453931"/>
              <a:gd name="connsiteY6" fmla="*/ 709448 h 852121"/>
              <a:gd name="connsiteX7" fmla="*/ 753242 w 1453931"/>
              <a:gd name="connsiteY7" fmla="*/ 823310 h 852121"/>
              <a:gd name="connsiteX8" fmla="*/ 1007242 w 1453931"/>
              <a:gd name="connsiteY8" fmla="*/ 709448 h 852121"/>
              <a:gd name="connsiteX9" fmla="*/ 1453931 w 1453931"/>
              <a:gd name="connsiteY9" fmla="*/ 639379 h 852121"/>
              <a:gd name="connsiteX10" fmla="*/ 1156138 w 1453931"/>
              <a:gd name="connsiteY10" fmla="*/ 192690 h 852121"/>
              <a:gd name="connsiteX11" fmla="*/ 1261242 w 1453931"/>
              <a:gd name="connsiteY11" fmla="*/ 0 h 8521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453931" h="852121">
                <a:moveTo>
                  <a:pt x="52552" y="770759"/>
                </a:moveTo>
                <a:lnTo>
                  <a:pt x="0" y="350345"/>
                </a:lnTo>
                <a:cubicBezTo>
                  <a:pt x="37954" y="484644"/>
                  <a:pt x="50347" y="628973"/>
                  <a:pt x="113862" y="753241"/>
                </a:cubicBezTo>
                <a:cubicBezTo>
                  <a:pt x="127216" y="779367"/>
                  <a:pt x="201449" y="744483"/>
                  <a:pt x="201449" y="744483"/>
                </a:cubicBezTo>
                <a:lnTo>
                  <a:pt x="271518" y="709448"/>
                </a:lnTo>
                <a:cubicBezTo>
                  <a:pt x="414132" y="798582"/>
                  <a:pt x="411656" y="852121"/>
                  <a:pt x="411656" y="788276"/>
                </a:cubicBezTo>
                <a:cubicBezTo>
                  <a:pt x="456867" y="706896"/>
                  <a:pt x="425390" y="709448"/>
                  <a:pt x="464207" y="709448"/>
                </a:cubicBezTo>
                <a:lnTo>
                  <a:pt x="753242" y="823310"/>
                </a:lnTo>
                <a:lnTo>
                  <a:pt x="1007242" y="709448"/>
                </a:lnTo>
                <a:lnTo>
                  <a:pt x="1453931" y="639379"/>
                </a:lnTo>
                <a:lnTo>
                  <a:pt x="1156138" y="192690"/>
                </a:lnTo>
                <a:lnTo>
                  <a:pt x="1261242" y="0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reeform 38"/>
          <p:cNvSpPr/>
          <p:nvPr/>
        </p:nvSpPr>
        <p:spPr>
          <a:xfrm>
            <a:off x="6681422" y="3571446"/>
            <a:ext cx="425984" cy="219446"/>
          </a:xfrm>
          <a:custGeom>
            <a:avLst/>
            <a:gdLst>
              <a:gd name="connsiteX0" fmla="*/ 0 w 578069"/>
              <a:gd name="connsiteY0" fmla="*/ 0 h 297793"/>
              <a:gd name="connsiteX1" fmla="*/ 420414 w 578069"/>
              <a:gd name="connsiteY1" fmla="*/ 297793 h 297793"/>
              <a:gd name="connsiteX2" fmla="*/ 481724 w 578069"/>
              <a:gd name="connsiteY2" fmla="*/ 254000 h 297793"/>
              <a:gd name="connsiteX3" fmla="*/ 578069 w 578069"/>
              <a:gd name="connsiteY3" fmla="*/ 175172 h 297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78069" h="297793">
                <a:moveTo>
                  <a:pt x="0" y="0"/>
                </a:moveTo>
                <a:lnTo>
                  <a:pt x="420414" y="297793"/>
                </a:lnTo>
                <a:lnTo>
                  <a:pt x="481724" y="254000"/>
                </a:lnTo>
                <a:lnTo>
                  <a:pt x="578069" y="17517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ounded Rectangle 15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18859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" fill="hold">
                            <p:stCondLst>
                              <p:cond delay="2000"/>
                            </p:stCondLst>
                            <p:childTnLst>
                              <p:par>
                                <p:cTn id="21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3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" fill="hold">
                            <p:stCondLst>
                              <p:cond delay="2500"/>
                            </p:stCondLst>
                            <p:childTnLst>
                              <p:par>
                                <p:cTn id="2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fill="hold">
                            <p:stCondLst>
                              <p:cond delay="3000"/>
                            </p:stCondLst>
                            <p:childTnLst>
                              <p:par>
                                <p:cTn id="2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1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3500"/>
                            </p:stCondLst>
                            <p:childTnLst>
                              <p:par>
                                <p:cTn id="33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5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4" grpId="0" animBg="1"/>
      <p:bldP spid="35" grpId="0" animBg="1"/>
      <p:bldP spid="24" grpId="0" animBg="1"/>
      <p:bldP spid="33" grpId="0" animBg="1"/>
      <p:bldP spid="36" grpId="0" animBg="1"/>
      <p:bldP spid="38" grpId="0" animBg="1"/>
      <p:bldP spid="39" grpId="0" animBg="1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/Ulna Injury Summary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2994101"/>
          </a:xfrm>
        </p:spPr>
        <p:txBody>
          <a:bodyPr>
            <a:normAutofit/>
          </a:bodyPr>
          <a:lstStyle/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Most intra-articular fractures need surgery when displaced &gt;2 mm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Extra-articular fractures often do not need surgery if reduction is adequate and stable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Most radial and ulnar styloid fractures do not need surgery if they are minimally displaced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8 of 17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54374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4000" dirty="0"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ther Wrist Fractures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529368"/>
            <a:ext cx="6400800" cy="1321412"/>
          </a:xfrm>
        </p:spPr>
        <p:txBody>
          <a:bodyPr>
            <a:normAutofit/>
          </a:bodyPr>
          <a:lstStyle/>
          <a:p>
            <a:r>
              <a:rPr lang="en-US" sz="2400" dirty="0"/>
              <a:t>Other wrist injuries may be missed because they are more rare but are often more urgent and should not be overlooked …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9 of 17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6427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aphoid.tif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152"/>
          <a:stretch/>
        </p:blipFill>
        <p:spPr>
          <a:xfrm>
            <a:off x="2531920" y="1373034"/>
            <a:ext cx="4080161" cy="4114800"/>
          </a:xfrm>
          <a:prstGeom prst="rect">
            <a:avLst/>
          </a:prstGeom>
        </p:spPr>
      </p:pic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caphoid Fracture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in in anatomic snuffbox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0 of 17</a:t>
            </a:r>
            <a:endParaRPr lang="en-US" sz="1200" i="1" dirty="0"/>
          </a:p>
        </p:txBody>
      </p:sp>
      <p:sp>
        <p:nvSpPr>
          <p:cNvPr id="10" name="Rounded Rectangular Callout 9"/>
          <p:cNvSpPr/>
          <p:nvPr/>
        </p:nvSpPr>
        <p:spPr>
          <a:xfrm>
            <a:off x="5486400" y="3086657"/>
            <a:ext cx="3291840" cy="1730669"/>
          </a:xfrm>
          <a:prstGeom prst="wedgeRoundRectCallout">
            <a:avLst>
              <a:gd name="adj1" fmla="val -89047"/>
              <a:gd name="adj2" fmla="val -1444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Scaphoid fractures can be hard to </a:t>
            </a:r>
            <a:r>
              <a:rPr lang="en-US" dirty="0" smtClean="0">
                <a:solidFill>
                  <a:prstClr val="white"/>
                </a:solidFill>
              </a:rPr>
              <a:t>see. A scaphoid view may be considered; if </a:t>
            </a:r>
            <a:r>
              <a:rPr lang="en-US" dirty="0">
                <a:solidFill>
                  <a:prstClr val="white"/>
                </a:solidFill>
              </a:rPr>
              <a:t> </a:t>
            </a:r>
            <a:r>
              <a:rPr lang="en-US" dirty="0" smtClean="0">
                <a:solidFill>
                  <a:prstClr val="white"/>
                </a:solidFill>
              </a:rPr>
              <a:t>no fracture is seen, CT </a:t>
            </a:r>
            <a:r>
              <a:rPr lang="en-US" dirty="0">
                <a:solidFill>
                  <a:prstClr val="white"/>
                </a:solidFill>
              </a:rPr>
              <a:t>or MRI is needed to exclude them when clinical suspicion is high</a:t>
            </a:r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74639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14400" y="2078912"/>
            <a:ext cx="7315200" cy="3123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576"/>
              </a:spcBef>
              <a:spcAft>
                <a:spcPts val="1000"/>
              </a:spcAft>
            </a:pPr>
            <a:r>
              <a:rPr lang="en-US" sz="2400" dirty="0"/>
              <a:t>What are the standard radiographs to order for a wrist injury</a:t>
            </a:r>
            <a:r>
              <a:rPr lang="en-US" sz="2400" dirty="0" smtClean="0"/>
              <a:t>?</a:t>
            </a:r>
          </a:p>
          <a:p>
            <a:pPr lvl="0">
              <a:spcBef>
                <a:spcPts val="576"/>
              </a:spcBef>
              <a:spcAft>
                <a:spcPts val="1000"/>
              </a:spcAft>
            </a:pPr>
            <a:r>
              <a:rPr lang="en-US" sz="2400" dirty="0">
                <a:solidFill>
                  <a:prstClr val="white"/>
                </a:solidFill>
              </a:rPr>
              <a:t>What are criteria for operative intervention in a wrist injury?</a:t>
            </a:r>
          </a:p>
          <a:p>
            <a:pPr>
              <a:spcBef>
                <a:spcPts val="576"/>
              </a:spcBef>
              <a:spcAft>
                <a:spcPts val="1000"/>
              </a:spcAft>
            </a:pPr>
            <a:r>
              <a:rPr lang="en-US" sz="2400" dirty="0"/>
              <a:t>What wrist injuries should be considered for urgent or emergent management?</a:t>
            </a:r>
          </a:p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lf-Assessment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Rounded Rectangle 7">
            <a:hlinkClick r:id="" action="ppaction://customshow?id=0&amp;return=true"/>
          </p:cNvPr>
          <p:cNvSpPr/>
          <p:nvPr/>
        </p:nvSpPr>
        <p:spPr>
          <a:xfrm>
            <a:off x="1945889" y="2613102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Answer …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9" name="Rounded Rectangle 8">
            <a:hlinkClick r:id="" action="ppaction://customshow?id=1&amp;return=true"/>
          </p:cNvPr>
          <p:cNvSpPr/>
          <p:nvPr/>
        </p:nvSpPr>
        <p:spPr>
          <a:xfrm>
            <a:off x="1945889" y="3526578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Answer …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0" name="Rounded Rectangle 9">
            <a:hlinkClick r:id="" action="ppaction://customshow?id=2&amp;return=true"/>
          </p:cNvPr>
          <p:cNvSpPr/>
          <p:nvPr/>
        </p:nvSpPr>
        <p:spPr>
          <a:xfrm>
            <a:off x="4114800" y="4456771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Answer …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5" name="Rounded Rectangle 14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3475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caphoid Fracture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in in anatomic snuffbox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4" name="Picture 3" descr="Scaphoid.tif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8152"/>
          <a:stretch/>
        </p:blipFill>
        <p:spPr>
          <a:xfrm>
            <a:off x="2531920" y="1371600"/>
            <a:ext cx="4080161" cy="4114800"/>
          </a:xfrm>
          <a:prstGeom prst="rect">
            <a:avLst/>
          </a:prstGeom>
        </p:spPr>
      </p:pic>
      <p:sp>
        <p:nvSpPr>
          <p:cNvPr id="6" name="Oval 5"/>
          <p:cNvSpPr/>
          <p:nvPr/>
        </p:nvSpPr>
        <p:spPr>
          <a:xfrm>
            <a:off x="3537760" y="3171287"/>
            <a:ext cx="1005840" cy="100584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1 of 17</a:t>
            </a:r>
            <a:endParaRPr lang="en-US" sz="1200" i="1" dirty="0"/>
          </a:p>
        </p:txBody>
      </p:sp>
      <p:cxnSp>
        <p:nvCxnSpPr>
          <p:cNvPr id="11" name="Straight Connector 10"/>
          <p:cNvCxnSpPr/>
          <p:nvPr/>
        </p:nvCxnSpPr>
        <p:spPr>
          <a:xfrm flipV="1">
            <a:off x="3854190" y="3659678"/>
            <a:ext cx="414069" cy="14529"/>
          </a:xfrm>
          <a:prstGeom prst="line">
            <a:avLst/>
          </a:pr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0" name="Rounded Rectangular Callout 9"/>
          <p:cNvSpPr/>
          <p:nvPr/>
        </p:nvSpPr>
        <p:spPr>
          <a:xfrm>
            <a:off x="5486400" y="3086657"/>
            <a:ext cx="3291840" cy="1730669"/>
          </a:xfrm>
          <a:prstGeom prst="wedgeRoundRectCallout">
            <a:avLst>
              <a:gd name="adj1" fmla="val -89047"/>
              <a:gd name="adj2" fmla="val -1444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Scaphoid fractures can be hard to </a:t>
            </a:r>
            <a:r>
              <a:rPr lang="en-US" dirty="0" smtClean="0">
                <a:solidFill>
                  <a:prstClr val="white"/>
                </a:solidFill>
              </a:rPr>
              <a:t>see. A scaphoid view may be considered; if </a:t>
            </a:r>
            <a:r>
              <a:rPr lang="en-US" dirty="0">
                <a:solidFill>
                  <a:prstClr val="white"/>
                </a:solidFill>
              </a:rPr>
              <a:t> </a:t>
            </a:r>
            <a:r>
              <a:rPr lang="en-US" dirty="0" smtClean="0">
                <a:solidFill>
                  <a:prstClr val="white"/>
                </a:solidFill>
              </a:rPr>
              <a:t>no fracture is seen, CT </a:t>
            </a:r>
            <a:r>
              <a:rPr lang="en-US" dirty="0">
                <a:solidFill>
                  <a:prstClr val="white"/>
                </a:solidFill>
              </a:rPr>
              <a:t>or MRI is needed to exclude them when clinical suspicion is high</a:t>
            </a:r>
          </a:p>
        </p:txBody>
      </p:sp>
    </p:spTree>
    <p:extLst>
      <p:ext uri="{BB962C8B-B14F-4D97-AF65-F5344CB8AC3E}">
        <p14:creationId xmlns:p14="http://schemas.microsoft.com/office/powerpoint/2010/main" val="13746393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unate Dislocation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2 of 17</a:t>
            </a:r>
            <a:endParaRPr lang="en-US" sz="1200" i="1" dirty="0"/>
          </a:p>
        </p:txBody>
      </p:sp>
      <p:sp>
        <p:nvSpPr>
          <p:cNvPr id="9" name="Rounded Rectangle 8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722" y="1331317"/>
            <a:ext cx="6456556" cy="5004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0575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unate Dislocation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3 of 17</a:t>
            </a:r>
            <a:endParaRPr lang="en-US" sz="1200" i="1" dirty="0"/>
          </a:p>
        </p:txBody>
      </p:sp>
      <p:sp>
        <p:nvSpPr>
          <p:cNvPr id="9" name="Rounded Rectangle 8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722" y="1331317"/>
            <a:ext cx="6456556" cy="5004097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>
          <a:xfrm>
            <a:off x="6212246" y="2142961"/>
            <a:ext cx="1005840" cy="100584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1851069" y="3079022"/>
            <a:ext cx="1583540" cy="1573384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/>
          <p:cNvSpPr/>
          <p:nvPr/>
        </p:nvSpPr>
        <p:spPr>
          <a:xfrm>
            <a:off x="2118717" y="3218488"/>
            <a:ext cx="1139434" cy="990343"/>
          </a:xfrm>
          <a:custGeom>
            <a:avLst/>
            <a:gdLst>
              <a:gd name="connsiteX0" fmla="*/ 0 w 1490874"/>
              <a:gd name="connsiteY0" fmla="*/ 886495 h 1295799"/>
              <a:gd name="connsiteX1" fmla="*/ 254000 w 1490874"/>
              <a:gd name="connsiteY1" fmla="*/ 1292895 h 1295799"/>
              <a:gd name="connsiteX2" fmla="*/ 477520 w 1490874"/>
              <a:gd name="connsiteY2" fmla="*/ 1221775 h 1295799"/>
              <a:gd name="connsiteX3" fmla="*/ 1219200 w 1490874"/>
              <a:gd name="connsiteY3" fmla="*/ 1211615 h 1295799"/>
              <a:gd name="connsiteX4" fmla="*/ 1483360 w 1490874"/>
              <a:gd name="connsiteY4" fmla="*/ 825535 h 1295799"/>
              <a:gd name="connsiteX5" fmla="*/ 1463040 w 1490874"/>
              <a:gd name="connsiteY5" fmla="*/ 784895 h 1295799"/>
              <a:gd name="connsiteX6" fmla="*/ 924560 w 1490874"/>
              <a:gd name="connsiteY6" fmla="*/ 337855 h 1295799"/>
              <a:gd name="connsiteX7" fmla="*/ 792480 w 1490874"/>
              <a:gd name="connsiteY7" fmla="*/ 22895 h 1295799"/>
              <a:gd name="connsiteX8" fmla="*/ 609600 w 1490874"/>
              <a:gd name="connsiteY8" fmla="*/ 2575 h 1295799"/>
              <a:gd name="connsiteX9" fmla="*/ 416560 w 1490874"/>
              <a:gd name="connsiteY9" fmla="*/ 337855 h 1295799"/>
              <a:gd name="connsiteX10" fmla="*/ 132080 w 1490874"/>
              <a:gd name="connsiteY10" fmla="*/ 642655 h 1295799"/>
              <a:gd name="connsiteX11" fmla="*/ 0 w 1490874"/>
              <a:gd name="connsiteY11" fmla="*/ 886495 h 12957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490874" h="1295799">
                <a:moveTo>
                  <a:pt x="0" y="886495"/>
                </a:moveTo>
                <a:cubicBezTo>
                  <a:pt x="245582" y="1295799"/>
                  <a:pt x="85860" y="1292895"/>
                  <a:pt x="254000" y="1292895"/>
                </a:cubicBezTo>
                <a:cubicBezTo>
                  <a:pt x="470573" y="1220704"/>
                  <a:pt x="392393" y="1221775"/>
                  <a:pt x="477520" y="1221775"/>
                </a:cubicBezTo>
                <a:lnTo>
                  <a:pt x="1219200" y="1211615"/>
                </a:lnTo>
                <a:cubicBezTo>
                  <a:pt x="1307253" y="1082922"/>
                  <a:pt x="1405995" y="960923"/>
                  <a:pt x="1483360" y="825535"/>
                </a:cubicBezTo>
                <a:cubicBezTo>
                  <a:pt x="1490874" y="812385"/>
                  <a:pt x="1463040" y="784895"/>
                  <a:pt x="1463040" y="784895"/>
                </a:cubicBezTo>
                <a:cubicBezTo>
                  <a:pt x="1283258" y="636230"/>
                  <a:pt x="1089519" y="502814"/>
                  <a:pt x="924560" y="337855"/>
                </a:cubicBezTo>
                <a:cubicBezTo>
                  <a:pt x="819841" y="13226"/>
                  <a:pt x="933274" y="22895"/>
                  <a:pt x="792480" y="22895"/>
                </a:cubicBezTo>
                <a:cubicBezTo>
                  <a:pt x="643664" y="0"/>
                  <a:pt x="704945" y="2575"/>
                  <a:pt x="609600" y="2575"/>
                </a:cubicBezTo>
                <a:cubicBezTo>
                  <a:pt x="414831" y="330607"/>
                  <a:pt x="416560" y="201658"/>
                  <a:pt x="416560" y="337855"/>
                </a:cubicBezTo>
                <a:lnTo>
                  <a:pt x="132080" y="642655"/>
                </a:lnTo>
                <a:lnTo>
                  <a:pt x="0" y="886495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 11"/>
          <p:cNvSpPr/>
          <p:nvPr/>
        </p:nvSpPr>
        <p:spPr>
          <a:xfrm>
            <a:off x="6394163" y="2280178"/>
            <a:ext cx="595961" cy="731407"/>
          </a:xfrm>
          <a:custGeom>
            <a:avLst/>
            <a:gdLst>
              <a:gd name="connsiteX0" fmla="*/ 751840 w 1117600"/>
              <a:gd name="connsiteY0" fmla="*/ 497840 h 1371600"/>
              <a:gd name="connsiteX1" fmla="*/ 772160 w 1117600"/>
              <a:gd name="connsiteY1" fmla="*/ 436880 h 1371600"/>
              <a:gd name="connsiteX2" fmla="*/ 792480 w 1117600"/>
              <a:gd name="connsiteY2" fmla="*/ 355600 h 1371600"/>
              <a:gd name="connsiteX3" fmla="*/ 822960 w 1117600"/>
              <a:gd name="connsiteY3" fmla="*/ 325120 h 1371600"/>
              <a:gd name="connsiteX4" fmla="*/ 833120 w 1117600"/>
              <a:gd name="connsiteY4" fmla="*/ 284480 h 1371600"/>
              <a:gd name="connsiteX5" fmla="*/ 863600 w 1117600"/>
              <a:gd name="connsiteY5" fmla="*/ 254000 h 1371600"/>
              <a:gd name="connsiteX6" fmla="*/ 904240 w 1117600"/>
              <a:gd name="connsiteY6" fmla="*/ 193040 h 1371600"/>
              <a:gd name="connsiteX7" fmla="*/ 924560 w 1117600"/>
              <a:gd name="connsiteY7" fmla="*/ 162560 h 1371600"/>
              <a:gd name="connsiteX8" fmla="*/ 944880 w 1117600"/>
              <a:gd name="connsiteY8" fmla="*/ 132080 h 1371600"/>
              <a:gd name="connsiteX9" fmla="*/ 589280 w 1117600"/>
              <a:gd name="connsiteY9" fmla="*/ 0 h 1371600"/>
              <a:gd name="connsiteX10" fmla="*/ 426720 w 1117600"/>
              <a:gd name="connsiteY10" fmla="*/ 111760 h 1371600"/>
              <a:gd name="connsiteX11" fmla="*/ 274320 w 1117600"/>
              <a:gd name="connsiteY11" fmla="*/ 304800 h 1371600"/>
              <a:gd name="connsiteX12" fmla="*/ 264160 w 1117600"/>
              <a:gd name="connsiteY12" fmla="*/ 335280 h 1371600"/>
              <a:gd name="connsiteX13" fmla="*/ 0 w 1117600"/>
              <a:gd name="connsiteY13" fmla="*/ 721360 h 1371600"/>
              <a:gd name="connsiteX14" fmla="*/ 71120 w 1117600"/>
              <a:gd name="connsiteY14" fmla="*/ 1137920 h 1371600"/>
              <a:gd name="connsiteX15" fmla="*/ 325120 w 1117600"/>
              <a:gd name="connsiteY15" fmla="*/ 1290320 h 1371600"/>
              <a:gd name="connsiteX16" fmla="*/ 762000 w 1117600"/>
              <a:gd name="connsiteY16" fmla="*/ 1371600 h 1371600"/>
              <a:gd name="connsiteX17" fmla="*/ 995680 w 1117600"/>
              <a:gd name="connsiteY17" fmla="*/ 1270000 h 1371600"/>
              <a:gd name="connsiteX18" fmla="*/ 1117600 w 1117600"/>
              <a:gd name="connsiteY18" fmla="*/ 995680 h 1371600"/>
              <a:gd name="connsiteX19" fmla="*/ 782320 w 1117600"/>
              <a:gd name="connsiteY19" fmla="*/ 792480 h 1371600"/>
              <a:gd name="connsiteX20" fmla="*/ 751840 w 1117600"/>
              <a:gd name="connsiteY20" fmla="*/ 497840 h 1371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1117600" h="1371600">
                <a:moveTo>
                  <a:pt x="751840" y="497840"/>
                </a:moveTo>
                <a:cubicBezTo>
                  <a:pt x="758613" y="477520"/>
                  <a:pt x="767959" y="457883"/>
                  <a:pt x="772160" y="436880"/>
                </a:cubicBezTo>
                <a:cubicBezTo>
                  <a:pt x="773626" y="429552"/>
                  <a:pt x="783554" y="368989"/>
                  <a:pt x="792480" y="355600"/>
                </a:cubicBezTo>
                <a:cubicBezTo>
                  <a:pt x="800450" y="343645"/>
                  <a:pt x="812800" y="335280"/>
                  <a:pt x="822960" y="325120"/>
                </a:cubicBezTo>
                <a:cubicBezTo>
                  <a:pt x="826347" y="311573"/>
                  <a:pt x="826192" y="296604"/>
                  <a:pt x="833120" y="284480"/>
                </a:cubicBezTo>
                <a:cubicBezTo>
                  <a:pt x="840249" y="272005"/>
                  <a:pt x="854779" y="265342"/>
                  <a:pt x="863600" y="254000"/>
                </a:cubicBezTo>
                <a:cubicBezTo>
                  <a:pt x="878593" y="234723"/>
                  <a:pt x="890693" y="213360"/>
                  <a:pt x="904240" y="193040"/>
                </a:cubicBezTo>
                <a:lnTo>
                  <a:pt x="924560" y="162560"/>
                </a:lnTo>
                <a:lnTo>
                  <a:pt x="944880" y="132080"/>
                </a:lnTo>
                <a:lnTo>
                  <a:pt x="589280" y="0"/>
                </a:lnTo>
                <a:cubicBezTo>
                  <a:pt x="434149" y="113763"/>
                  <a:pt x="499876" y="111760"/>
                  <a:pt x="426720" y="111760"/>
                </a:cubicBezTo>
                <a:cubicBezTo>
                  <a:pt x="375920" y="176107"/>
                  <a:pt x="322540" y="238498"/>
                  <a:pt x="274320" y="304800"/>
                </a:cubicBezTo>
                <a:cubicBezTo>
                  <a:pt x="268021" y="313461"/>
                  <a:pt x="264160" y="335280"/>
                  <a:pt x="264160" y="335280"/>
                </a:cubicBezTo>
                <a:lnTo>
                  <a:pt x="0" y="721360"/>
                </a:lnTo>
                <a:lnTo>
                  <a:pt x="71120" y="1137920"/>
                </a:lnTo>
                <a:lnTo>
                  <a:pt x="325120" y="1290320"/>
                </a:lnTo>
                <a:lnTo>
                  <a:pt x="762000" y="1371600"/>
                </a:lnTo>
                <a:cubicBezTo>
                  <a:pt x="988603" y="1268599"/>
                  <a:pt x="903678" y="1270000"/>
                  <a:pt x="995680" y="1270000"/>
                </a:cubicBezTo>
                <a:lnTo>
                  <a:pt x="1117600" y="995680"/>
                </a:lnTo>
                <a:cubicBezTo>
                  <a:pt x="779385" y="800950"/>
                  <a:pt x="782320" y="931600"/>
                  <a:pt x="782320" y="792480"/>
                </a:cubicBezTo>
                <a:lnTo>
                  <a:pt x="751840" y="497840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19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10" grpId="0" animBg="1"/>
      <p:bldP spid="11" grpId="0" animBg="1"/>
      <p:bldP spid="12" grpId="0" animBg="1"/>
    </p:bld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unate Dislocation</a:t>
            </a:r>
            <a:endParaRPr lang="en-US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4 of 17</a:t>
            </a:r>
            <a:endParaRPr lang="en-US" sz="1200" i="1" dirty="0"/>
          </a:p>
        </p:txBody>
      </p:sp>
      <p:sp>
        <p:nvSpPr>
          <p:cNvPr id="9" name="Rounded Rectangle 8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722" y="1331317"/>
            <a:ext cx="6456556" cy="5004097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>
          <a:xfrm>
            <a:off x="6212246" y="2142961"/>
            <a:ext cx="1005840" cy="100584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Oval 9"/>
          <p:cNvSpPr/>
          <p:nvPr/>
        </p:nvSpPr>
        <p:spPr>
          <a:xfrm>
            <a:off x="1851069" y="3079022"/>
            <a:ext cx="1583540" cy="1573384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/>
          <p:cNvSpPr/>
          <p:nvPr/>
        </p:nvSpPr>
        <p:spPr>
          <a:xfrm>
            <a:off x="2118717" y="3218488"/>
            <a:ext cx="1139434" cy="990343"/>
          </a:xfrm>
          <a:custGeom>
            <a:avLst/>
            <a:gdLst>
              <a:gd name="connsiteX0" fmla="*/ 0 w 1490874"/>
              <a:gd name="connsiteY0" fmla="*/ 886495 h 1295799"/>
              <a:gd name="connsiteX1" fmla="*/ 254000 w 1490874"/>
              <a:gd name="connsiteY1" fmla="*/ 1292895 h 1295799"/>
              <a:gd name="connsiteX2" fmla="*/ 477520 w 1490874"/>
              <a:gd name="connsiteY2" fmla="*/ 1221775 h 1295799"/>
              <a:gd name="connsiteX3" fmla="*/ 1219200 w 1490874"/>
              <a:gd name="connsiteY3" fmla="*/ 1211615 h 1295799"/>
              <a:gd name="connsiteX4" fmla="*/ 1483360 w 1490874"/>
              <a:gd name="connsiteY4" fmla="*/ 825535 h 1295799"/>
              <a:gd name="connsiteX5" fmla="*/ 1463040 w 1490874"/>
              <a:gd name="connsiteY5" fmla="*/ 784895 h 1295799"/>
              <a:gd name="connsiteX6" fmla="*/ 924560 w 1490874"/>
              <a:gd name="connsiteY6" fmla="*/ 337855 h 1295799"/>
              <a:gd name="connsiteX7" fmla="*/ 792480 w 1490874"/>
              <a:gd name="connsiteY7" fmla="*/ 22895 h 1295799"/>
              <a:gd name="connsiteX8" fmla="*/ 609600 w 1490874"/>
              <a:gd name="connsiteY8" fmla="*/ 2575 h 1295799"/>
              <a:gd name="connsiteX9" fmla="*/ 416560 w 1490874"/>
              <a:gd name="connsiteY9" fmla="*/ 337855 h 1295799"/>
              <a:gd name="connsiteX10" fmla="*/ 132080 w 1490874"/>
              <a:gd name="connsiteY10" fmla="*/ 642655 h 1295799"/>
              <a:gd name="connsiteX11" fmla="*/ 0 w 1490874"/>
              <a:gd name="connsiteY11" fmla="*/ 886495 h 12957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490874" h="1295799">
                <a:moveTo>
                  <a:pt x="0" y="886495"/>
                </a:moveTo>
                <a:cubicBezTo>
                  <a:pt x="245582" y="1295799"/>
                  <a:pt x="85860" y="1292895"/>
                  <a:pt x="254000" y="1292895"/>
                </a:cubicBezTo>
                <a:cubicBezTo>
                  <a:pt x="470573" y="1220704"/>
                  <a:pt x="392393" y="1221775"/>
                  <a:pt x="477520" y="1221775"/>
                </a:cubicBezTo>
                <a:lnTo>
                  <a:pt x="1219200" y="1211615"/>
                </a:lnTo>
                <a:cubicBezTo>
                  <a:pt x="1307253" y="1082922"/>
                  <a:pt x="1405995" y="960923"/>
                  <a:pt x="1483360" y="825535"/>
                </a:cubicBezTo>
                <a:cubicBezTo>
                  <a:pt x="1490874" y="812385"/>
                  <a:pt x="1463040" y="784895"/>
                  <a:pt x="1463040" y="784895"/>
                </a:cubicBezTo>
                <a:cubicBezTo>
                  <a:pt x="1283258" y="636230"/>
                  <a:pt x="1089519" y="502814"/>
                  <a:pt x="924560" y="337855"/>
                </a:cubicBezTo>
                <a:cubicBezTo>
                  <a:pt x="819841" y="13226"/>
                  <a:pt x="933274" y="22895"/>
                  <a:pt x="792480" y="22895"/>
                </a:cubicBezTo>
                <a:cubicBezTo>
                  <a:pt x="643664" y="0"/>
                  <a:pt x="704945" y="2575"/>
                  <a:pt x="609600" y="2575"/>
                </a:cubicBezTo>
                <a:cubicBezTo>
                  <a:pt x="414831" y="330607"/>
                  <a:pt x="416560" y="201658"/>
                  <a:pt x="416560" y="337855"/>
                </a:cubicBezTo>
                <a:lnTo>
                  <a:pt x="132080" y="642655"/>
                </a:lnTo>
                <a:lnTo>
                  <a:pt x="0" y="886495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Freeform 11"/>
          <p:cNvSpPr/>
          <p:nvPr/>
        </p:nvSpPr>
        <p:spPr>
          <a:xfrm>
            <a:off x="6394163" y="2280178"/>
            <a:ext cx="595961" cy="731407"/>
          </a:xfrm>
          <a:custGeom>
            <a:avLst/>
            <a:gdLst>
              <a:gd name="connsiteX0" fmla="*/ 751840 w 1117600"/>
              <a:gd name="connsiteY0" fmla="*/ 497840 h 1371600"/>
              <a:gd name="connsiteX1" fmla="*/ 772160 w 1117600"/>
              <a:gd name="connsiteY1" fmla="*/ 436880 h 1371600"/>
              <a:gd name="connsiteX2" fmla="*/ 792480 w 1117600"/>
              <a:gd name="connsiteY2" fmla="*/ 355600 h 1371600"/>
              <a:gd name="connsiteX3" fmla="*/ 822960 w 1117600"/>
              <a:gd name="connsiteY3" fmla="*/ 325120 h 1371600"/>
              <a:gd name="connsiteX4" fmla="*/ 833120 w 1117600"/>
              <a:gd name="connsiteY4" fmla="*/ 284480 h 1371600"/>
              <a:gd name="connsiteX5" fmla="*/ 863600 w 1117600"/>
              <a:gd name="connsiteY5" fmla="*/ 254000 h 1371600"/>
              <a:gd name="connsiteX6" fmla="*/ 904240 w 1117600"/>
              <a:gd name="connsiteY6" fmla="*/ 193040 h 1371600"/>
              <a:gd name="connsiteX7" fmla="*/ 924560 w 1117600"/>
              <a:gd name="connsiteY7" fmla="*/ 162560 h 1371600"/>
              <a:gd name="connsiteX8" fmla="*/ 944880 w 1117600"/>
              <a:gd name="connsiteY8" fmla="*/ 132080 h 1371600"/>
              <a:gd name="connsiteX9" fmla="*/ 589280 w 1117600"/>
              <a:gd name="connsiteY9" fmla="*/ 0 h 1371600"/>
              <a:gd name="connsiteX10" fmla="*/ 426720 w 1117600"/>
              <a:gd name="connsiteY10" fmla="*/ 111760 h 1371600"/>
              <a:gd name="connsiteX11" fmla="*/ 274320 w 1117600"/>
              <a:gd name="connsiteY11" fmla="*/ 304800 h 1371600"/>
              <a:gd name="connsiteX12" fmla="*/ 264160 w 1117600"/>
              <a:gd name="connsiteY12" fmla="*/ 335280 h 1371600"/>
              <a:gd name="connsiteX13" fmla="*/ 0 w 1117600"/>
              <a:gd name="connsiteY13" fmla="*/ 721360 h 1371600"/>
              <a:gd name="connsiteX14" fmla="*/ 71120 w 1117600"/>
              <a:gd name="connsiteY14" fmla="*/ 1137920 h 1371600"/>
              <a:gd name="connsiteX15" fmla="*/ 325120 w 1117600"/>
              <a:gd name="connsiteY15" fmla="*/ 1290320 h 1371600"/>
              <a:gd name="connsiteX16" fmla="*/ 762000 w 1117600"/>
              <a:gd name="connsiteY16" fmla="*/ 1371600 h 1371600"/>
              <a:gd name="connsiteX17" fmla="*/ 995680 w 1117600"/>
              <a:gd name="connsiteY17" fmla="*/ 1270000 h 1371600"/>
              <a:gd name="connsiteX18" fmla="*/ 1117600 w 1117600"/>
              <a:gd name="connsiteY18" fmla="*/ 995680 h 1371600"/>
              <a:gd name="connsiteX19" fmla="*/ 782320 w 1117600"/>
              <a:gd name="connsiteY19" fmla="*/ 792480 h 1371600"/>
              <a:gd name="connsiteX20" fmla="*/ 751840 w 1117600"/>
              <a:gd name="connsiteY20" fmla="*/ 497840 h 1371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1117600" h="1371600">
                <a:moveTo>
                  <a:pt x="751840" y="497840"/>
                </a:moveTo>
                <a:cubicBezTo>
                  <a:pt x="758613" y="477520"/>
                  <a:pt x="767959" y="457883"/>
                  <a:pt x="772160" y="436880"/>
                </a:cubicBezTo>
                <a:cubicBezTo>
                  <a:pt x="773626" y="429552"/>
                  <a:pt x="783554" y="368989"/>
                  <a:pt x="792480" y="355600"/>
                </a:cubicBezTo>
                <a:cubicBezTo>
                  <a:pt x="800450" y="343645"/>
                  <a:pt x="812800" y="335280"/>
                  <a:pt x="822960" y="325120"/>
                </a:cubicBezTo>
                <a:cubicBezTo>
                  <a:pt x="826347" y="311573"/>
                  <a:pt x="826192" y="296604"/>
                  <a:pt x="833120" y="284480"/>
                </a:cubicBezTo>
                <a:cubicBezTo>
                  <a:pt x="840249" y="272005"/>
                  <a:pt x="854779" y="265342"/>
                  <a:pt x="863600" y="254000"/>
                </a:cubicBezTo>
                <a:cubicBezTo>
                  <a:pt x="878593" y="234723"/>
                  <a:pt x="890693" y="213360"/>
                  <a:pt x="904240" y="193040"/>
                </a:cubicBezTo>
                <a:lnTo>
                  <a:pt x="924560" y="162560"/>
                </a:lnTo>
                <a:lnTo>
                  <a:pt x="944880" y="132080"/>
                </a:lnTo>
                <a:lnTo>
                  <a:pt x="589280" y="0"/>
                </a:lnTo>
                <a:cubicBezTo>
                  <a:pt x="434149" y="113763"/>
                  <a:pt x="499876" y="111760"/>
                  <a:pt x="426720" y="111760"/>
                </a:cubicBezTo>
                <a:cubicBezTo>
                  <a:pt x="375920" y="176107"/>
                  <a:pt x="322540" y="238498"/>
                  <a:pt x="274320" y="304800"/>
                </a:cubicBezTo>
                <a:cubicBezTo>
                  <a:pt x="268021" y="313461"/>
                  <a:pt x="264160" y="335280"/>
                  <a:pt x="264160" y="335280"/>
                </a:cubicBezTo>
                <a:lnTo>
                  <a:pt x="0" y="721360"/>
                </a:lnTo>
                <a:lnTo>
                  <a:pt x="71120" y="1137920"/>
                </a:lnTo>
                <a:lnTo>
                  <a:pt x="325120" y="1290320"/>
                </a:lnTo>
                <a:lnTo>
                  <a:pt x="762000" y="1371600"/>
                </a:lnTo>
                <a:cubicBezTo>
                  <a:pt x="988603" y="1268599"/>
                  <a:pt x="903678" y="1270000"/>
                  <a:pt x="995680" y="1270000"/>
                </a:cubicBezTo>
                <a:lnTo>
                  <a:pt x="1117600" y="995680"/>
                </a:lnTo>
                <a:cubicBezTo>
                  <a:pt x="779385" y="800950"/>
                  <a:pt x="782320" y="931600"/>
                  <a:pt x="782320" y="792480"/>
                </a:cubicBezTo>
                <a:lnTo>
                  <a:pt x="751840" y="497840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ounded Rectangular Callout 12"/>
          <p:cNvSpPr/>
          <p:nvPr/>
        </p:nvSpPr>
        <p:spPr>
          <a:xfrm>
            <a:off x="4007865" y="2939159"/>
            <a:ext cx="1747954" cy="1097280"/>
          </a:xfrm>
          <a:prstGeom prst="wedgeRoundRectCallout">
            <a:avLst>
              <a:gd name="adj1" fmla="val 74710"/>
              <a:gd name="adj2" fmla="val -5345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err="1">
                <a:solidFill>
                  <a:prstClr val="white"/>
                </a:solidFill>
              </a:rPr>
              <a:t>Capitate</a:t>
            </a:r>
            <a:r>
              <a:rPr lang="en-US" dirty="0">
                <a:solidFill>
                  <a:prstClr val="white"/>
                </a:solidFill>
              </a:rPr>
              <a:t> / lunate / radius NOT in line</a:t>
            </a:r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6115948" y="2303392"/>
            <a:ext cx="222460" cy="1271533"/>
          </a:xfrm>
          <a:prstGeom prst="straightConnector1">
            <a:avLst/>
          </a:prstGeom>
          <a:ln w="50800" cap="flat" cmpd="sng" algn="ctr">
            <a:solidFill>
              <a:srgbClr val="FF0000"/>
            </a:solidFill>
            <a:prstDash val="sysDot"/>
            <a:round/>
            <a:headEnd type="stealth" w="med" len="med"/>
            <a:tailEnd type="stealth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88067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1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</p:bld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erilunate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Disloca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6" name="Picture 5" descr="perilunate.jpg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74" b="23323"/>
          <a:stretch/>
        </p:blipFill>
        <p:spPr>
          <a:xfrm>
            <a:off x="1096829" y="1371600"/>
            <a:ext cx="6950340" cy="411479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5 of 17</a:t>
            </a:r>
            <a:endParaRPr lang="en-US" sz="1200" i="1" dirty="0"/>
          </a:p>
        </p:txBody>
      </p:sp>
      <p:sp>
        <p:nvSpPr>
          <p:cNvPr id="7" name="Rounded Rectangle 6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4684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erilunate</a:t>
            </a:r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Dislocation 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Lunate outlined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15" name="Picture 14" descr="perilunate.jpg"/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74" b="23323"/>
          <a:stretch/>
        </p:blipFill>
        <p:spPr>
          <a:xfrm>
            <a:off x="1096829" y="1371600"/>
            <a:ext cx="6950343" cy="4114800"/>
          </a:xfrm>
          <a:prstGeom prst="rect">
            <a:avLst/>
          </a:prstGeom>
        </p:spPr>
      </p:pic>
      <p:sp>
        <p:nvSpPr>
          <p:cNvPr id="20" name="Oval 19"/>
          <p:cNvSpPr/>
          <p:nvPr/>
        </p:nvSpPr>
        <p:spPr>
          <a:xfrm>
            <a:off x="5817590" y="2993467"/>
            <a:ext cx="1143000" cy="1143000"/>
          </a:xfrm>
          <a:prstGeom prst="ellipse">
            <a:avLst/>
          </a:prstGeom>
          <a:solidFill>
            <a:srgbClr val="FF0000">
              <a:alpha val="25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Oval 18"/>
          <p:cNvSpPr/>
          <p:nvPr/>
        </p:nvSpPr>
        <p:spPr>
          <a:xfrm>
            <a:off x="1953692" y="3155566"/>
            <a:ext cx="1143000" cy="1143000"/>
          </a:xfrm>
          <a:prstGeom prst="ellipse">
            <a:avLst/>
          </a:prstGeom>
          <a:solidFill>
            <a:srgbClr val="FF0000">
              <a:alpha val="25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6 of 17</a:t>
            </a:r>
            <a:endParaRPr lang="en-US" sz="1200" i="1" dirty="0"/>
          </a:p>
        </p:txBody>
      </p:sp>
      <p:sp>
        <p:nvSpPr>
          <p:cNvPr id="13" name="Freeform 12"/>
          <p:cNvSpPr/>
          <p:nvPr/>
        </p:nvSpPr>
        <p:spPr>
          <a:xfrm>
            <a:off x="2242039" y="3473066"/>
            <a:ext cx="545836" cy="463960"/>
          </a:xfrm>
          <a:custGeom>
            <a:avLst/>
            <a:gdLst>
              <a:gd name="connsiteX0" fmla="*/ 271517 w 700690"/>
              <a:gd name="connsiteY0" fmla="*/ 0 h 595586"/>
              <a:gd name="connsiteX1" fmla="*/ 96345 w 700690"/>
              <a:gd name="connsiteY1" fmla="*/ 201448 h 595586"/>
              <a:gd name="connsiteX2" fmla="*/ 0 w 700690"/>
              <a:gd name="connsiteY2" fmla="*/ 516758 h 595586"/>
              <a:gd name="connsiteX3" fmla="*/ 297793 w 700690"/>
              <a:gd name="connsiteY3" fmla="*/ 595586 h 595586"/>
              <a:gd name="connsiteX4" fmla="*/ 621862 w 700690"/>
              <a:gd name="connsiteY4" fmla="*/ 490482 h 595586"/>
              <a:gd name="connsiteX5" fmla="*/ 700690 w 700690"/>
              <a:gd name="connsiteY5" fmla="*/ 96344 h 595586"/>
              <a:gd name="connsiteX6" fmla="*/ 455448 w 700690"/>
              <a:gd name="connsiteY6" fmla="*/ 87586 h 595586"/>
              <a:gd name="connsiteX7" fmla="*/ 271517 w 700690"/>
              <a:gd name="connsiteY7" fmla="*/ 0 h 59558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700690" h="595586">
                <a:moveTo>
                  <a:pt x="271517" y="0"/>
                </a:moveTo>
                <a:lnTo>
                  <a:pt x="96345" y="201448"/>
                </a:lnTo>
                <a:lnTo>
                  <a:pt x="0" y="516758"/>
                </a:lnTo>
                <a:lnTo>
                  <a:pt x="297793" y="595586"/>
                </a:lnTo>
                <a:lnTo>
                  <a:pt x="621862" y="490482"/>
                </a:lnTo>
                <a:lnTo>
                  <a:pt x="700690" y="96344"/>
                </a:lnTo>
                <a:lnTo>
                  <a:pt x="455448" y="87586"/>
                </a:lnTo>
                <a:lnTo>
                  <a:pt x="271517" y="0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Freeform 13"/>
          <p:cNvSpPr/>
          <p:nvPr/>
        </p:nvSpPr>
        <p:spPr>
          <a:xfrm>
            <a:off x="5994656" y="3268378"/>
            <a:ext cx="798284" cy="627710"/>
          </a:xfrm>
          <a:custGeom>
            <a:avLst/>
            <a:gdLst>
              <a:gd name="connsiteX0" fmla="*/ 131380 w 1024759"/>
              <a:gd name="connsiteY0" fmla="*/ 0 h 805793"/>
              <a:gd name="connsiteX1" fmla="*/ 0 w 1024759"/>
              <a:gd name="connsiteY1" fmla="*/ 534276 h 805793"/>
              <a:gd name="connsiteX2" fmla="*/ 254000 w 1024759"/>
              <a:gd name="connsiteY2" fmla="*/ 770759 h 805793"/>
              <a:gd name="connsiteX3" fmla="*/ 586828 w 1024759"/>
              <a:gd name="connsiteY3" fmla="*/ 805793 h 805793"/>
              <a:gd name="connsiteX4" fmla="*/ 902138 w 1024759"/>
              <a:gd name="connsiteY4" fmla="*/ 604345 h 805793"/>
              <a:gd name="connsiteX5" fmla="*/ 1016000 w 1024759"/>
              <a:gd name="connsiteY5" fmla="*/ 481724 h 805793"/>
              <a:gd name="connsiteX6" fmla="*/ 1024759 w 1024759"/>
              <a:gd name="connsiteY6" fmla="*/ 297793 h 805793"/>
              <a:gd name="connsiteX7" fmla="*/ 902138 w 1024759"/>
              <a:gd name="connsiteY7" fmla="*/ 218966 h 805793"/>
              <a:gd name="connsiteX8" fmla="*/ 718207 w 1024759"/>
              <a:gd name="connsiteY8" fmla="*/ 192690 h 805793"/>
              <a:gd name="connsiteX9" fmla="*/ 499242 w 1024759"/>
              <a:gd name="connsiteY9" fmla="*/ 262759 h 805793"/>
              <a:gd name="connsiteX10" fmla="*/ 131380 w 1024759"/>
              <a:gd name="connsiteY10" fmla="*/ 0 h 805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24759" h="805793">
                <a:moveTo>
                  <a:pt x="131380" y="0"/>
                </a:moveTo>
                <a:cubicBezTo>
                  <a:pt x="86899" y="177922"/>
                  <a:pt x="0" y="350879"/>
                  <a:pt x="0" y="534276"/>
                </a:cubicBezTo>
                <a:cubicBezTo>
                  <a:pt x="84771" y="612992"/>
                  <a:pt x="172205" y="688955"/>
                  <a:pt x="254000" y="770759"/>
                </a:cubicBezTo>
                <a:lnTo>
                  <a:pt x="586828" y="805793"/>
                </a:lnTo>
                <a:lnTo>
                  <a:pt x="902138" y="604345"/>
                </a:lnTo>
                <a:lnTo>
                  <a:pt x="1016000" y="481724"/>
                </a:lnTo>
                <a:lnTo>
                  <a:pt x="1024759" y="297793"/>
                </a:lnTo>
                <a:cubicBezTo>
                  <a:pt x="899762" y="208510"/>
                  <a:pt x="902138" y="159977"/>
                  <a:pt x="902138" y="218966"/>
                </a:cubicBezTo>
                <a:cubicBezTo>
                  <a:pt x="722917" y="183121"/>
                  <a:pt x="769072" y="141825"/>
                  <a:pt x="718207" y="192690"/>
                </a:cubicBezTo>
                <a:lnTo>
                  <a:pt x="499242" y="262759"/>
                </a:lnTo>
                <a:lnTo>
                  <a:pt x="131380" y="0"/>
                </a:lnTo>
                <a:close/>
              </a:path>
            </a:pathLst>
          </a:custGeom>
          <a:noFill/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ounded Rectangle 11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46847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 animBg="1"/>
      <p:bldP spid="19" grpId="0" animBg="1"/>
      <p:bldP spid="13" grpId="0" animBg="1"/>
      <p:bldP spid="14" grpId="0" animBg="1"/>
    </p:bld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rpal Injuries Summary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err="1" smtClean="0"/>
              <a:t>Scaphoid</a:t>
            </a:r>
            <a:r>
              <a:rPr lang="en-US" sz="2400" dirty="0" smtClean="0"/>
              <a:t> fracture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Urgent treatment is long arm thumb </a:t>
            </a:r>
            <a:r>
              <a:rPr lang="en-US" sz="2200" dirty="0" err="1" smtClean="0"/>
              <a:t>spica</a:t>
            </a:r>
            <a:r>
              <a:rPr lang="en-US" sz="2200" dirty="0" smtClean="0"/>
              <a:t> cast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Almost always need surgical intervention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Carpal dislocations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err="1" smtClean="0"/>
              <a:t>Lunate</a:t>
            </a:r>
            <a:r>
              <a:rPr lang="en-US" sz="2200" dirty="0" smtClean="0"/>
              <a:t> dislocation = </a:t>
            </a:r>
            <a:r>
              <a:rPr lang="en-US" sz="2200" dirty="0" err="1" smtClean="0"/>
              <a:t>lunate</a:t>
            </a:r>
            <a:r>
              <a:rPr lang="en-US" sz="2200" dirty="0" smtClean="0"/>
              <a:t> out of place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err="1" smtClean="0"/>
              <a:t>Perilunate</a:t>
            </a:r>
            <a:r>
              <a:rPr lang="en-US" sz="2200" dirty="0" smtClean="0"/>
              <a:t> dislocation = </a:t>
            </a:r>
            <a:r>
              <a:rPr lang="en-US" sz="2200" dirty="0" err="1" smtClean="0"/>
              <a:t>lunate</a:t>
            </a:r>
            <a:r>
              <a:rPr lang="en-US" sz="2200" dirty="0" smtClean="0"/>
              <a:t> in place, everything around </a:t>
            </a:r>
            <a:r>
              <a:rPr lang="en-US" sz="2200" dirty="0" err="1" smtClean="0"/>
              <a:t>lunate</a:t>
            </a:r>
            <a:r>
              <a:rPr lang="en-US" sz="2200" dirty="0" smtClean="0"/>
              <a:t> is dislocated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Very difficult to reduce in a closed fashion</a:t>
            </a:r>
          </a:p>
          <a:p>
            <a:pPr lvl="1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Need urgent surgical interventi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Types of Fracture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7 of 17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0797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3362093"/>
          </a:xfrm>
        </p:spPr>
        <p:txBody>
          <a:bodyPr>
            <a:normAutofit/>
          </a:bodyPr>
          <a:lstStyle/>
          <a:p>
            <a:pPr marL="0" indent="0">
              <a:spcBef>
                <a:spcPts val="576"/>
              </a:spcBef>
              <a:spcAft>
                <a:spcPts val="1000"/>
              </a:spcAft>
              <a:buNone/>
            </a:pPr>
            <a:r>
              <a:rPr lang="en-US" sz="2400" b="1" dirty="0" smtClean="0"/>
              <a:t>Open wounds</a:t>
            </a:r>
          </a:p>
          <a:p>
            <a:pPr marL="514350" indent="-4572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Antibiotics and tetanus</a:t>
            </a:r>
          </a:p>
          <a:p>
            <a:pPr marL="514350" indent="-4572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Consider taking a picture for the medical record and to avoid multiple people looking at the injury</a:t>
            </a:r>
          </a:p>
          <a:p>
            <a:pPr marL="514350" indent="-4572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Gently irrigate obvious debris away</a:t>
            </a:r>
          </a:p>
          <a:p>
            <a:pPr marL="514350" indent="-457200">
              <a:spcBef>
                <a:spcPts val="576"/>
              </a:spcBef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Sterile bandage</a:t>
            </a:r>
          </a:p>
        </p:txBody>
      </p:sp>
      <p:sp>
        <p:nvSpPr>
          <p:cNvPr id="11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rgent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1 of 9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0797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0" indent="0">
              <a:spcAft>
                <a:spcPts val="1000"/>
              </a:spcAft>
              <a:buNone/>
            </a:pPr>
            <a:r>
              <a:rPr lang="en-US" sz="2600" b="1" dirty="0" smtClean="0"/>
              <a:t>Deformity (dislocation or subluxation</a:t>
            </a:r>
            <a:r>
              <a:rPr lang="en-US" sz="2400" b="1" dirty="0" smtClean="0"/>
              <a:t>)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Reduce wrist to alleviate abnormal pressure on neurovascular structures and </a:t>
            </a:r>
            <a:r>
              <a:rPr lang="en-US" sz="2400" dirty="0"/>
              <a:t>skin; e</a:t>
            </a:r>
            <a:r>
              <a:rPr lang="en-US" sz="2400" dirty="0" smtClean="0"/>
              <a:t>xamine </a:t>
            </a:r>
            <a:r>
              <a:rPr lang="en-US" sz="2400" dirty="0"/>
              <a:t>and document neurovascular status pre- and post-</a:t>
            </a:r>
            <a:r>
              <a:rPr lang="en-US" sz="2400" dirty="0" smtClean="0"/>
              <a:t>intervention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Patient sedation as needed</a:t>
            </a:r>
          </a:p>
          <a:p>
            <a:pPr marL="971550" lvl="1" indent="-457200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Conscious sedation vs. hematoma block</a:t>
            </a:r>
          </a:p>
          <a:p>
            <a:pPr marL="514350" indent="-457200"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Reduction technique</a:t>
            </a:r>
          </a:p>
          <a:p>
            <a:pPr marL="971550" lvl="1" indent="-457200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Slight over-exaggeration of deformity</a:t>
            </a:r>
          </a:p>
          <a:p>
            <a:pPr marL="971550" lvl="1" indent="-457200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Traction</a:t>
            </a:r>
          </a:p>
          <a:p>
            <a:pPr marL="971550" lvl="1" indent="-457200">
              <a:spcAft>
                <a:spcPts val="1000"/>
              </a:spcAft>
              <a:buFont typeface="Wingdings" panose="05000000000000000000" pitchFamily="2" charset="2"/>
              <a:buChar char="v"/>
            </a:pPr>
            <a:r>
              <a:rPr lang="en-US" sz="2200" dirty="0" smtClean="0"/>
              <a:t>Translation of </a:t>
            </a:r>
            <a:r>
              <a:rPr lang="en-US" sz="2200" dirty="0" err="1" smtClean="0"/>
              <a:t>carpus</a:t>
            </a:r>
            <a:r>
              <a:rPr lang="en-US" sz="2200" dirty="0" smtClean="0"/>
              <a:t> (NOT FLEXION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2 of 9</a:t>
            </a:r>
            <a:endParaRPr lang="en-US" sz="1200" i="1" dirty="0"/>
          </a:p>
        </p:txBody>
      </p:sp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rgent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8" name="Rounded Rectangle 7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0797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43833" y="1495704"/>
            <a:ext cx="3802566" cy="4001847"/>
          </a:xfrm>
        </p:spPr>
        <p:txBody>
          <a:bodyPr>
            <a:normAutofit fontScale="92500" lnSpcReduction="20000"/>
          </a:bodyPr>
          <a:lstStyle/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Dorsal TRANSLATION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Note thumbs translating carpus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Versus fingers translating forearm in opposite direction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This example is for an apex dorsal deformity</a:t>
            </a:r>
          </a:p>
          <a:p>
            <a:pPr>
              <a:lnSpc>
                <a:spcPct val="110000"/>
              </a:lnSpc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(See radiographs on next slide)</a:t>
            </a:r>
          </a:p>
        </p:txBody>
      </p:sp>
      <p:pic>
        <p:nvPicPr>
          <p:cNvPr id="8" name="Picture 7" descr="IMG_7593.png"/>
          <p:cNvPicPr>
            <a:picLocks noChangeAspect="1"/>
          </p:cNvPicPr>
          <p:nvPr/>
        </p:nvPicPr>
        <p:blipFill>
          <a:blip r:embed="rId3"/>
          <a:srcRect l="25040" t="38865" r="40139" b="3868"/>
          <a:stretch>
            <a:fillRect/>
          </a:stretch>
        </p:blipFill>
        <p:spPr>
          <a:xfrm rot="5400000">
            <a:off x="631165" y="1085608"/>
            <a:ext cx="4130524" cy="50948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3 of 9</a:t>
            </a:r>
            <a:endParaRPr lang="en-US" sz="1200" i="1" dirty="0"/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rgent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0" name="Rounded Rectangle 9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0797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ntents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aphicFrame>
        <p:nvGraphicFramePr>
          <p:cNvPr id="16" name="Diagram 15"/>
          <p:cNvGraphicFramePr/>
          <p:nvPr>
            <p:extLst>
              <p:ext uri="{D42A27DB-BD31-4B8C-83A1-F6EECF244321}">
                <p14:modId xmlns:p14="http://schemas.microsoft.com/office/powerpoint/2010/main" val="1388986859"/>
              </p:ext>
            </p:extLst>
          </p:nvPr>
        </p:nvGraphicFramePr>
        <p:xfrm>
          <a:off x="189571" y="1185588"/>
          <a:ext cx="8764858" cy="504794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28941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P DR 2.tif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87" b="17306"/>
          <a:stretch/>
        </p:blipFill>
        <p:spPr>
          <a:xfrm>
            <a:off x="694944" y="1371600"/>
            <a:ext cx="3735416" cy="4114800"/>
          </a:xfrm>
          <a:prstGeom prst="rect">
            <a:avLst/>
          </a:prstGeom>
        </p:spPr>
      </p:pic>
      <p:pic>
        <p:nvPicPr>
          <p:cNvPr id="39" name="Picture 38" descr="Lat DR 2.tiff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5" r="27649" b="31125"/>
          <a:stretch/>
        </p:blipFill>
        <p:spPr>
          <a:xfrm>
            <a:off x="4957402" y="1371600"/>
            <a:ext cx="3491371" cy="4114800"/>
          </a:xfrm>
          <a:prstGeom prst="rect">
            <a:avLst/>
          </a:prstGeom>
        </p:spPr>
      </p:pic>
      <p:sp>
        <p:nvSpPr>
          <p:cNvPr id="40" name="Oval 39"/>
          <p:cNvSpPr/>
          <p:nvPr/>
        </p:nvSpPr>
        <p:spPr>
          <a:xfrm>
            <a:off x="5769864" y="3099816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Freeform 40"/>
          <p:cNvSpPr/>
          <p:nvPr/>
        </p:nvSpPr>
        <p:spPr>
          <a:xfrm>
            <a:off x="6681422" y="3571446"/>
            <a:ext cx="425984" cy="219446"/>
          </a:xfrm>
          <a:custGeom>
            <a:avLst/>
            <a:gdLst>
              <a:gd name="connsiteX0" fmla="*/ 0 w 578069"/>
              <a:gd name="connsiteY0" fmla="*/ 0 h 297793"/>
              <a:gd name="connsiteX1" fmla="*/ 420414 w 578069"/>
              <a:gd name="connsiteY1" fmla="*/ 297793 h 297793"/>
              <a:gd name="connsiteX2" fmla="*/ 481724 w 578069"/>
              <a:gd name="connsiteY2" fmla="*/ 254000 h 297793"/>
              <a:gd name="connsiteX3" fmla="*/ 578069 w 578069"/>
              <a:gd name="connsiteY3" fmla="*/ 175172 h 297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78069" h="297793">
                <a:moveTo>
                  <a:pt x="0" y="0"/>
                </a:moveTo>
                <a:lnTo>
                  <a:pt x="420414" y="297793"/>
                </a:lnTo>
                <a:lnTo>
                  <a:pt x="481724" y="254000"/>
                </a:lnTo>
                <a:lnTo>
                  <a:pt x="578069" y="17517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Freeform 41"/>
          <p:cNvSpPr/>
          <p:nvPr/>
        </p:nvSpPr>
        <p:spPr>
          <a:xfrm>
            <a:off x="6236075" y="3552083"/>
            <a:ext cx="1071413" cy="627934"/>
          </a:xfrm>
          <a:custGeom>
            <a:avLst/>
            <a:gdLst>
              <a:gd name="connsiteX0" fmla="*/ 52552 w 1453931"/>
              <a:gd name="connsiteY0" fmla="*/ 770759 h 852121"/>
              <a:gd name="connsiteX1" fmla="*/ 0 w 1453931"/>
              <a:gd name="connsiteY1" fmla="*/ 350345 h 852121"/>
              <a:gd name="connsiteX2" fmla="*/ 113862 w 1453931"/>
              <a:gd name="connsiteY2" fmla="*/ 753241 h 852121"/>
              <a:gd name="connsiteX3" fmla="*/ 201449 w 1453931"/>
              <a:gd name="connsiteY3" fmla="*/ 744483 h 852121"/>
              <a:gd name="connsiteX4" fmla="*/ 271518 w 1453931"/>
              <a:gd name="connsiteY4" fmla="*/ 709448 h 852121"/>
              <a:gd name="connsiteX5" fmla="*/ 411656 w 1453931"/>
              <a:gd name="connsiteY5" fmla="*/ 788276 h 852121"/>
              <a:gd name="connsiteX6" fmla="*/ 464207 w 1453931"/>
              <a:gd name="connsiteY6" fmla="*/ 709448 h 852121"/>
              <a:gd name="connsiteX7" fmla="*/ 753242 w 1453931"/>
              <a:gd name="connsiteY7" fmla="*/ 823310 h 852121"/>
              <a:gd name="connsiteX8" fmla="*/ 1007242 w 1453931"/>
              <a:gd name="connsiteY8" fmla="*/ 709448 h 852121"/>
              <a:gd name="connsiteX9" fmla="*/ 1453931 w 1453931"/>
              <a:gd name="connsiteY9" fmla="*/ 639379 h 852121"/>
              <a:gd name="connsiteX10" fmla="*/ 1156138 w 1453931"/>
              <a:gd name="connsiteY10" fmla="*/ 192690 h 852121"/>
              <a:gd name="connsiteX11" fmla="*/ 1261242 w 1453931"/>
              <a:gd name="connsiteY11" fmla="*/ 0 h 8521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453931" h="852121">
                <a:moveTo>
                  <a:pt x="52552" y="770759"/>
                </a:moveTo>
                <a:lnTo>
                  <a:pt x="0" y="350345"/>
                </a:lnTo>
                <a:cubicBezTo>
                  <a:pt x="37954" y="484644"/>
                  <a:pt x="50347" y="628973"/>
                  <a:pt x="113862" y="753241"/>
                </a:cubicBezTo>
                <a:cubicBezTo>
                  <a:pt x="127216" y="779367"/>
                  <a:pt x="201449" y="744483"/>
                  <a:pt x="201449" y="744483"/>
                </a:cubicBezTo>
                <a:lnTo>
                  <a:pt x="271518" y="709448"/>
                </a:lnTo>
                <a:cubicBezTo>
                  <a:pt x="414132" y="798582"/>
                  <a:pt x="411656" y="852121"/>
                  <a:pt x="411656" y="788276"/>
                </a:cubicBezTo>
                <a:cubicBezTo>
                  <a:pt x="456867" y="706896"/>
                  <a:pt x="425390" y="709448"/>
                  <a:pt x="464207" y="709448"/>
                </a:cubicBezTo>
                <a:lnTo>
                  <a:pt x="753242" y="823310"/>
                </a:lnTo>
                <a:lnTo>
                  <a:pt x="1007242" y="709448"/>
                </a:lnTo>
                <a:lnTo>
                  <a:pt x="1453931" y="639379"/>
                </a:lnTo>
                <a:lnTo>
                  <a:pt x="1156138" y="192690"/>
                </a:lnTo>
                <a:lnTo>
                  <a:pt x="1261242" y="0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32588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/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ra-articular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4 of 9</a:t>
            </a:r>
            <a:endParaRPr lang="en-US" sz="1200" i="1" dirty="0"/>
          </a:p>
        </p:txBody>
      </p:sp>
      <p:sp>
        <p:nvSpPr>
          <p:cNvPr id="17" name="Freeform 16"/>
          <p:cNvSpPr/>
          <p:nvPr/>
        </p:nvSpPr>
        <p:spPr>
          <a:xfrm>
            <a:off x="2012573" y="3861537"/>
            <a:ext cx="363758" cy="299358"/>
          </a:xfrm>
          <a:custGeom>
            <a:avLst/>
            <a:gdLst>
              <a:gd name="connsiteX0" fmla="*/ 0 w 492743"/>
              <a:gd name="connsiteY0" fmla="*/ 274128 h 405508"/>
              <a:gd name="connsiteX1" fmla="*/ 140138 w 492743"/>
              <a:gd name="connsiteY1" fmla="*/ 169025 h 405508"/>
              <a:gd name="connsiteX2" fmla="*/ 201448 w 492743"/>
              <a:gd name="connsiteY2" fmla="*/ 405508 h 405508"/>
              <a:gd name="connsiteX3" fmla="*/ 490483 w 492743"/>
              <a:gd name="connsiteY3" fmla="*/ 160266 h 405508"/>
              <a:gd name="connsiteX4" fmla="*/ 402896 w 492743"/>
              <a:gd name="connsiteY4" fmla="*/ 2611 h 4055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92743" h="405508">
                <a:moveTo>
                  <a:pt x="0" y="274128"/>
                </a:moveTo>
                <a:lnTo>
                  <a:pt x="140138" y="169025"/>
                </a:lnTo>
                <a:lnTo>
                  <a:pt x="201448" y="405508"/>
                </a:lnTo>
                <a:cubicBezTo>
                  <a:pt x="492743" y="167176"/>
                  <a:pt x="490483" y="293509"/>
                  <a:pt x="490483" y="160266"/>
                </a:cubicBezTo>
                <a:cubicBezTo>
                  <a:pt x="410349" y="0"/>
                  <a:pt x="470410" y="2611"/>
                  <a:pt x="402896" y="2611"/>
                </a:cubicBez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Freeform 17"/>
          <p:cNvSpPr/>
          <p:nvPr/>
        </p:nvSpPr>
        <p:spPr>
          <a:xfrm>
            <a:off x="2393427" y="3829051"/>
            <a:ext cx="660153" cy="344445"/>
          </a:xfrm>
          <a:custGeom>
            <a:avLst/>
            <a:gdLst>
              <a:gd name="connsiteX0" fmla="*/ 894237 w 894237"/>
              <a:gd name="connsiteY0" fmla="*/ 449513 h 466582"/>
              <a:gd name="connsiteX1" fmla="*/ 666513 w 894237"/>
              <a:gd name="connsiteY1" fmla="*/ 414478 h 466582"/>
              <a:gd name="connsiteX2" fmla="*/ 648995 w 894237"/>
              <a:gd name="connsiteY2" fmla="*/ 291858 h 466582"/>
              <a:gd name="connsiteX3" fmla="*/ 447547 w 894237"/>
              <a:gd name="connsiteY3" fmla="*/ 396961 h 466582"/>
              <a:gd name="connsiteX4" fmla="*/ 202306 w 894237"/>
              <a:gd name="connsiteY4" fmla="*/ 335651 h 466582"/>
              <a:gd name="connsiteX5" fmla="*/ 123478 w 894237"/>
              <a:gd name="connsiteY5" fmla="*/ 2823 h 466582"/>
              <a:gd name="connsiteX6" fmla="*/ 70926 w 894237"/>
              <a:gd name="connsiteY6" fmla="*/ 11582 h 4665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94237" h="466582">
                <a:moveTo>
                  <a:pt x="894237" y="449513"/>
                </a:moveTo>
                <a:lnTo>
                  <a:pt x="666513" y="414478"/>
                </a:lnTo>
                <a:lnTo>
                  <a:pt x="648995" y="291858"/>
                </a:lnTo>
                <a:cubicBezTo>
                  <a:pt x="458193" y="419058"/>
                  <a:pt x="517168" y="466582"/>
                  <a:pt x="447547" y="396961"/>
                </a:cubicBezTo>
                <a:lnTo>
                  <a:pt x="202306" y="335651"/>
                </a:lnTo>
                <a:cubicBezTo>
                  <a:pt x="113977" y="0"/>
                  <a:pt x="0" y="2823"/>
                  <a:pt x="123478" y="2823"/>
                </a:cubicBezTo>
                <a:lnTo>
                  <a:pt x="70926" y="1158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/>
          <p:cNvCxnSpPr>
            <a:stCxn id="17" idx="3"/>
            <a:endCxn id="18" idx="4"/>
          </p:cNvCxnSpPr>
          <p:nvPr/>
        </p:nvCxnSpPr>
        <p:spPr>
          <a:xfrm>
            <a:off x="2374663" y="3979850"/>
            <a:ext cx="168113" cy="96989"/>
          </a:xfrm>
          <a:prstGeom prst="line">
            <a:avLst/>
          </a:pr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Freeform 19"/>
          <p:cNvSpPr/>
          <p:nvPr/>
        </p:nvSpPr>
        <p:spPr>
          <a:xfrm>
            <a:off x="1411246" y="3979850"/>
            <a:ext cx="556066" cy="305925"/>
          </a:xfrm>
          <a:custGeom>
            <a:avLst/>
            <a:gdLst>
              <a:gd name="connsiteX0" fmla="*/ 0 w 753242"/>
              <a:gd name="connsiteY0" fmla="*/ 0 h 414403"/>
              <a:gd name="connsiteX1" fmla="*/ 236483 w 753242"/>
              <a:gd name="connsiteY1" fmla="*/ 157656 h 414403"/>
              <a:gd name="connsiteX2" fmla="*/ 341586 w 753242"/>
              <a:gd name="connsiteY2" fmla="*/ 140138 h 414403"/>
              <a:gd name="connsiteX3" fmla="*/ 472966 w 753242"/>
              <a:gd name="connsiteY3" fmla="*/ 192690 h 414403"/>
              <a:gd name="connsiteX4" fmla="*/ 560552 w 753242"/>
              <a:gd name="connsiteY4" fmla="*/ 411656 h 414403"/>
              <a:gd name="connsiteX5" fmla="*/ 753242 w 753242"/>
              <a:gd name="connsiteY5" fmla="*/ 297793 h 4144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53242" h="414403">
                <a:moveTo>
                  <a:pt x="0" y="0"/>
                </a:moveTo>
                <a:cubicBezTo>
                  <a:pt x="238954" y="150453"/>
                  <a:pt x="236483" y="55746"/>
                  <a:pt x="236483" y="157656"/>
                </a:cubicBezTo>
                <a:lnTo>
                  <a:pt x="341586" y="140138"/>
                </a:lnTo>
                <a:cubicBezTo>
                  <a:pt x="475736" y="184854"/>
                  <a:pt x="472966" y="137769"/>
                  <a:pt x="472966" y="192690"/>
                </a:cubicBezTo>
                <a:cubicBezTo>
                  <a:pt x="552782" y="414403"/>
                  <a:pt x="474219" y="411656"/>
                  <a:pt x="560552" y="411656"/>
                </a:cubicBezTo>
                <a:lnTo>
                  <a:pt x="753242" y="297793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Oval 20"/>
          <p:cNvSpPr/>
          <p:nvPr/>
        </p:nvSpPr>
        <p:spPr>
          <a:xfrm>
            <a:off x="1316736" y="3200400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ounded Rectangle 21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00591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500"/>
                            </p:stCondLst>
                            <p:childTnLst>
                              <p:par>
                                <p:cTn id="17" presetID="2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9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" fill="hold">
                            <p:stCondLst>
                              <p:cond delay="2000"/>
                            </p:stCondLst>
                            <p:childTnLst>
                              <p:par>
                                <p:cTn id="21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3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4" fill="hold">
                            <p:stCondLst>
                              <p:cond delay="2500"/>
                            </p:stCondLst>
                            <p:childTnLst>
                              <p:par>
                                <p:cTn id="25" presetID="10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8" fill="hold">
                            <p:stCondLst>
                              <p:cond delay="3000"/>
                            </p:stCondLst>
                            <p:childTnLst>
                              <p:par>
                                <p:cTn id="2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1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2" fill="hold">
                            <p:stCondLst>
                              <p:cond delay="3500"/>
                            </p:stCondLst>
                            <p:childTnLst>
                              <p:par>
                                <p:cTn id="33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35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0" grpId="0" animBg="1"/>
      <p:bldP spid="41" grpId="0" animBg="1"/>
      <p:bldP spid="42" grpId="0" animBg="1"/>
      <p:bldP spid="17" grpId="0" animBg="1"/>
      <p:bldP spid="18" grpId="0" animBg="1"/>
      <p:bldP spid="20" grpId="0" animBg="1"/>
      <p:bldP spid="21" grpId="0" animBg="1"/>
    </p:bld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P DR 2.tif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87" b="17306"/>
          <a:stretch/>
        </p:blipFill>
        <p:spPr>
          <a:xfrm>
            <a:off x="694944" y="1371600"/>
            <a:ext cx="3735416" cy="4114800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>
          <a:xfrm>
            <a:off x="1316736" y="3200400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 descr="AP DR 2 postred.tiff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77" t="39032" r="12831"/>
          <a:stretch/>
        </p:blipFill>
        <p:spPr>
          <a:xfrm>
            <a:off x="4109924" y="1389447"/>
            <a:ext cx="3718193" cy="4114800"/>
          </a:xfrm>
          <a:prstGeom prst="rect">
            <a:avLst/>
          </a:prstGeom>
        </p:spPr>
      </p:pic>
      <p:sp>
        <p:nvSpPr>
          <p:cNvPr id="15" name="Rounded Rectangular Callout 14"/>
          <p:cNvSpPr/>
          <p:nvPr/>
        </p:nvSpPr>
        <p:spPr>
          <a:xfrm>
            <a:off x="4430360" y="4389120"/>
            <a:ext cx="2743200" cy="1097280"/>
          </a:xfrm>
          <a:prstGeom prst="wedgeRoundRectCallout">
            <a:avLst>
              <a:gd name="adj1" fmla="val 11184"/>
              <a:gd name="adj2" fmla="val -123170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Well-aligned </a:t>
            </a:r>
            <a:r>
              <a:rPr lang="en-US" dirty="0">
                <a:solidFill>
                  <a:prstClr val="white"/>
                </a:solidFill>
              </a:rPr>
              <a:t>wrist joint with appropriate </a:t>
            </a:r>
            <a:r>
              <a:rPr lang="en-US" dirty="0" err="1">
                <a:solidFill>
                  <a:prstClr val="white"/>
                </a:solidFill>
              </a:rPr>
              <a:t>radiocarpal</a:t>
            </a:r>
            <a:r>
              <a:rPr lang="en-US" dirty="0">
                <a:solidFill>
                  <a:prstClr val="white"/>
                </a:solidFill>
              </a:rPr>
              <a:t> space</a:t>
            </a:r>
          </a:p>
        </p:txBody>
      </p:sp>
      <p:sp>
        <p:nvSpPr>
          <p:cNvPr id="9" name="Freeform 8"/>
          <p:cNvSpPr/>
          <p:nvPr/>
        </p:nvSpPr>
        <p:spPr>
          <a:xfrm>
            <a:off x="1411246" y="3979850"/>
            <a:ext cx="556066" cy="305925"/>
          </a:xfrm>
          <a:custGeom>
            <a:avLst/>
            <a:gdLst>
              <a:gd name="connsiteX0" fmla="*/ 0 w 753242"/>
              <a:gd name="connsiteY0" fmla="*/ 0 h 414403"/>
              <a:gd name="connsiteX1" fmla="*/ 236483 w 753242"/>
              <a:gd name="connsiteY1" fmla="*/ 157656 h 414403"/>
              <a:gd name="connsiteX2" fmla="*/ 341586 w 753242"/>
              <a:gd name="connsiteY2" fmla="*/ 140138 h 414403"/>
              <a:gd name="connsiteX3" fmla="*/ 472966 w 753242"/>
              <a:gd name="connsiteY3" fmla="*/ 192690 h 414403"/>
              <a:gd name="connsiteX4" fmla="*/ 560552 w 753242"/>
              <a:gd name="connsiteY4" fmla="*/ 411656 h 414403"/>
              <a:gd name="connsiteX5" fmla="*/ 753242 w 753242"/>
              <a:gd name="connsiteY5" fmla="*/ 297793 h 4144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53242" h="414403">
                <a:moveTo>
                  <a:pt x="0" y="0"/>
                </a:moveTo>
                <a:cubicBezTo>
                  <a:pt x="238954" y="150453"/>
                  <a:pt x="236483" y="55746"/>
                  <a:pt x="236483" y="157656"/>
                </a:cubicBezTo>
                <a:lnTo>
                  <a:pt x="341586" y="140138"/>
                </a:lnTo>
                <a:cubicBezTo>
                  <a:pt x="475736" y="184854"/>
                  <a:pt x="472966" y="137769"/>
                  <a:pt x="472966" y="192690"/>
                </a:cubicBezTo>
                <a:cubicBezTo>
                  <a:pt x="552782" y="414403"/>
                  <a:pt x="474219" y="411656"/>
                  <a:pt x="560552" y="411656"/>
                </a:cubicBezTo>
                <a:lnTo>
                  <a:pt x="753242" y="297793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Freeform 9"/>
          <p:cNvSpPr/>
          <p:nvPr/>
        </p:nvSpPr>
        <p:spPr>
          <a:xfrm>
            <a:off x="2012573" y="3861537"/>
            <a:ext cx="363758" cy="299358"/>
          </a:xfrm>
          <a:custGeom>
            <a:avLst/>
            <a:gdLst>
              <a:gd name="connsiteX0" fmla="*/ 0 w 492743"/>
              <a:gd name="connsiteY0" fmla="*/ 274128 h 405508"/>
              <a:gd name="connsiteX1" fmla="*/ 140138 w 492743"/>
              <a:gd name="connsiteY1" fmla="*/ 169025 h 405508"/>
              <a:gd name="connsiteX2" fmla="*/ 201448 w 492743"/>
              <a:gd name="connsiteY2" fmla="*/ 405508 h 405508"/>
              <a:gd name="connsiteX3" fmla="*/ 490483 w 492743"/>
              <a:gd name="connsiteY3" fmla="*/ 160266 h 405508"/>
              <a:gd name="connsiteX4" fmla="*/ 402896 w 492743"/>
              <a:gd name="connsiteY4" fmla="*/ 2611 h 40550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92743" h="405508">
                <a:moveTo>
                  <a:pt x="0" y="274128"/>
                </a:moveTo>
                <a:lnTo>
                  <a:pt x="140138" y="169025"/>
                </a:lnTo>
                <a:lnTo>
                  <a:pt x="201448" y="405508"/>
                </a:lnTo>
                <a:cubicBezTo>
                  <a:pt x="492743" y="167176"/>
                  <a:pt x="490483" y="293509"/>
                  <a:pt x="490483" y="160266"/>
                </a:cubicBezTo>
                <a:cubicBezTo>
                  <a:pt x="410349" y="0"/>
                  <a:pt x="470410" y="2611"/>
                  <a:pt x="402896" y="2611"/>
                </a:cubicBez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Freeform 10"/>
          <p:cNvSpPr/>
          <p:nvPr/>
        </p:nvSpPr>
        <p:spPr>
          <a:xfrm>
            <a:off x="2393427" y="3829051"/>
            <a:ext cx="660153" cy="344445"/>
          </a:xfrm>
          <a:custGeom>
            <a:avLst/>
            <a:gdLst>
              <a:gd name="connsiteX0" fmla="*/ 894237 w 894237"/>
              <a:gd name="connsiteY0" fmla="*/ 449513 h 466582"/>
              <a:gd name="connsiteX1" fmla="*/ 666513 w 894237"/>
              <a:gd name="connsiteY1" fmla="*/ 414478 h 466582"/>
              <a:gd name="connsiteX2" fmla="*/ 648995 w 894237"/>
              <a:gd name="connsiteY2" fmla="*/ 291858 h 466582"/>
              <a:gd name="connsiteX3" fmla="*/ 447547 w 894237"/>
              <a:gd name="connsiteY3" fmla="*/ 396961 h 466582"/>
              <a:gd name="connsiteX4" fmla="*/ 202306 w 894237"/>
              <a:gd name="connsiteY4" fmla="*/ 335651 h 466582"/>
              <a:gd name="connsiteX5" fmla="*/ 123478 w 894237"/>
              <a:gd name="connsiteY5" fmla="*/ 2823 h 466582"/>
              <a:gd name="connsiteX6" fmla="*/ 70926 w 894237"/>
              <a:gd name="connsiteY6" fmla="*/ 11582 h 4665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894237" h="466582">
                <a:moveTo>
                  <a:pt x="894237" y="449513"/>
                </a:moveTo>
                <a:lnTo>
                  <a:pt x="666513" y="414478"/>
                </a:lnTo>
                <a:lnTo>
                  <a:pt x="648995" y="291858"/>
                </a:lnTo>
                <a:cubicBezTo>
                  <a:pt x="458193" y="419058"/>
                  <a:pt x="517168" y="466582"/>
                  <a:pt x="447547" y="396961"/>
                </a:cubicBezTo>
                <a:lnTo>
                  <a:pt x="202306" y="335651"/>
                </a:lnTo>
                <a:cubicBezTo>
                  <a:pt x="113977" y="0"/>
                  <a:pt x="0" y="2823"/>
                  <a:pt x="123478" y="2823"/>
                </a:cubicBezTo>
                <a:lnTo>
                  <a:pt x="70926" y="1158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" name="Straight Connector 15"/>
          <p:cNvCxnSpPr>
            <a:stCxn id="10" idx="3"/>
            <a:endCxn id="11" idx="4"/>
          </p:cNvCxnSpPr>
          <p:nvPr/>
        </p:nvCxnSpPr>
        <p:spPr>
          <a:xfrm>
            <a:off x="2374663" y="3979850"/>
            <a:ext cx="168113" cy="96989"/>
          </a:xfrm>
          <a:prstGeom prst="line">
            <a:avLst/>
          </a:pr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Rounded Rectangular Callout 16"/>
          <p:cNvSpPr/>
          <p:nvPr/>
        </p:nvSpPr>
        <p:spPr>
          <a:xfrm flipV="1">
            <a:off x="4467949" y="1731350"/>
            <a:ext cx="2743200" cy="777240"/>
          </a:xfrm>
          <a:prstGeom prst="wedgeRoundRectCallout">
            <a:avLst>
              <a:gd name="adj1" fmla="val -13826"/>
              <a:gd name="adj2" fmla="val -179566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US" sz="2800" dirty="0">
              <a:solidFill>
                <a:prstClr val="white"/>
              </a:solidFill>
            </a:endParaRPr>
          </a:p>
        </p:txBody>
      </p:sp>
      <p:sp>
        <p:nvSpPr>
          <p:cNvPr id="14" name="Rounded Rectangular Callout 13"/>
          <p:cNvSpPr/>
          <p:nvPr/>
        </p:nvSpPr>
        <p:spPr>
          <a:xfrm>
            <a:off x="4467949" y="1731350"/>
            <a:ext cx="2743200" cy="777240"/>
          </a:xfrm>
          <a:prstGeom prst="wedgeRoundRectCallout">
            <a:avLst>
              <a:gd name="adj1" fmla="val 36026"/>
              <a:gd name="adj2" fmla="val 98912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>
                <a:solidFill>
                  <a:prstClr val="white"/>
                </a:solidFill>
              </a:rPr>
              <a:t>Radial styloid distal to ulnar styloid</a:t>
            </a:r>
          </a:p>
        </p:txBody>
      </p:sp>
      <p:sp>
        <p:nvSpPr>
          <p:cNvPr id="20" name="Title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32588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/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ra-articular pre and post reduc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1" name="Rounded Rectangle 20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5 of 9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3297266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 descr="Lat DR 2.tiff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75" r="27649" b="31125"/>
          <a:stretch/>
        </p:blipFill>
        <p:spPr>
          <a:xfrm>
            <a:off x="457200" y="1522983"/>
            <a:ext cx="3491371" cy="4114800"/>
          </a:xfrm>
          <a:prstGeom prst="rect">
            <a:avLst/>
          </a:prstGeom>
        </p:spPr>
      </p:pic>
      <p:sp>
        <p:nvSpPr>
          <p:cNvPr id="22" name="Oval 21"/>
          <p:cNvSpPr/>
          <p:nvPr/>
        </p:nvSpPr>
        <p:spPr>
          <a:xfrm>
            <a:off x="1353312" y="3099816"/>
            <a:ext cx="1828800" cy="1828800"/>
          </a:xfrm>
          <a:prstGeom prst="ellipse">
            <a:avLst/>
          </a:prstGeom>
          <a:solidFill>
            <a:srgbClr val="FF0000">
              <a:alpha val="10000"/>
            </a:srgbClr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reeform 22"/>
          <p:cNvSpPr/>
          <p:nvPr/>
        </p:nvSpPr>
        <p:spPr>
          <a:xfrm>
            <a:off x="2181220" y="3722829"/>
            <a:ext cx="425984" cy="219446"/>
          </a:xfrm>
          <a:custGeom>
            <a:avLst/>
            <a:gdLst>
              <a:gd name="connsiteX0" fmla="*/ 0 w 578069"/>
              <a:gd name="connsiteY0" fmla="*/ 0 h 297793"/>
              <a:gd name="connsiteX1" fmla="*/ 420414 w 578069"/>
              <a:gd name="connsiteY1" fmla="*/ 297793 h 297793"/>
              <a:gd name="connsiteX2" fmla="*/ 481724 w 578069"/>
              <a:gd name="connsiteY2" fmla="*/ 254000 h 297793"/>
              <a:gd name="connsiteX3" fmla="*/ 578069 w 578069"/>
              <a:gd name="connsiteY3" fmla="*/ 175172 h 297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578069" h="297793">
                <a:moveTo>
                  <a:pt x="0" y="0"/>
                </a:moveTo>
                <a:lnTo>
                  <a:pt x="420414" y="297793"/>
                </a:lnTo>
                <a:lnTo>
                  <a:pt x="481724" y="254000"/>
                </a:lnTo>
                <a:lnTo>
                  <a:pt x="578069" y="175172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Freeform 23"/>
          <p:cNvSpPr/>
          <p:nvPr/>
        </p:nvSpPr>
        <p:spPr>
          <a:xfrm>
            <a:off x="1735873" y="3703466"/>
            <a:ext cx="1071413" cy="627934"/>
          </a:xfrm>
          <a:custGeom>
            <a:avLst/>
            <a:gdLst>
              <a:gd name="connsiteX0" fmla="*/ 52552 w 1453931"/>
              <a:gd name="connsiteY0" fmla="*/ 770759 h 852121"/>
              <a:gd name="connsiteX1" fmla="*/ 0 w 1453931"/>
              <a:gd name="connsiteY1" fmla="*/ 350345 h 852121"/>
              <a:gd name="connsiteX2" fmla="*/ 113862 w 1453931"/>
              <a:gd name="connsiteY2" fmla="*/ 753241 h 852121"/>
              <a:gd name="connsiteX3" fmla="*/ 201449 w 1453931"/>
              <a:gd name="connsiteY3" fmla="*/ 744483 h 852121"/>
              <a:gd name="connsiteX4" fmla="*/ 271518 w 1453931"/>
              <a:gd name="connsiteY4" fmla="*/ 709448 h 852121"/>
              <a:gd name="connsiteX5" fmla="*/ 411656 w 1453931"/>
              <a:gd name="connsiteY5" fmla="*/ 788276 h 852121"/>
              <a:gd name="connsiteX6" fmla="*/ 464207 w 1453931"/>
              <a:gd name="connsiteY6" fmla="*/ 709448 h 852121"/>
              <a:gd name="connsiteX7" fmla="*/ 753242 w 1453931"/>
              <a:gd name="connsiteY7" fmla="*/ 823310 h 852121"/>
              <a:gd name="connsiteX8" fmla="*/ 1007242 w 1453931"/>
              <a:gd name="connsiteY8" fmla="*/ 709448 h 852121"/>
              <a:gd name="connsiteX9" fmla="*/ 1453931 w 1453931"/>
              <a:gd name="connsiteY9" fmla="*/ 639379 h 852121"/>
              <a:gd name="connsiteX10" fmla="*/ 1156138 w 1453931"/>
              <a:gd name="connsiteY10" fmla="*/ 192690 h 852121"/>
              <a:gd name="connsiteX11" fmla="*/ 1261242 w 1453931"/>
              <a:gd name="connsiteY11" fmla="*/ 0 h 8521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453931" h="852121">
                <a:moveTo>
                  <a:pt x="52552" y="770759"/>
                </a:moveTo>
                <a:lnTo>
                  <a:pt x="0" y="350345"/>
                </a:lnTo>
                <a:cubicBezTo>
                  <a:pt x="37954" y="484644"/>
                  <a:pt x="50347" y="628973"/>
                  <a:pt x="113862" y="753241"/>
                </a:cubicBezTo>
                <a:cubicBezTo>
                  <a:pt x="127216" y="779367"/>
                  <a:pt x="201449" y="744483"/>
                  <a:pt x="201449" y="744483"/>
                </a:cubicBezTo>
                <a:lnTo>
                  <a:pt x="271518" y="709448"/>
                </a:lnTo>
                <a:cubicBezTo>
                  <a:pt x="414132" y="798582"/>
                  <a:pt x="411656" y="852121"/>
                  <a:pt x="411656" y="788276"/>
                </a:cubicBezTo>
                <a:cubicBezTo>
                  <a:pt x="456867" y="706896"/>
                  <a:pt x="425390" y="709448"/>
                  <a:pt x="464207" y="709448"/>
                </a:cubicBezTo>
                <a:lnTo>
                  <a:pt x="753242" y="823310"/>
                </a:lnTo>
                <a:lnTo>
                  <a:pt x="1007242" y="709448"/>
                </a:lnTo>
                <a:lnTo>
                  <a:pt x="1453931" y="639379"/>
                </a:lnTo>
                <a:lnTo>
                  <a:pt x="1156138" y="192690"/>
                </a:lnTo>
                <a:lnTo>
                  <a:pt x="1261242" y="0"/>
                </a:lnTo>
              </a:path>
            </a:pathLst>
          </a:custGeom>
          <a:ln w="38100" cap="flat" cmpd="sng" algn="ctr">
            <a:solidFill>
              <a:srgbClr val="FFFF00"/>
            </a:solidFill>
            <a:prstDash val="sysDash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Picture 4" descr="Lat DR 2 postred.tiff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759" t="37528" r="34019" b="16471"/>
          <a:stretch/>
        </p:blipFill>
        <p:spPr>
          <a:xfrm rot="18906163">
            <a:off x="3952279" y="2464772"/>
            <a:ext cx="4744720" cy="3051641"/>
          </a:xfrm>
          <a:prstGeom prst="rect">
            <a:avLst/>
          </a:prstGeom>
        </p:spPr>
      </p:pic>
      <p:sp>
        <p:nvSpPr>
          <p:cNvPr id="18" name="Rounded Rectangular Callout 17"/>
          <p:cNvSpPr/>
          <p:nvPr/>
        </p:nvSpPr>
        <p:spPr>
          <a:xfrm>
            <a:off x="3724502" y="2548895"/>
            <a:ext cx="2514600" cy="777240"/>
          </a:xfrm>
          <a:prstGeom prst="wedgeRoundRectCallout">
            <a:avLst>
              <a:gd name="adj1" fmla="val 64331"/>
              <a:gd name="adj2" fmla="val 68786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err="1">
                <a:solidFill>
                  <a:prstClr val="white"/>
                </a:solidFill>
              </a:rPr>
              <a:t>Capitate</a:t>
            </a:r>
            <a:r>
              <a:rPr lang="en-US" dirty="0">
                <a:solidFill>
                  <a:prstClr val="white"/>
                </a:solidFill>
              </a:rPr>
              <a:t> / lunate / radius </a:t>
            </a:r>
            <a:r>
              <a:rPr lang="en-US" dirty="0" smtClean="0">
                <a:solidFill>
                  <a:prstClr val="white"/>
                </a:solidFill>
              </a:rPr>
              <a:t>in </a:t>
            </a:r>
            <a:r>
              <a:rPr lang="en-US" dirty="0">
                <a:solidFill>
                  <a:prstClr val="white"/>
                </a:solidFill>
              </a:rPr>
              <a:t>line</a:t>
            </a:r>
          </a:p>
        </p:txBody>
      </p:sp>
      <p:sp>
        <p:nvSpPr>
          <p:cNvPr id="19" name="Rounded Rectangular Callout 18"/>
          <p:cNvSpPr/>
          <p:nvPr/>
        </p:nvSpPr>
        <p:spPr>
          <a:xfrm>
            <a:off x="3724502" y="4133388"/>
            <a:ext cx="2514600" cy="1097280"/>
          </a:xfrm>
          <a:prstGeom prst="wedgeRoundRectCallout">
            <a:avLst>
              <a:gd name="adj1" fmla="val 57885"/>
              <a:gd name="adj2" fmla="val -6769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Well-aligned </a:t>
            </a:r>
            <a:r>
              <a:rPr lang="en-US" dirty="0">
                <a:solidFill>
                  <a:prstClr val="white"/>
                </a:solidFill>
              </a:rPr>
              <a:t>wrist joint with appropriate </a:t>
            </a:r>
            <a:r>
              <a:rPr lang="en-US" dirty="0" err="1">
                <a:solidFill>
                  <a:prstClr val="white"/>
                </a:solidFill>
              </a:rPr>
              <a:t>radiocarpal</a:t>
            </a:r>
            <a:r>
              <a:rPr lang="en-US" dirty="0">
                <a:solidFill>
                  <a:prstClr val="white"/>
                </a:solidFill>
              </a:rPr>
              <a:t> space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6556540" y="2810108"/>
            <a:ext cx="206485" cy="1435208"/>
          </a:xfrm>
          <a:prstGeom prst="straightConnector1">
            <a:avLst/>
          </a:prstGeom>
          <a:ln w="50800" cap="flat" cmpd="sng" algn="ctr">
            <a:solidFill>
              <a:srgbClr val="00B050"/>
            </a:solidFill>
            <a:prstDash val="sysDot"/>
            <a:round/>
            <a:headEnd type="stealth" w="med" len="med"/>
            <a:tailEnd type="stealth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6 of 9</a:t>
            </a:r>
            <a:endParaRPr lang="en-US" sz="1200" i="1" dirty="0"/>
          </a:p>
        </p:txBody>
      </p:sp>
      <p:sp>
        <p:nvSpPr>
          <p:cNvPr id="17" name="Title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32588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istal Radius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/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tra-articular pre and post reduc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15" name="Rounded Rectangle 14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72668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rgent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6316" y="1494263"/>
            <a:ext cx="6400800" cy="4759148"/>
          </a:xfrm>
        </p:spPr>
        <p:txBody>
          <a:bodyPr>
            <a:normAutofit/>
          </a:bodyPr>
          <a:lstStyle/>
          <a:p>
            <a:pPr marL="0" indent="0">
              <a:spcAft>
                <a:spcPts val="1000"/>
              </a:spcAft>
              <a:buNone/>
            </a:pPr>
            <a:r>
              <a:rPr lang="en-US" sz="2600" b="1" dirty="0"/>
              <a:t>Splinting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3-5 layers of padding, depending on thickness of your cotton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Be sure to pad bony prominences to avoid pressure sores (</a:t>
            </a:r>
            <a:r>
              <a:rPr lang="en-US" sz="2200" dirty="0" err="1" smtClean="0"/>
              <a:t>ulnar</a:t>
            </a:r>
            <a:r>
              <a:rPr lang="en-US" sz="2200" dirty="0" smtClean="0"/>
              <a:t> </a:t>
            </a:r>
            <a:r>
              <a:rPr lang="en-US" sz="2200" dirty="0" err="1" smtClean="0"/>
              <a:t>styloid</a:t>
            </a:r>
            <a:r>
              <a:rPr lang="en-US" sz="2200" dirty="0" smtClean="0"/>
              <a:t>, </a:t>
            </a:r>
            <a:r>
              <a:rPr lang="en-US" sz="2200" dirty="0" err="1" smtClean="0"/>
              <a:t>olecranon</a:t>
            </a:r>
            <a:r>
              <a:rPr lang="en-US" sz="2200" dirty="0" smtClean="0"/>
              <a:t>)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10 layers plaster for strength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Must have wrist in neutral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Sugar tong shape; do NOT pass transverse </a:t>
            </a:r>
            <a:r>
              <a:rPr lang="en-US" sz="2200" dirty="0" err="1" smtClean="0"/>
              <a:t>palmar</a:t>
            </a:r>
            <a:r>
              <a:rPr lang="en-US" sz="2200" dirty="0" smtClean="0"/>
              <a:t> crease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200" dirty="0" smtClean="0"/>
              <a:t>Gentle ACE wrap to avoid cutting off circulation</a:t>
            </a:r>
          </a:p>
        </p:txBody>
      </p:sp>
      <p:sp>
        <p:nvSpPr>
          <p:cNvPr id="5" name="Rectangle 4"/>
          <p:cNvSpPr/>
          <p:nvPr/>
        </p:nvSpPr>
        <p:spPr>
          <a:xfrm>
            <a:off x="426216" y="5955223"/>
            <a:ext cx="2707281" cy="70788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Reproduced with permission from Koman LA </a:t>
            </a:r>
            <a:r>
              <a:rPr lang="en-US" sz="1000" dirty="0" smtClean="0"/>
              <a:t>ed.</a:t>
            </a:r>
          </a:p>
          <a:p>
            <a:r>
              <a:rPr lang="en-US" sz="1000" dirty="0" smtClean="0"/>
              <a:t>Wake </a:t>
            </a:r>
            <a:r>
              <a:rPr lang="en-US" sz="1000" dirty="0"/>
              <a:t>Forest University Orthopaedic </a:t>
            </a:r>
            <a:r>
              <a:rPr lang="en-US" sz="1000" dirty="0" smtClean="0"/>
              <a:t>Manual</a:t>
            </a:r>
          </a:p>
          <a:p>
            <a:r>
              <a:rPr lang="en-US" sz="1000" dirty="0" smtClean="0"/>
              <a:t>Wake </a:t>
            </a:r>
            <a:r>
              <a:rPr lang="en-US" sz="1000" dirty="0"/>
              <a:t>Forest University Orthopaedic </a:t>
            </a:r>
            <a:r>
              <a:rPr lang="en-US" sz="1000" dirty="0" smtClean="0"/>
              <a:t>Press,</a:t>
            </a:r>
          </a:p>
          <a:p>
            <a:r>
              <a:rPr lang="en-US" sz="1000" dirty="0" smtClean="0"/>
              <a:t>Winston-Salem</a:t>
            </a:r>
            <a:r>
              <a:rPr lang="en-US" sz="1000" dirty="0"/>
              <a:t>, NC, </a:t>
            </a:r>
            <a:r>
              <a:rPr lang="en-US" sz="1000" dirty="0" smtClean="0"/>
              <a:t>27157</a:t>
            </a:r>
            <a:endParaRPr lang="en-US" sz="1000" dirty="0"/>
          </a:p>
        </p:txBody>
      </p:sp>
      <p:pic>
        <p:nvPicPr>
          <p:cNvPr id="2051" name="Picture 3" descr="S:\ort\File Transfers (Data Over 24 hrs is Removed Automatically)\Eileen to Dr. Anna Miller\Dr Miller wrist splint 020615.jpg"/>
          <p:cNvPicPr>
            <a:picLocks noChangeAspect="1" noChangeArrowheads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" r="22968" b="2822"/>
          <a:stretch/>
        </p:blipFill>
        <p:spPr bwMode="auto">
          <a:xfrm>
            <a:off x="426216" y="1741017"/>
            <a:ext cx="1887706" cy="411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7 of 9</a:t>
            </a:r>
            <a:endParaRPr lang="en-US" sz="1200" i="1" dirty="0"/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hlinkClick r:id="" action="ppaction://customshow?id=3&amp;return=true"/>
          </p:cNvPr>
          <p:cNvSpPr txBox="1"/>
          <p:nvPr/>
        </p:nvSpPr>
        <p:spPr>
          <a:xfrm>
            <a:off x="4114800" y="1617906"/>
            <a:ext cx="685800" cy="246221"/>
          </a:xfrm>
          <a:prstGeom prst="rect">
            <a:avLst/>
          </a:prstGeom>
          <a:gradFill>
            <a:gsLst>
              <a:gs pos="0">
                <a:schemeClr val="accent1">
                  <a:tint val="66000"/>
                  <a:satMod val="160000"/>
                </a:schemeClr>
              </a:gs>
              <a:gs pos="50000">
                <a:schemeClr val="accent1">
                  <a:tint val="44500"/>
                  <a:satMod val="160000"/>
                </a:schemeClr>
              </a:gs>
              <a:gs pos="100000">
                <a:schemeClr val="accent1">
                  <a:tint val="23500"/>
                  <a:satMod val="160000"/>
                </a:schemeClr>
              </a:gs>
            </a:gsLst>
            <a:lin ang="5400000" scaled="0"/>
          </a:gradFill>
          <a:scene3d>
            <a:camera prst="orthographicFront"/>
            <a:lightRig rig="threePt" dir="t"/>
          </a:scene3d>
          <a:sp3d>
            <a:bevelT w="165100" prst="coolSlant"/>
          </a:sp3d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chemeClr val="bg1"/>
                </a:solidFill>
              </a:rPr>
              <a:t>More …</a:t>
            </a:r>
            <a:endParaRPr lang="en-US" sz="10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973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solidFill>
                  <a:prstClr val="white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rgent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7" name="Picture 6" descr="IMG_7593.png"/>
          <p:cNvPicPr>
            <a:picLocks noChangeAspect="1"/>
          </p:cNvPicPr>
          <p:nvPr/>
        </p:nvPicPr>
        <p:blipFill>
          <a:blip r:embed="rId3"/>
          <a:srcRect l="25040" t="57630" r="55092" b="21141"/>
          <a:stretch>
            <a:fillRect/>
          </a:stretch>
        </p:blipFill>
        <p:spPr>
          <a:xfrm rot="5400000">
            <a:off x="149315" y="2516835"/>
            <a:ext cx="3763849" cy="3016169"/>
          </a:xfrm>
          <a:prstGeom prst="rect">
            <a:avLst/>
          </a:prstGeom>
        </p:spPr>
      </p:pic>
      <p:sp>
        <p:nvSpPr>
          <p:cNvPr id="16" name="Rounded Rectangular Callout 15"/>
          <p:cNvSpPr/>
          <p:nvPr/>
        </p:nvSpPr>
        <p:spPr>
          <a:xfrm>
            <a:off x="3692577" y="2880271"/>
            <a:ext cx="2514600" cy="411480"/>
          </a:xfrm>
          <a:prstGeom prst="wedgeRoundRectCallout">
            <a:avLst>
              <a:gd name="adj1" fmla="val -131422"/>
              <a:gd name="adj2" fmla="val 48351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Do not end splint here!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17" name="Rounded Rectangular Callout 16"/>
          <p:cNvSpPr/>
          <p:nvPr/>
        </p:nvSpPr>
        <p:spPr>
          <a:xfrm>
            <a:off x="3692577" y="4509481"/>
            <a:ext cx="2514600" cy="411480"/>
          </a:xfrm>
          <a:prstGeom prst="wedgeRoundRectCallout">
            <a:avLst>
              <a:gd name="adj1" fmla="val -134815"/>
              <a:gd name="adj2" fmla="val -17140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dirty="0" smtClean="0">
                <a:solidFill>
                  <a:prstClr val="white"/>
                </a:solidFill>
              </a:rPr>
              <a:t>Splint ends </a:t>
            </a:r>
            <a:r>
              <a:rPr lang="en-US" dirty="0">
                <a:solidFill>
                  <a:prstClr val="white"/>
                </a:solidFill>
              </a:rPr>
              <a:t>h</a:t>
            </a:r>
            <a:r>
              <a:rPr lang="en-US" dirty="0" smtClean="0">
                <a:solidFill>
                  <a:prstClr val="white"/>
                </a:solidFill>
              </a:rPr>
              <a:t>ere!</a:t>
            </a:r>
            <a:endParaRPr lang="en-US" dirty="0">
              <a:solidFill>
                <a:prstClr val="white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8 of 9</a:t>
            </a:r>
            <a:endParaRPr lang="en-US" sz="1200" i="1" dirty="0"/>
          </a:p>
        </p:txBody>
      </p:sp>
      <p:sp>
        <p:nvSpPr>
          <p:cNvPr id="3" name="TextBox 2"/>
          <p:cNvSpPr txBox="1"/>
          <p:nvPr/>
        </p:nvSpPr>
        <p:spPr>
          <a:xfrm>
            <a:off x="3692577" y="1618898"/>
            <a:ext cx="17588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Splinting</a:t>
            </a:r>
            <a:endParaRPr lang="en-US" sz="2400" b="1" dirty="0"/>
          </a:p>
        </p:txBody>
      </p:sp>
      <p:sp>
        <p:nvSpPr>
          <p:cNvPr id="10" name="Rounded Rectangular Callout 9"/>
          <p:cNvSpPr/>
          <p:nvPr/>
        </p:nvSpPr>
        <p:spPr>
          <a:xfrm>
            <a:off x="3692577" y="3511996"/>
            <a:ext cx="2514600" cy="777240"/>
          </a:xfrm>
          <a:prstGeom prst="wedgeRoundRectCallout">
            <a:avLst>
              <a:gd name="adj1" fmla="val -125946"/>
              <a:gd name="adj2" fmla="val -8483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b="1" i="1" dirty="0">
                <a:solidFill>
                  <a:prstClr val="white"/>
                </a:solidFill>
              </a:rPr>
              <a:t>Do not pass transverse palmar crease</a:t>
            </a:r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457200" y="3436714"/>
            <a:ext cx="1895707" cy="1200450"/>
          </a:xfrm>
          <a:prstGeom prst="line">
            <a:avLst/>
          </a:prstGeom>
          <a:ln w="38100">
            <a:solidFill>
              <a:srgbClr val="FFFF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ounded Rectangle 11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97389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89768"/>
            <a:ext cx="8229600" cy="3685476"/>
          </a:xfrm>
        </p:spPr>
        <p:txBody>
          <a:bodyPr>
            <a:normAutofit/>
          </a:bodyPr>
          <a:lstStyle/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For open fractures, neurovascular compromise (including acute carpal tunnel syndrome), or irreducible dislocations, emergent management is required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For injuries that require surgery but do not include the above, follow up in the next 7-10 days is appropriate to schedule surgical intervention</a:t>
            </a:r>
          </a:p>
          <a:p>
            <a:pPr>
              <a:spcAft>
                <a:spcPts val="1000"/>
              </a:spcAft>
              <a:buFont typeface="Wingdings" panose="05000000000000000000" pitchFamily="2" charset="2"/>
              <a:buChar char="Ø"/>
            </a:pPr>
            <a:r>
              <a:rPr lang="en-US" sz="2400" dirty="0" smtClean="0"/>
              <a:t>For injuries that do not require surgery, follow-up in 10-14 days is appropriat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Management</a:t>
            </a:r>
          </a:p>
          <a:p>
            <a:pPr algn="r"/>
            <a:r>
              <a:rPr lang="en-US" sz="1200" i="1" dirty="0"/>
              <a:t>S</a:t>
            </a:r>
            <a:r>
              <a:rPr lang="en-US" sz="1200" i="1" dirty="0" smtClean="0"/>
              <a:t>lide 9 of 9</a:t>
            </a:r>
            <a:endParaRPr lang="en-US" sz="1200" i="1" dirty="0"/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25562"/>
          </a:xfrm>
        </p:spPr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anagement</a:t>
            </a:r>
            <a:b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3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Definitive</a:t>
            </a:r>
            <a:endParaRPr lang="en-US" sz="36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0797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1371600" y="274638"/>
            <a:ext cx="6400800" cy="1143000"/>
          </a:xfrm>
        </p:spPr>
        <p:txBody>
          <a:bodyPr>
            <a:normAutofit/>
          </a:bodyPr>
          <a:lstStyle/>
          <a:p>
            <a:r>
              <a:rPr lang="en-US" sz="2200" b="1" dirty="0"/>
              <a:t>What are the standard radiographs to order for </a:t>
            </a:r>
            <a:r>
              <a:rPr lang="en-US" sz="2200" b="1" dirty="0" smtClean="0"/>
              <a:t>a wrist </a:t>
            </a:r>
            <a:r>
              <a:rPr lang="en-US" sz="2200" b="1" dirty="0"/>
              <a:t>injury?</a:t>
            </a:r>
            <a:endParaRPr lang="en-US" dirty="0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914400" y="1600200"/>
            <a:ext cx="7315200" cy="4525963"/>
          </a:xfrm>
        </p:spPr>
        <p:txBody>
          <a:bodyPr/>
          <a:lstStyle/>
          <a:p>
            <a:pPr lvl="0">
              <a:buFont typeface="+mj-lt"/>
              <a:buAutoNum type="arabicPeriod"/>
            </a:pPr>
            <a:r>
              <a:rPr lang="en-US" sz="1800" dirty="0" smtClean="0"/>
              <a:t>PA</a:t>
            </a:r>
            <a:endParaRPr lang="en-US" sz="1800" dirty="0"/>
          </a:p>
          <a:p>
            <a:pPr lvl="0">
              <a:buFont typeface="+mj-lt"/>
              <a:buAutoNum type="arabicPeriod"/>
            </a:pPr>
            <a:r>
              <a:rPr lang="en-US" sz="1800" dirty="0" smtClean="0"/>
              <a:t>Lateral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8941904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1371600" y="274638"/>
            <a:ext cx="6400800" cy="1143000"/>
          </a:xfrm>
        </p:spPr>
        <p:txBody>
          <a:bodyPr>
            <a:normAutofit/>
          </a:bodyPr>
          <a:lstStyle/>
          <a:p>
            <a:r>
              <a:rPr lang="en-US" sz="2200" b="1" dirty="0"/>
              <a:t>What are the criteria for operative intervention in </a:t>
            </a:r>
            <a:r>
              <a:rPr lang="en-US" sz="2200" b="1" dirty="0" smtClean="0"/>
              <a:t>a wrist injury</a:t>
            </a:r>
            <a:r>
              <a:rPr lang="en-US" sz="2200" b="1" dirty="0"/>
              <a:t>?</a:t>
            </a:r>
            <a:endParaRPr lang="en-US" dirty="0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914400" y="1600200"/>
            <a:ext cx="7315200" cy="4525963"/>
          </a:xfrm>
        </p:spPr>
        <p:txBody>
          <a:bodyPr/>
          <a:lstStyle/>
          <a:p>
            <a:pPr lvl="0">
              <a:buFont typeface="+mj-lt"/>
              <a:buAutoNum type="arabicPeriod"/>
            </a:pPr>
            <a:r>
              <a:rPr lang="en-US" sz="1800" dirty="0"/>
              <a:t>Carpal bone fractures or dislocations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Intra-articular fractures with displacement &gt;2 mm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Open fracture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Irreducible </a:t>
            </a:r>
            <a:r>
              <a:rPr lang="en-US" sz="1800" dirty="0" smtClean="0"/>
              <a:t>dislocation</a:t>
            </a:r>
          </a:p>
          <a:p>
            <a:pPr lvl="0">
              <a:buFont typeface="+mj-lt"/>
              <a:buAutoNum type="arabicPeriod"/>
            </a:pPr>
            <a:r>
              <a:rPr lang="en-US" sz="1800" dirty="0" smtClean="0"/>
              <a:t>Acute carpal tunnel syndrome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32704777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1371600" y="274638"/>
            <a:ext cx="6400800" cy="1143000"/>
          </a:xfrm>
        </p:spPr>
        <p:txBody>
          <a:bodyPr>
            <a:normAutofit/>
          </a:bodyPr>
          <a:lstStyle/>
          <a:p>
            <a:r>
              <a:rPr lang="en-US" sz="2200" b="1" dirty="0"/>
              <a:t>What </a:t>
            </a:r>
            <a:r>
              <a:rPr lang="en-US" sz="2200" b="1" dirty="0" smtClean="0"/>
              <a:t>wrist </a:t>
            </a:r>
            <a:r>
              <a:rPr lang="en-US" sz="2200" b="1" dirty="0"/>
              <a:t>injuries should be considered for urgent or emergent management?</a:t>
            </a:r>
            <a:endParaRPr lang="en-US" dirty="0"/>
          </a:p>
        </p:txBody>
      </p:sp>
      <p:sp>
        <p:nvSpPr>
          <p:cNvPr id="4" name="Content Placeholder 2"/>
          <p:cNvSpPr>
            <a:spLocks noGrp="1"/>
          </p:cNvSpPr>
          <p:nvPr>
            <p:ph idx="1"/>
          </p:nvPr>
        </p:nvSpPr>
        <p:spPr>
          <a:xfrm>
            <a:off x="914400" y="1600200"/>
            <a:ext cx="7315200" cy="4525963"/>
          </a:xfrm>
        </p:spPr>
        <p:txBody>
          <a:bodyPr/>
          <a:lstStyle/>
          <a:p>
            <a:pPr lvl="0">
              <a:buFont typeface="+mj-lt"/>
              <a:buAutoNum type="arabicPeriod"/>
            </a:pPr>
            <a:r>
              <a:rPr lang="en-US" sz="1800" dirty="0"/>
              <a:t>Open fracture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Irreducible dislocation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Scaphoid fracture</a:t>
            </a:r>
          </a:p>
          <a:p>
            <a:pPr lvl="0">
              <a:buFont typeface="+mj-lt"/>
              <a:buAutoNum type="arabicPeriod"/>
            </a:pPr>
            <a:r>
              <a:rPr lang="en-US" sz="1800" dirty="0"/>
              <a:t>Acute carpal tunnel syndrome</a:t>
            </a:r>
          </a:p>
          <a:p>
            <a:endParaRPr lang="en-US" sz="1800" dirty="0" smtClean="0"/>
          </a:p>
          <a:p>
            <a:pPr marL="0" indent="0">
              <a:buNone/>
            </a:pPr>
            <a:r>
              <a:rPr lang="en-US" sz="1800" dirty="0" smtClean="0"/>
              <a:t>Other </a:t>
            </a:r>
            <a:r>
              <a:rPr lang="en-US" sz="1800" dirty="0"/>
              <a:t>wrist injuries that require operative intervention </a:t>
            </a:r>
            <a:r>
              <a:rPr lang="en-US" sz="1800" dirty="0" smtClean="0"/>
              <a:t>may follow </a:t>
            </a:r>
            <a:r>
              <a:rPr lang="en-US" sz="1800" dirty="0"/>
              <a:t>up with orthopaedic surgeon over the next 7-10 days after </a:t>
            </a:r>
            <a:r>
              <a:rPr lang="en-US" sz="1800" dirty="0" smtClean="0"/>
              <a:t>splinting; patient should be instructed to keep hand elevated to allow swelling to </a:t>
            </a:r>
            <a:r>
              <a:rPr lang="en-US" sz="1800" smtClean="0"/>
              <a:t>go down</a:t>
            </a:r>
            <a:endParaRPr lang="en-US" sz="1800" dirty="0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0" y="274638"/>
            <a:ext cx="6400800" cy="1143000"/>
          </a:xfrm>
        </p:spPr>
        <p:txBody>
          <a:bodyPr>
            <a:normAutofit/>
          </a:bodyPr>
          <a:lstStyle/>
          <a:p>
            <a:r>
              <a:rPr lang="en-US" sz="2200" b="1" dirty="0" smtClean="0"/>
              <a:t>Splinting (additional information)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4400" y="1600200"/>
            <a:ext cx="7315200" cy="4525963"/>
          </a:xfrm>
        </p:spPr>
        <p:txBody>
          <a:bodyPr/>
          <a:lstStyle/>
          <a:p>
            <a:pPr marL="0" lvl="0" indent="0">
              <a:buNone/>
            </a:pPr>
            <a:r>
              <a:rPr lang="en-US" sz="1800" dirty="0" smtClean="0"/>
              <a:t>Some Emergency Rooms are transitioning to fiberglass splinting because this is lighter and more comfortable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40902672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1 of 8</a:t>
            </a:r>
            <a:endParaRPr lang="en-US" sz="1200" i="1" dirty="0"/>
          </a:p>
        </p:txBody>
      </p:sp>
      <p:sp>
        <p:nvSpPr>
          <p:cNvPr id="7" name="Rounded Rectangle 6">
            <a:hlinkClick r:id="rId3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  <p:sp>
        <p:nvSpPr>
          <p:cNvPr id="8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264795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b="1" dirty="0" smtClean="0"/>
              <a:t>Overall appearance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200" dirty="0"/>
              <a:t>Examine skin at zone of injury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200" dirty="0" smtClean="0"/>
              <a:t>Open wounds: 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000" dirty="0" smtClean="0"/>
              <a:t>Open wound + fracture = OPEN FRACTURE</a:t>
            </a:r>
          </a:p>
          <a:p>
            <a:pPr>
              <a:buFont typeface="Wingdings" panose="05000000000000000000" pitchFamily="2" charset="2"/>
              <a:buChar char="Ø"/>
            </a:pPr>
            <a:r>
              <a:rPr lang="en-US" sz="2200" dirty="0" smtClean="0"/>
              <a:t>Deformity:</a:t>
            </a:r>
          </a:p>
          <a:p>
            <a:pPr lvl="1">
              <a:buFont typeface="Wingdings" panose="05000000000000000000" pitchFamily="2" charset="2"/>
              <a:buChar char="v"/>
            </a:pPr>
            <a:r>
              <a:rPr lang="en-US" sz="2000" dirty="0" smtClean="0"/>
              <a:t>Watch out for skin at risk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irculation Evaluation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pic>
        <p:nvPicPr>
          <p:cNvPr id="4" name="Picture 3" descr="IMG_7571.JPG"/>
          <p:cNvPicPr>
            <a:picLocks noChangeAspect="1"/>
          </p:cNvPicPr>
          <p:nvPr/>
        </p:nvPicPr>
        <p:blipFill>
          <a:blip r:embed="rId3"/>
          <a:srcRect l="30214" t="19030" r="26230" b="7908"/>
          <a:stretch>
            <a:fillRect/>
          </a:stretch>
        </p:blipFill>
        <p:spPr>
          <a:xfrm rot="10800000">
            <a:off x="2514601" y="1344456"/>
            <a:ext cx="4114800" cy="4169087"/>
          </a:xfrm>
          <a:prstGeom prst="rect">
            <a:avLst/>
          </a:prstGeom>
        </p:spPr>
      </p:pic>
      <p:sp>
        <p:nvSpPr>
          <p:cNvPr id="3" name="Rounded Rectangular Callout 2"/>
          <p:cNvSpPr/>
          <p:nvPr/>
        </p:nvSpPr>
        <p:spPr>
          <a:xfrm>
            <a:off x="6835698" y="4716966"/>
            <a:ext cx="1828800" cy="411480"/>
          </a:xfrm>
          <a:prstGeom prst="wedgeRoundRectCallout">
            <a:avLst>
              <a:gd name="adj1" fmla="val -138295"/>
              <a:gd name="adj2" fmla="val -97845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Pulse (radial)</a:t>
            </a:r>
            <a:endParaRPr lang="en-US" dirty="0"/>
          </a:p>
        </p:txBody>
      </p:sp>
      <p:sp>
        <p:nvSpPr>
          <p:cNvPr id="12" name="Rounded Rectangular Callout 11"/>
          <p:cNvSpPr/>
          <p:nvPr/>
        </p:nvSpPr>
        <p:spPr>
          <a:xfrm>
            <a:off x="6835698" y="2423532"/>
            <a:ext cx="1828800" cy="411480"/>
          </a:xfrm>
          <a:prstGeom prst="wedgeRoundRectCallout">
            <a:avLst>
              <a:gd name="adj1" fmla="val -66148"/>
              <a:gd name="adj2" fmla="val -156475"/>
              <a:gd name="adj3" fmla="val 16667"/>
            </a:avLst>
          </a:prstGeom>
          <a:solidFill>
            <a:schemeClr val="accent1">
              <a:alpha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Capillary refill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2 of 8</a:t>
            </a:r>
            <a:endParaRPr lang="en-US" sz="1200" i="1" dirty="0"/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nsory Evaluation – Radial Nerv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514600" y="1371601"/>
            <a:ext cx="4114800" cy="4114800"/>
            <a:chOff x="2851082" y="1371601"/>
            <a:chExt cx="3441835" cy="4114800"/>
          </a:xfrm>
        </p:grpSpPr>
        <p:pic>
          <p:nvPicPr>
            <p:cNvPr id="12" name="Picture 11" descr="IMG_7590.JPG"/>
            <p:cNvPicPr>
              <a:picLocks noChangeAspect="1"/>
            </p:cNvPicPr>
            <p:nvPr/>
          </p:nvPicPr>
          <p:blipFill>
            <a:blip r:embed="rId3"/>
            <a:srcRect r="10336"/>
            <a:stretch>
              <a:fillRect/>
            </a:stretch>
          </p:blipFill>
          <p:spPr>
            <a:xfrm rot="16200000">
              <a:off x="2514600" y="1708083"/>
              <a:ext cx="4114800" cy="3441835"/>
            </a:xfrm>
            <a:prstGeom prst="rect">
              <a:avLst/>
            </a:prstGeom>
          </p:spPr>
        </p:pic>
        <p:sp>
          <p:nvSpPr>
            <p:cNvPr id="14" name="Freeform 13"/>
            <p:cNvSpPr/>
            <p:nvPr/>
          </p:nvSpPr>
          <p:spPr>
            <a:xfrm>
              <a:off x="2884535" y="1417637"/>
              <a:ext cx="2646470" cy="3656171"/>
            </a:xfrm>
            <a:custGeom>
              <a:avLst/>
              <a:gdLst>
                <a:gd name="connsiteX0" fmla="*/ 3290108 w 3290108"/>
                <a:gd name="connsiteY0" fmla="*/ 500339 h 4349093"/>
                <a:gd name="connsiteX1" fmla="*/ 2154924 w 3290108"/>
                <a:gd name="connsiteY1" fmla="*/ 4329850 h 4349093"/>
                <a:gd name="connsiteX2" fmla="*/ 1135183 w 3290108"/>
                <a:gd name="connsiteY2" fmla="*/ 4349093 h 4349093"/>
                <a:gd name="connsiteX3" fmla="*/ 0 w 3290108"/>
                <a:gd name="connsiteY3" fmla="*/ 2001353 h 4349093"/>
                <a:gd name="connsiteX4" fmla="*/ 1385308 w 3290108"/>
                <a:gd name="connsiteY4" fmla="*/ 211682 h 4349093"/>
                <a:gd name="connsiteX5" fmla="*/ 2539732 w 3290108"/>
                <a:gd name="connsiteY5" fmla="*/ 0 h 4349093"/>
                <a:gd name="connsiteX6" fmla="*/ 3290108 w 3290108"/>
                <a:gd name="connsiteY6" fmla="*/ 500339 h 43490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290108" h="4349093">
                  <a:moveTo>
                    <a:pt x="3290108" y="500339"/>
                  </a:moveTo>
                  <a:lnTo>
                    <a:pt x="2154924" y="4329850"/>
                  </a:lnTo>
                  <a:lnTo>
                    <a:pt x="1135183" y="4349093"/>
                  </a:lnTo>
                  <a:lnTo>
                    <a:pt x="0" y="2001353"/>
                  </a:lnTo>
                  <a:lnTo>
                    <a:pt x="1385308" y="211682"/>
                  </a:lnTo>
                  <a:lnTo>
                    <a:pt x="2539732" y="0"/>
                  </a:lnTo>
                  <a:lnTo>
                    <a:pt x="3290108" y="500339"/>
                  </a:lnTo>
                  <a:close/>
                </a:path>
              </a:pathLst>
            </a:custGeom>
            <a:gradFill flip="none" rotWithShape="1">
              <a:gsLst>
                <a:gs pos="0">
                  <a:schemeClr val="accent1">
                    <a:shade val="51000"/>
                    <a:satMod val="130000"/>
                    <a:alpha val="25000"/>
                  </a:schemeClr>
                </a:gs>
                <a:gs pos="80000">
                  <a:schemeClr val="accent1">
                    <a:shade val="93000"/>
                    <a:satMod val="130000"/>
                    <a:alpha val="25000"/>
                  </a:schemeClr>
                </a:gs>
                <a:gs pos="100000">
                  <a:schemeClr val="accent1">
                    <a:shade val="94000"/>
                    <a:satMod val="135000"/>
                    <a:alpha val="2500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3 of 8</a:t>
            </a:r>
            <a:endParaRPr lang="en-US" sz="1200" i="1" dirty="0"/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3686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nsory Evaluation </a:t>
            </a:r>
            <a:r>
              <a:rPr lang="en-US" sz="40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– </a:t>
            </a: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edian Nerv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2514600" y="1371600"/>
            <a:ext cx="4114800" cy="4114800"/>
            <a:chOff x="4410861" y="1420750"/>
            <a:chExt cx="4305040" cy="4882191"/>
          </a:xfrm>
        </p:grpSpPr>
        <p:pic>
          <p:nvPicPr>
            <p:cNvPr id="7" name="Picture 6" descr="IMG_7591.JPG"/>
            <p:cNvPicPr>
              <a:picLocks noChangeAspect="1"/>
            </p:cNvPicPr>
            <p:nvPr/>
          </p:nvPicPr>
          <p:blipFill>
            <a:blip r:embed="rId3"/>
            <a:srcRect l="7126" r="7241"/>
            <a:stretch>
              <a:fillRect/>
            </a:stretch>
          </p:blipFill>
          <p:spPr>
            <a:xfrm rot="16200000">
              <a:off x="4107735" y="1723876"/>
              <a:ext cx="4882191" cy="4275940"/>
            </a:xfrm>
            <a:prstGeom prst="rect">
              <a:avLst/>
            </a:prstGeom>
          </p:spPr>
        </p:pic>
        <p:sp>
          <p:nvSpPr>
            <p:cNvPr id="8" name="Freeform 7"/>
            <p:cNvSpPr/>
            <p:nvPr/>
          </p:nvSpPr>
          <p:spPr>
            <a:xfrm>
              <a:off x="5714399" y="1539502"/>
              <a:ext cx="3001502" cy="4733968"/>
            </a:xfrm>
            <a:custGeom>
              <a:avLst/>
              <a:gdLst>
                <a:gd name="connsiteX0" fmla="*/ 0 w 3001502"/>
                <a:gd name="connsiteY0" fmla="*/ 288657 h 4733968"/>
                <a:gd name="connsiteX1" fmla="*/ 731135 w 3001502"/>
                <a:gd name="connsiteY1" fmla="*/ 4733968 h 4733968"/>
                <a:gd name="connsiteX2" fmla="*/ 1500751 w 3001502"/>
                <a:gd name="connsiteY2" fmla="*/ 4695481 h 4733968"/>
                <a:gd name="connsiteX3" fmla="*/ 3001502 w 3001502"/>
                <a:gd name="connsiteY3" fmla="*/ 2674885 h 4733968"/>
                <a:gd name="connsiteX4" fmla="*/ 2828339 w 3001502"/>
                <a:gd name="connsiteY4" fmla="*/ 2309253 h 4733968"/>
                <a:gd name="connsiteX5" fmla="*/ 1770117 w 3001502"/>
                <a:gd name="connsiteY5" fmla="*/ 269413 h 4733968"/>
                <a:gd name="connsiteX6" fmla="*/ 865818 w 3001502"/>
                <a:gd name="connsiteY6" fmla="*/ 0 h 4733968"/>
                <a:gd name="connsiteX7" fmla="*/ 0 w 3001502"/>
                <a:gd name="connsiteY7" fmla="*/ 288657 h 47339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3001502" h="4733968">
                  <a:moveTo>
                    <a:pt x="0" y="288657"/>
                  </a:moveTo>
                  <a:lnTo>
                    <a:pt x="731135" y="4733968"/>
                  </a:lnTo>
                  <a:lnTo>
                    <a:pt x="1500751" y="4695481"/>
                  </a:lnTo>
                  <a:lnTo>
                    <a:pt x="3001502" y="2674885"/>
                  </a:lnTo>
                  <a:lnTo>
                    <a:pt x="2828339" y="2309253"/>
                  </a:lnTo>
                  <a:lnTo>
                    <a:pt x="1770117" y="269413"/>
                  </a:lnTo>
                  <a:lnTo>
                    <a:pt x="865818" y="0"/>
                  </a:lnTo>
                  <a:lnTo>
                    <a:pt x="0" y="288657"/>
                  </a:lnTo>
                  <a:close/>
                </a:path>
              </a:pathLst>
            </a:custGeom>
            <a:gradFill flip="none" rotWithShape="1">
              <a:gsLst>
                <a:gs pos="0">
                  <a:schemeClr val="accent1">
                    <a:shade val="51000"/>
                    <a:satMod val="130000"/>
                    <a:alpha val="25000"/>
                  </a:schemeClr>
                </a:gs>
                <a:gs pos="80000">
                  <a:schemeClr val="accent1">
                    <a:shade val="93000"/>
                    <a:satMod val="130000"/>
                    <a:alpha val="25000"/>
                  </a:schemeClr>
                </a:gs>
                <a:gs pos="100000">
                  <a:schemeClr val="accent1">
                    <a:shade val="94000"/>
                    <a:satMod val="135000"/>
                    <a:alpha val="2500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4 of 8</a:t>
            </a:r>
            <a:endParaRPr lang="en-US" sz="1200" i="1" dirty="0"/>
          </a:p>
        </p:txBody>
      </p:sp>
      <p:sp>
        <p:nvSpPr>
          <p:cNvPr id="9" name="Rounded Rectangle 8">
            <a:hlinkClick r:id="rId4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hysical Examination</a:t>
            </a:r>
            <a:br>
              <a:rPr lang="en-US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</a:br>
            <a:r>
              <a:rPr lang="en-US" sz="40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ensory Evaluation – Ulnar Nerve</a:t>
            </a:r>
            <a:endParaRPr lang="en-US" sz="4000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50060" y="1371600"/>
            <a:ext cx="8443880" cy="4114800"/>
            <a:chOff x="675717" y="1371600"/>
            <a:chExt cx="8443880" cy="4114800"/>
          </a:xfrm>
        </p:grpSpPr>
        <p:grpSp>
          <p:nvGrpSpPr>
            <p:cNvPr id="5" name="Group 4"/>
            <p:cNvGrpSpPr/>
            <p:nvPr/>
          </p:nvGrpSpPr>
          <p:grpSpPr>
            <a:xfrm>
              <a:off x="675717" y="1371600"/>
              <a:ext cx="4114800" cy="4114800"/>
              <a:chOff x="675718" y="2540174"/>
              <a:chExt cx="3402067" cy="4067257"/>
            </a:xfrm>
          </p:grpSpPr>
          <p:pic>
            <p:nvPicPr>
              <p:cNvPr id="8" name="Picture 7" descr="IMG_7590.JPG"/>
              <p:cNvPicPr>
                <a:picLocks noChangeAspect="1"/>
              </p:cNvPicPr>
              <p:nvPr/>
            </p:nvPicPr>
            <p:blipFill>
              <a:blip r:embed="rId3"/>
              <a:srcRect r="10336"/>
              <a:stretch>
                <a:fillRect/>
              </a:stretch>
            </p:blipFill>
            <p:spPr>
              <a:xfrm rot="16200000">
                <a:off x="343123" y="2872769"/>
                <a:ext cx="4067257" cy="3402067"/>
              </a:xfrm>
              <a:prstGeom prst="rect">
                <a:avLst/>
              </a:prstGeom>
            </p:spPr>
          </p:pic>
          <p:sp>
            <p:nvSpPr>
              <p:cNvPr id="10" name="Freeform 9"/>
              <p:cNvSpPr/>
              <p:nvPr/>
            </p:nvSpPr>
            <p:spPr>
              <a:xfrm>
                <a:off x="2616694" y="2963541"/>
                <a:ext cx="1443030" cy="3560098"/>
              </a:xfrm>
              <a:custGeom>
                <a:avLst/>
                <a:gdLst>
                  <a:gd name="connsiteX0" fmla="*/ 731136 w 1443030"/>
                  <a:gd name="connsiteY0" fmla="*/ 0 h 3560098"/>
                  <a:gd name="connsiteX1" fmla="*/ 76962 w 1443030"/>
                  <a:gd name="connsiteY1" fmla="*/ 2078328 h 3560098"/>
                  <a:gd name="connsiteX2" fmla="*/ 0 w 1443030"/>
                  <a:gd name="connsiteY2" fmla="*/ 3560098 h 3560098"/>
                  <a:gd name="connsiteX3" fmla="*/ 538732 w 1443030"/>
                  <a:gd name="connsiteY3" fmla="*/ 3483123 h 3560098"/>
                  <a:gd name="connsiteX4" fmla="*/ 846578 w 1443030"/>
                  <a:gd name="connsiteY4" fmla="*/ 2136059 h 3560098"/>
                  <a:gd name="connsiteX5" fmla="*/ 1443030 w 1443030"/>
                  <a:gd name="connsiteY5" fmla="*/ 788995 h 3560098"/>
                  <a:gd name="connsiteX6" fmla="*/ 731136 w 1443030"/>
                  <a:gd name="connsiteY6" fmla="*/ 0 h 35600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443030" h="3560098">
                    <a:moveTo>
                      <a:pt x="731136" y="0"/>
                    </a:moveTo>
                    <a:lnTo>
                      <a:pt x="76962" y="2078328"/>
                    </a:lnTo>
                    <a:lnTo>
                      <a:pt x="0" y="3560098"/>
                    </a:lnTo>
                    <a:cubicBezTo>
                      <a:pt x="525835" y="3482183"/>
                      <a:pt x="344437" y="3483123"/>
                      <a:pt x="538732" y="3483123"/>
                    </a:cubicBezTo>
                    <a:lnTo>
                      <a:pt x="846578" y="2136059"/>
                    </a:lnTo>
                    <a:cubicBezTo>
                      <a:pt x="1047796" y="1688108"/>
                      <a:pt x="1443030" y="1280064"/>
                      <a:pt x="1443030" y="788995"/>
                    </a:cubicBezTo>
                    <a:lnTo>
                      <a:pt x="731136" y="0"/>
                    </a:lnTo>
                    <a:close/>
                  </a:path>
                </a:pathLst>
              </a:custGeom>
              <a:gradFill flip="none" rotWithShape="1">
                <a:gsLst>
                  <a:gs pos="0">
                    <a:schemeClr val="accent1">
                      <a:shade val="51000"/>
                      <a:satMod val="130000"/>
                      <a:alpha val="25000"/>
                    </a:schemeClr>
                  </a:gs>
                  <a:gs pos="80000">
                    <a:schemeClr val="accent1">
                      <a:shade val="93000"/>
                      <a:satMod val="130000"/>
                      <a:alpha val="25000"/>
                    </a:schemeClr>
                  </a:gs>
                  <a:gs pos="100000">
                    <a:schemeClr val="accent1">
                      <a:shade val="94000"/>
                      <a:satMod val="135000"/>
                      <a:alpha val="25000"/>
                    </a:schemeClr>
                  </a:gs>
                </a:gsLst>
                <a:lin ang="16200000" scaled="0"/>
                <a:tileRect/>
              </a:gra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5004797" y="1371600"/>
              <a:ext cx="4114800" cy="4114800"/>
              <a:chOff x="5004797" y="2540173"/>
              <a:chExt cx="3544788" cy="4047375"/>
            </a:xfrm>
          </p:grpSpPr>
          <p:pic>
            <p:nvPicPr>
              <p:cNvPr id="9" name="Picture 8" descr="IMG_7591.JPG"/>
              <p:cNvPicPr>
                <a:picLocks noChangeAspect="1"/>
              </p:cNvPicPr>
              <p:nvPr/>
            </p:nvPicPr>
            <p:blipFill>
              <a:blip r:embed="rId4"/>
              <a:srcRect l="7126" r="7241"/>
              <a:stretch>
                <a:fillRect/>
              </a:stretch>
            </p:blipFill>
            <p:spPr>
              <a:xfrm rot="16200000">
                <a:off x="4753503" y="2791467"/>
                <a:ext cx="4047375" cy="3544788"/>
              </a:xfrm>
              <a:prstGeom prst="rect">
                <a:avLst/>
              </a:prstGeom>
            </p:spPr>
          </p:pic>
          <p:sp>
            <p:nvSpPr>
              <p:cNvPr id="12" name="Freeform 11"/>
              <p:cNvSpPr/>
              <p:nvPr/>
            </p:nvSpPr>
            <p:spPr>
              <a:xfrm>
                <a:off x="5021744" y="2828835"/>
                <a:ext cx="1443030" cy="3598586"/>
              </a:xfrm>
              <a:custGeom>
                <a:avLst/>
                <a:gdLst>
                  <a:gd name="connsiteX0" fmla="*/ 1096703 w 1443030"/>
                  <a:gd name="connsiteY0" fmla="*/ 0 h 3598586"/>
                  <a:gd name="connsiteX1" fmla="*/ 1423790 w 1443030"/>
                  <a:gd name="connsiteY1" fmla="*/ 2443959 h 3598586"/>
                  <a:gd name="connsiteX2" fmla="*/ 1443030 w 1443030"/>
                  <a:gd name="connsiteY2" fmla="*/ 3598586 h 3598586"/>
                  <a:gd name="connsiteX3" fmla="*/ 865818 w 1443030"/>
                  <a:gd name="connsiteY3" fmla="*/ 3579342 h 3598586"/>
                  <a:gd name="connsiteX4" fmla="*/ 596453 w 1443030"/>
                  <a:gd name="connsiteY4" fmla="*/ 2136059 h 3598586"/>
                  <a:gd name="connsiteX5" fmla="*/ 0 w 1443030"/>
                  <a:gd name="connsiteY5" fmla="*/ 981432 h 3598586"/>
                  <a:gd name="connsiteX6" fmla="*/ 1096703 w 1443030"/>
                  <a:gd name="connsiteY6" fmla="*/ 0 h 359858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443030" h="3598586">
                    <a:moveTo>
                      <a:pt x="1096703" y="0"/>
                    </a:moveTo>
                    <a:lnTo>
                      <a:pt x="1423790" y="2443959"/>
                    </a:lnTo>
                    <a:lnTo>
                      <a:pt x="1443030" y="3598586"/>
                    </a:lnTo>
                    <a:lnTo>
                      <a:pt x="865818" y="3579342"/>
                    </a:lnTo>
                    <a:lnTo>
                      <a:pt x="596453" y="2136059"/>
                    </a:lnTo>
                    <a:lnTo>
                      <a:pt x="0" y="981432"/>
                    </a:lnTo>
                    <a:lnTo>
                      <a:pt x="1096703" y="0"/>
                    </a:lnTo>
                    <a:close/>
                  </a:path>
                </a:pathLst>
              </a:custGeom>
              <a:gradFill flip="none" rotWithShape="1">
                <a:gsLst>
                  <a:gs pos="0">
                    <a:schemeClr val="accent1">
                      <a:shade val="51000"/>
                      <a:satMod val="130000"/>
                      <a:alpha val="25000"/>
                    </a:schemeClr>
                  </a:gs>
                  <a:gs pos="80000">
                    <a:schemeClr val="accent1">
                      <a:shade val="93000"/>
                      <a:satMod val="130000"/>
                      <a:alpha val="25000"/>
                    </a:schemeClr>
                  </a:gs>
                  <a:gs pos="100000">
                    <a:schemeClr val="accent1">
                      <a:shade val="94000"/>
                      <a:satMod val="135000"/>
                      <a:alpha val="25000"/>
                    </a:schemeClr>
                  </a:gs>
                </a:gsLst>
                <a:lin ang="16200000" scaled="0"/>
                <a:tileRect/>
              </a:gra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1" name="TextBox 10"/>
          <p:cNvSpPr txBox="1"/>
          <p:nvPr/>
        </p:nvSpPr>
        <p:spPr>
          <a:xfrm>
            <a:off x="6858000" y="6309360"/>
            <a:ext cx="20116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i="1" dirty="0" smtClean="0"/>
              <a:t>Physical Exam</a:t>
            </a:r>
          </a:p>
          <a:p>
            <a:pPr algn="r"/>
            <a:r>
              <a:rPr lang="en-US" sz="1200" i="1" dirty="0" smtClean="0"/>
              <a:t>Slide 5 of 8</a:t>
            </a:r>
            <a:endParaRPr lang="en-US" sz="1200" i="1" dirty="0"/>
          </a:p>
        </p:txBody>
      </p:sp>
      <p:sp>
        <p:nvSpPr>
          <p:cNvPr id="13" name="Rounded Rectangle 12">
            <a:hlinkClick r:id="rId5" action="ppaction://hlinksldjump"/>
          </p:cNvPr>
          <p:cNvSpPr/>
          <p:nvPr/>
        </p:nvSpPr>
        <p:spPr>
          <a:xfrm>
            <a:off x="4114800" y="6492240"/>
            <a:ext cx="914400" cy="228600"/>
          </a:xfrm>
          <a:prstGeom prst="roundRect">
            <a:avLst/>
          </a:prstGeom>
          <a:gradFill flip="none" rotWithShape="1">
            <a:gsLst>
              <a:gs pos="0">
                <a:schemeClr val="tx1">
                  <a:lumMod val="50000"/>
                </a:schemeClr>
              </a:gs>
              <a:gs pos="50000">
                <a:schemeClr val="tx1">
                  <a:lumMod val="65000"/>
                </a:schemeClr>
              </a:gs>
              <a:gs pos="100000">
                <a:schemeClr val="tx1">
                  <a:lumMod val="75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0">
            <a:schemeClr val="dk1"/>
          </a:lnRef>
          <a:fillRef idx="3">
            <a:schemeClr val="dk1"/>
          </a:fillRef>
          <a:effectRef idx="3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bg1"/>
                </a:solidFill>
              </a:rPr>
              <a:t>Contents</a:t>
            </a:r>
            <a:endParaRPr lang="en-US" sz="1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52459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_PE_HAS_URLS" val="oh hey this is notes box, due to this not being an empty string. woot."/>
</p:tagLst>
</file>

<file path=ppt/theme/theme1.xml><?xml version="1.0" encoding="utf-8"?>
<a:theme xmlns:a="http://schemas.openxmlformats.org/drawingml/2006/main" name=" Black 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3503</TotalTime>
  <Words>1498</Words>
  <Application>Microsoft Office PowerPoint</Application>
  <PresentationFormat>On-screen Show (4:3)</PresentationFormat>
  <Paragraphs>357</Paragraphs>
  <Slides>49</Slides>
  <Notes>49</Notes>
  <HiddenSlides>4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Slide Titles</vt:lpstr>
      </vt:variant>
      <vt:variant>
        <vt:i4>49</vt:i4>
      </vt:variant>
      <vt:variant>
        <vt:lpstr>Custom Shows</vt:lpstr>
      </vt:variant>
      <vt:variant>
        <vt:i4>4</vt:i4>
      </vt:variant>
    </vt:vector>
  </HeadingPairs>
  <TitlesOfParts>
    <vt:vector size="54" baseType="lpstr">
      <vt:lpstr> Black </vt:lpstr>
      <vt:lpstr>Evaluation of Wrist Injuries in the Urgent Setting</vt:lpstr>
      <vt:lpstr>Educational Objectives</vt:lpstr>
      <vt:lpstr>Self-Assessment</vt:lpstr>
      <vt:lpstr>Contents</vt:lpstr>
      <vt:lpstr>Physical Examination</vt:lpstr>
      <vt:lpstr>Physical Examination Circulation Evaluation</vt:lpstr>
      <vt:lpstr>Physical Examination Sensory Evaluation – Radial Nerve</vt:lpstr>
      <vt:lpstr>Physical Examination Sensory Evaluation – Median Nerve</vt:lpstr>
      <vt:lpstr>Physical Examination Sensory Evaluation – Ulnar Nerve</vt:lpstr>
      <vt:lpstr>Physical Examination Motor – Finger Flexion</vt:lpstr>
      <vt:lpstr>Physical Examination Motor – Finger Extension</vt:lpstr>
      <vt:lpstr>Physical Examination Motor – Finger Spread</vt:lpstr>
      <vt:lpstr>Acute Carpal Tunnel Syndrome</vt:lpstr>
      <vt:lpstr>Acute Carpal Tunnel Syndrome</vt:lpstr>
      <vt:lpstr>Radiographic Examination</vt:lpstr>
      <vt:lpstr>Wrist Radiographs</vt:lpstr>
      <vt:lpstr>Normal Radiographs PA</vt:lpstr>
      <vt:lpstr>Normal Radiographs Lateral</vt:lpstr>
      <vt:lpstr>Normal Radiographs Lateral</vt:lpstr>
      <vt:lpstr>Types of Wrist Fracture</vt:lpstr>
      <vt:lpstr>Radial/Ulnar Styloid</vt:lpstr>
      <vt:lpstr>Radial/Ulnar Styloid</vt:lpstr>
      <vt:lpstr>Distal Radius: Extra-articular</vt:lpstr>
      <vt:lpstr>Distal Radius: Extra-articular</vt:lpstr>
      <vt:lpstr>Distal Radius: Intra-articular</vt:lpstr>
      <vt:lpstr>Distal Radius: Intra-articular</vt:lpstr>
      <vt:lpstr>Distal Radius/Ulna Injury Summary</vt:lpstr>
      <vt:lpstr>Other Wrist Fractures</vt:lpstr>
      <vt:lpstr>Scaphoid Fracture Pain in anatomic snuffbox</vt:lpstr>
      <vt:lpstr>Scaphoid Fracture Pain in anatomic snuffbox</vt:lpstr>
      <vt:lpstr>Lunate Dislocation</vt:lpstr>
      <vt:lpstr>Lunate Dislocation</vt:lpstr>
      <vt:lpstr>Lunate Dislocation</vt:lpstr>
      <vt:lpstr>Perilunate Dislocation</vt:lpstr>
      <vt:lpstr>Perilunate Dislocation  Lunate outlined</vt:lpstr>
      <vt:lpstr>Carpal Injuries Summary</vt:lpstr>
      <vt:lpstr>Management Urgent</vt:lpstr>
      <vt:lpstr>Management Urgent</vt:lpstr>
      <vt:lpstr>Management Urgent</vt:lpstr>
      <vt:lpstr>Distal Radius Intra-articular</vt:lpstr>
      <vt:lpstr>Distal Radius Intra-articular pre and post reduction</vt:lpstr>
      <vt:lpstr>Distal Radius Intra-articular pre and post reduction</vt:lpstr>
      <vt:lpstr>Management Urgent</vt:lpstr>
      <vt:lpstr>Management Urgent</vt:lpstr>
      <vt:lpstr>Management Definitive</vt:lpstr>
      <vt:lpstr>What are the standard radiographs to order for a wrist injury?</vt:lpstr>
      <vt:lpstr>What are the criteria for operative intervention in a wrist injury?</vt:lpstr>
      <vt:lpstr>What wrist injuries should be considered for urgent or emergent management?</vt:lpstr>
      <vt:lpstr>Splinting (additional information)</vt:lpstr>
      <vt:lpstr>Self-Assessment - Standard Radi</vt:lpstr>
      <vt:lpstr>Self-Assessment - Operative Int</vt:lpstr>
      <vt:lpstr>Self-Assessment - Urgent Manage</vt:lpstr>
      <vt:lpstr>Splinting - additional informat</vt:lpstr>
    </vt:vector>
  </TitlesOfParts>
  <Company>Wake Forest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kle Injuries</dc:title>
  <dc:creator>Anna Miller</dc:creator>
  <cp:lastModifiedBy>WFBMC</cp:lastModifiedBy>
  <cp:revision>130</cp:revision>
  <dcterms:created xsi:type="dcterms:W3CDTF">2015-01-21T21:31:23Z</dcterms:created>
  <dcterms:modified xsi:type="dcterms:W3CDTF">2016-10-10T16:10:18Z</dcterms:modified>
</cp:coreProperties>
</file>